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88163" cy="10020300"/>
  <p:defaultTextStyle>
    <a:defPPr>
      <a:defRPr lang="es-MX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odrigo Franco Cruz" initials="RFC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629" autoAdjust="0"/>
    <p:restoredTop sz="94660"/>
  </p:normalViewPr>
  <p:slideViewPr>
    <p:cSldViewPr>
      <p:cViewPr>
        <p:scale>
          <a:sx n="98" d="100"/>
          <a:sy n="98" d="100"/>
        </p:scale>
        <p:origin x="-774" y="-72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406" cy="500674"/>
          </a:xfrm>
          <a:prstGeom prst="rect">
            <a:avLst/>
          </a:prstGeom>
        </p:spPr>
        <p:txBody>
          <a:bodyPr vert="horz" lIns="93497" tIns="46749" rIns="93497" bIns="46749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902210" y="0"/>
            <a:ext cx="2984405" cy="500674"/>
          </a:xfrm>
          <a:prstGeom prst="rect">
            <a:avLst/>
          </a:prstGeom>
        </p:spPr>
        <p:txBody>
          <a:bodyPr vert="horz" lIns="93497" tIns="46749" rIns="93497" bIns="46749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B9718C40-844F-4EF5-B419-924C37D47A17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39800" y="752475"/>
            <a:ext cx="5010150" cy="37576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497" tIns="46749" rIns="93497" bIns="46749" rtlCol="0" anchor="ctr"/>
          <a:lstStyle/>
          <a:p>
            <a:pPr lvl="0"/>
            <a:endParaRPr lang="es-MX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8351" y="4758960"/>
            <a:ext cx="5511461" cy="4509476"/>
          </a:xfrm>
          <a:prstGeom prst="rect">
            <a:avLst/>
          </a:prstGeom>
        </p:spPr>
        <p:txBody>
          <a:bodyPr vert="horz" lIns="93497" tIns="46749" rIns="93497" bIns="46749" rtlCol="0"/>
          <a:lstStyle/>
          <a:p>
            <a:pPr lvl="0"/>
            <a:r>
              <a:rPr lang="es-ES" noProof="0"/>
              <a:t>Haga clic para modificar el estilo de texto del patrón</a:t>
            </a:r>
          </a:p>
          <a:p>
            <a:pPr lvl="1"/>
            <a:r>
              <a:rPr lang="es-ES" noProof="0"/>
              <a:t>Segundo nivel</a:t>
            </a:r>
          </a:p>
          <a:p>
            <a:pPr lvl="2"/>
            <a:r>
              <a:rPr lang="es-ES" noProof="0"/>
              <a:t>Tercer nivel</a:t>
            </a:r>
          </a:p>
          <a:p>
            <a:pPr lvl="3"/>
            <a:r>
              <a:rPr lang="es-ES" noProof="0"/>
              <a:t>Cuarto nivel</a:t>
            </a:r>
          </a:p>
          <a:p>
            <a:pPr lvl="4"/>
            <a:r>
              <a:rPr lang="es-ES" noProof="0"/>
              <a:t>Quinto nivel</a:t>
            </a:r>
            <a:endParaRPr lang="es-MX" noProof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517918"/>
            <a:ext cx="2984406" cy="500674"/>
          </a:xfrm>
          <a:prstGeom prst="rect">
            <a:avLst/>
          </a:prstGeom>
        </p:spPr>
        <p:txBody>
          <a:bodyPr vert="horz" lIns="93497" tIns="46749" rIns="93497" bIns="46749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902210" y="9517918"/>
            <a:ext cx="2984405" cy="500674"/>
          </a:xfrm>
          <a:prstGeom prst="rect">
            <a:avLst/>
          </a:prstGeom>
        </p:spPr>
        <p:txBody>
          <a:bodyPr vert="horz" lIns="93497" tIns="46749" rIns="93497" bIns="46749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72DC6F87-BA16-4BB2-ACBB-7CD6DB6EE7EC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303646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FB0D52-8912-461C-A428-137405325D90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868D3A-9432-4FDE-A601-61E6692DABDB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75417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7D3898-81B4-4A87-971D-75E3203590E9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19EDD0-1ACA-49AC-B7DC-6E5976652ADA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60257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0B8422-2971-4079-86D9-C7C0B86DE574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4E0EFD-A1D2-4531-AFD7-44D9BC4A99EE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05914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9317A9-D554-429E-93B6-2585CE696CEE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C2F606-DF85-4A20-A0EF-3864ACE48B4D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69083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7920B6-E432-414B-992B-3C6B85CC2E3C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94CAB6-14D1-4DF7-9C55-BC5E7423777B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20855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2B4A7F-502A-43EB-BF5D-2B3B6B7722D9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BA8F50-DD6A-4044-B196-84857CA3B06B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8936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489CAB-7CE7-48BC-81BA-CD216C300A29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0B506C-4775-40D2-B4FB-417AE213A5DD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38679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57F885-FFE2-4838-9727-CE51783661AC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EF60C2-0BE3-4DC0-8691-E985229F2D3F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58334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CEB2FE-E408-4AC3-85EF-56E3FA5687B9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DF6847-EEFC-4AAD-BC36-646798E5E801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45977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9AAFF0-7FD5-45B2-B9C7-C9A857E09983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9F4A03-A7C0-487D-892D-E99DA85D9808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17404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MX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0F7EA7-6A3C-470C-9743-B8F548182F91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AE284-C809-4E2D-A11A-530D0FD40D07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08685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3CE3225-CED3-468F-9740-DD0AF7B6BC16}" type="datetimeFigureOut">
              <a:rPr lang="es-MX"/>
              <a:pPr>
                <a:defRPr/>
              </a:pPr>
              <a:t>10/06/2018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3FA8773-C10A-4369-8626-9788C19FF51E}" type="slidenum">
              <a:rPr lang="es-MX"/>
              <a:pPr>
                <a:defRPr/>
              </a:pPr>
              <a:t>‹Nº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4 Grupo"/>
          <p:cNvGrpSpPr/>
          <p:nvPr/>
        </p:nvGrpSpPr>
        <p:grpSpPr>
          <a:xfrm>
            <a:off x="1548344" y="644974"/>
            <a:ext cx="6120000" cy="3701683"/>
            <a:chOff x="973758" y="644974"/>
            <a:chExt cx="6215040" cy="3410614"/>
          </a:xfrm>
        </p:grpSpPr>
        <p:grpSp>
          <p:nvGrpSpPr>
            <p:cNvPr id="3" name="2 Grupo"/>
            <p:cNvGrpSpPr/>
            <p:nvPr/>
          </p:nvGrpSpPr>
          <p:grpSpPr>
            <a:xfrm>
              <a:off x="1023447" y="2007036"/>
              <a:ext cx="3441582" cy="849167"/>
              <a:chOff x="1023447" y="2007036"/>
              <a:chExt cx="3441582" cy="849167"/>
            </a:xfrm>
          </p:grpSpPr>
          <p:grpSp>
            <p:nvGrpSpPr>
              <p:cNvPr id="49" name="63 Grupo">
                <a:extLst>
                  <a:ext uri="{FF2B5EF4-FFF2-40B4-BE49-F238E27FC236}">
                    <a16:creationId xmlns="" xmlns:a16="http://schemas.microsoft.com/office/drawing/2014/main" id="{C799E9E1-DAFB-4E95-B705-8EF1498FEF11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23447" y="2009107"/>
                <a:ext cx="691237" cy="384487"/>
                <a:chOff x="-444663" y="3332149"/>
                <a:chExt cx="1139786" cy="384319"/>
              </a:xfrm>
            </p:grpSpPr>
            <p:sp>
              <p:nvSpPr>
                <p:cNvPr id="56" name="145 CuadroTexto">
                  <a:extLst>
                    <a:ext uri="{FF2B5EF4-FFF2-40B4-BE49-F238E27FC236}">
                      <a16:creationId xmlns="" xmlns:a16="http://schemas.microsoft.com/office/drawing/2014/main" id="{F49234DD-6555-4A74-9DBC-A1E4D3A65CE2}"/>
                    </a:ext>
                  </a:extLst>
                </p:cNvPr>
                <p:cNvSpPr txBox="1"/>
                <p:nvPr/>
              </p:nvSpPr>
              <p:spPr>
                <a:xfrm>
                  <a:off x="-444663" y="3485737"/>
                  <a:ext cx="1139786" cy="230731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900" kern="0" dirty="0" err="1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Hypo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 (3mM)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57" name="146 CuadroTexto">
                  <a:extLst>
                    <a:ext uri="{FF2B5EF4-FFF2-40B4-BE49-F238E27FC236}">
                      <a16:creationId xmlns="" xmlns:a16="http://schemas.microsoft.com/office/drawing/2014/main" id="{58644ADD-125E-4D32-BDE8-079D7DC29A55}"/>
                    </a:ext>
                  </a:extLst>
                </p:cNvPr>
                <p:cNvSpPr txBox="1"/>
                <p:nvPr/>
              </p:nvSpPr>
              <p:spPr>
                <a:xfrm>
                  <a:off x="-438707" y="3332149"/>
                  <a:ext cx="819293" cy="230732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Homo 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cs typeface="Arial" pitchFamily="34" charset="0"/>
                    </a:rPr>
                    <a:t>(µM)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</p:grpSp>
          <p:sp>
            <p:nvSpPr>
              <p:cNvPr id="125" name="AutoShape 15">
                <a:extLst>
                  <a:ext uri="{FF2B5EF4-FFF2-40B4-BE49-F238E27FC236}">
                    <a16:creationId xmlns="" xmlns:a16="http://schemas.microsoft.com/office/drawing/2014/main" id="{599FB7BD-0018-4375-9389-00D788D10E02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722531" y="2341168"/>
                <a:ext cx="2742498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 dirty="0"/>
              </a:p>
            </p:txBody>
          </p:sp>
          <p:sp>
            <p:nvSpPr>
              <p:cNvPr id="126" name="Freeform 17">
                <a:extLst>
                  <a:ext uri="{FF2B5EF4-FFF2-40B4-BE49-F238E27FC236}">
                    <a16:creationId xmlns="" xmlns:a16="http://schemas.microsoft.com/office/drawing/2014/main" id="{E3B9CE30-A115-4EBC-959A-4D18B0C6BD2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31700" y="2360218"/>
                <a:ext cx="2723326" cy="277813"/>
              </a:xfrm>
              <a:custGeom>
                <a:avLst/>
                <a:gdLst>
                  <a:gd name="T0" fmla="*/ 5 w 571"/>
                  <a:gd name="T1" fmla="*/ 2 h 30"/>
                  <a:gd name="T2" fmla="*/ 18 w 571"/>
                  <a:gd name="T3" fmla="*/ 3 h 30"/>
                  <a:gd name="T4" fmla="*/ 26 w 571"/>
                  <a:gd name="T5" fmla="*/ 28 h 30"/>
                  <a:gd name="T6" fmla="*/ 41 w 571"/>
                  <a:gd name="T7" fmla="*/ 28 h 30"/>
                  <a:gd name="T8" fmla="*/ 55 w 571"/>
                  <a:gd name="T9" fmla="*/ 1 h 30"/>
                  <a:gd name="T10" fmla="*/ 103 w 571"/>
                  <a:gd name="T11" fmla="*/ 1 h 30"/>
                  <a:gd name="T12" fmla="*/ 112 w 571"/>
                  <a:gd name="T13" fmla="*/ 28 h 30"/>
                  <a:gd name="T14" fmla="*/ 121 w 571"/>
                  <a:gd name="T15" fmla="*/ 29 h 30"/>
                  <a:gd name="T16" fmla="*/ 127 w 571"/>
                  <a:gd name="T17" fmla="*/ 28 h 30"/>
                  <a:gd name="T18" fmla="*/ 175 w 571"/>
                  <a:gd name="T19" fmla="*/ 0 h 30"/>
                  <a:gd name="T20" fmla="*/ 182 w 571"/>
                  <a:gd name="T21" fmla="*/ 0 h 30"/>
                  <a:gd name="T22" fmla="*/ 198 w 571"/>
                  <a:gd name="T23" fmla="*/ 29 h 30"/>
                  <a:gd name="T24" fmla="*/ 208 w 571"/>
                  <a:gd name="T25" fmla="*/ 29 h 30"/>
                  <a:gd name="T26" fmla="*/ 248 w 571"/>
                  <a:gd name="T27" fmla="*/ 0 h 30"/>
                  <a:gd name="T28" fmla="*/ 262 w 571"/>
                  <a:gd name="T29" fmla="*/ 0 h 30"/>
                  <a:gd name="T30" fmla="*/ 277 w 571"/>
                  <a:gd name="T31" fmla="*/ 28 h 30"/>
                  <a:gd name="T32" fmla="*/ 284 w 571"/>
                  <a:gd name="T33" fmla="*/ 28 h 30"/>
                  <a:gd name="T34" fmla="*/ 290 w 571"/>
                  <a:gd name="T35" fmla="*/ 29 h 30"/>
                  <a:gd name="T36" fmla="*/ 310 w 571"/>
                  <a:gd name="T37" fmla="*/ 0 h 30"/>
                  <a:gd name="T38" fmla="*/ 350 w 571"/>
                  <a:gd name="T39" fmla="*/ 0 h 30"/>
                  <a:gd name="T40" fmla="*/ 361 w 571"/>
                  <a:gd name="T41" fmla="*/ 28 h 30"/>
                  <a:gd name="T42" fmla="*/ 368 w 571"/>
                  <a:gd name="T43" fmla="*/ 21 h 30"/>
                  <a:gd name="T44" fmla="*/ 375 w 571"/>
                  <a:gd name="T45" fmla="*/ 29 h 30"/>
                  <a:gd name="T46" fmla="*/ 389 w 571"/>
                  <a:gd name="T47" fmla="*/ 0 h 30"/>
                  <a:gd name="T48" fmla="*/ 432 w 571"/>
                  <a:gd name="T49" fmla="*/ 0 h 30"/>
                  <a:gd name="T50" fmla="*/ 444 w 571"/>
                  <a:gd name="T51" fmla="*/ 29 h 30"/>
                  <a:gd name="T52" fmla="*/ 453 w 571"/>
                  <a:gd name="T53" fmla="*/ 16 h 30"/>
                  <a:gd name="T54" fmla="*/ 461 w 571"/>
                  <a:gd name="T55" fmla="*/ 28 h 30"/>
                  <a:gd name="T56" fmla="*/ 475 w 571"/>
                  <a:gd name="T57" fmla="*/ 0 h 30"/>
                  <a:gd name="T58" fmla="*/ 495 w 571"/>
                  <a:gd name="T59" fmla="*/ 0 h 30"/>
                  <a:gd name="T60" fmla="*/ 516 w 571"/>
                  <a:gd name="T61" fmla="*/ 28 h 30"/>
                  <a:gd name="T62" fmla="*/ 524 w 571"/>
                  <a:gd name="T63" fmla="*/ 10 h 30"/>
                  <a:gd name="T64" fmla="*/ 536 w 571"/>
                  <a:gd name="T65" fmla="*/ 28 h 30"/>
                  <a:gd name="T66" fmla="*/ 550 w 571"/>
                  <a:gd name="T67" fmla="*/ 1 h 30"/>
                  <a:gd name="T68" fmla="*/ 571 w 571"/>
                  <a:gd name="T69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571" h="30">
                    <a:moveTo>
                      <a:pt x="0" y="2"/>
                    </a:moveTo>
                    <a:cubicBezTo>
                      <a:pt x="0" y="2"/>
                      <a:pt x="3" y="2"/>
                      <a:pt x="5" y="2"/>
                    </a:cubicBezTo>
                    <a:cubicBezTo>
                      <a:pt x="8" y="2"/>
                      <a:pt x="10" y="2"/>
                      <a:pt x="11" y="2"/>
                    </a:cubicBezTo>
                    <a:cubicBezTo>
                      <a:pt x="15" y="2"/>
                      <a:pt x="18" y="1"/>
                      <a:pt x="18" y="3"/>
                    </a:cubicBezTo>
                    <a:cubicBezTo>
                      <a:pt x="20" y="7"/>
                      <a:pt x="19" y="13"/>
                      <a:pt x="22" y="28"/>
                    </a:cubicBezTo>
                    <a:cubicBezTo>
                      <a:pt x="23" y="28"/>
                      <a:pt x="26" y="28"/>
                      <a:pt x="26" y="28"/>
                    </a:cubicBezTo>
                    <a:cubicBezTo>
                      <a:pt x="29" y="28"/>
                      <a:pt x="30" y="28"/>
                      <a:pt x="31" y="28"/>
                    </a:cubicBezTo>
                    <a:cubicBezTo>
                      <a:pt x="35" y="29"/>
                      <a:pt x="38" y="29"/>
                      <a:pt x="41" y="28"/>
                    </a:cubicBezTo>
                    <a:cubicBezTo>
                      <a:pt x="44" y="28"/>
                      <a:pt x="45" y="7"/>
                      <a:pt x="46" y="2"/>
                    </a:cubicBezTo>
                    <a:cubicBezTo>
                      <a:pt x="46" y="0"/>
                      <a:pt x="53" y="1"/>
                      <a:pt x="55" y="1"/>
                    </a:cubicBezTo>
                    <a:cubicBezTo>
                      <a:pt x="58" y="0"/>
                      <a:pt x="74" y="0"/>
                      <a:pt x="77" y="0"/>
                    </a:cubicBezTo>
                    <a:cubicBezTo>
                      <a:pt x="88" y="0"/>
                      <a:pt x="93" y="1"/>
                      <a:pt x="103" y="1"/>
                    </a:cubicBezTo>
                    <a:cubicBezTo>
                      <a:pt x="104" y="1"/>
                      <a:pt x="106" y="1"/>
                      <a:pt x="107" y="1"/>
                    </a:cubicBezTo>
                    <a:cubicBezTo>
                      <a:pt x="108" y="1"/>
                      <a:pt x="110" y="28"/>
                      <a:pt x="112" y="28"/>
                    </a:cubicBezTo>
                    <a:cubicBezTo>
                      <a:pt x="113" y="28"/>
                      <a:pt x="116" y="28"/>
                      <a:pt x="117" y="28"/>
                    </a:cubicBezTo>
                    <a:cubicBezTo>
                      <a:pt x="118" y="28"/>
                      <a:pt x="120" y="29"/>
                      <a:pt x="121" y="29"/>
                    </a:cubicBezTo>
                    <a:cubicBezTo>
                      <a:pt x="122" y="29"/>
                      <a:pt x="124" y="28"/>
                      <a:pt x="125" y="28"/>
                    </a:cubicBezTo>
                    <a:cubicBezTo>
                      <a:pt x="126" y="28"/>
                      <a:pt x="126" y="28"/>
                      <a:pt x="127" y="28"/>
                    </a:cubicBezTo>
                    <a:cubicBezTo>
                      <a:pt x="129" y="28"/>
                      <a:pt x="131" y="0"/>
                      <a:pt x="133" y="0"/>
                    </a:cubicBezTo>
                    <a:cubicBezTo>
                      <a:pt x="152" y="0"/>
                      <a:pt x="159" y="0"/>
                      <a:pt x="175" y="0"/>
                    </a:cubicBezTo>
                    <a:cubicBezTo>
                      <a:pt x="177" y="0"/>
                      <a:pt x="178" y="0"/>
                      <a:pt x="179" y="0"/>
                    </a:cubicBezTo>
                    <a:cubicBezTo>
                      <a:pt x="180" y="0"/>
                      <a:pt x="181" y="0"/>
                      <a:pt x="182" y="0"/>
                    </a:cubicBezTo>
                    <a:cubicBezTo>
                      <a:pt x="185" y="0"/>
                      <a:pt x="187" y="29"/>
                      <a:pt x="190" y="29"/>
                    </a:cubicBezTo>
                    <a:cubicBezTo>
                      <a:pt x="192" y="29"/>
                      <a:pt x="196" y="29"/>
                      <a:pt x="198" y="29"/>
                    </a:cubicBezTo>
                    <a:cubicBezTo>
                      <a:pt x="199" y="29"/>
                      <a:pt x="201" y="29"/>
                      <a:pt x="202" y="29"/>
                    </a:cubicBezTo>
                    <a:cubicBezTo>
                      <a:pt x="204" y="29"/>
                      <a:pt x="206" y="29"/>
                      <a:pt x="208" y="29"/>
                    </a:cubicBezTo>
                    <a:cubicBezTo>
                      <a:pt x="212" y="29"/>
                      <a:pt x="214" y="0"/>
                      <a:pt x="218" y="0"/>
                    </a:cubicBezTo>
                    <a:cubicBezTo>
                      <a:pt x="228" y="0"/>
                      <a:pt x="238" y="0"/>
                      <a:pt x="248" y="0"/>
                    </a:cubicBezTo>
                    <a:cubicBezTo>
                      <a:pt x="251" y="0"/>
                      <a:pt x="257" y="0"/>
                      <a:pt x="260" y="0"/>
                    </a:cubicBezTo>
                    <a:cubicBezTo>
                      <a:pt x="261" y="0"/>
                      <a:pt x="261" y="0"/>
                      <a:pt x="262" y="0"/>
                    </a:cubicBezTo>
                    <a:cubicBezTo>
                      <a:pt x="268" y="0"/>
                      <a:pt x="268" y="28"/>
                      <a:pt x="273" y="28"/>
                    </a:cubicBezTo>
                    <a:cubicBezTo>
                      <a:pt x="274" y="28"/>
                      <a:pt x="276" y="28"/>
                      <a:pt x="277" y="28"/>
                    </a:cubicBezTo>
                    <a:cubicBezTo>
                      <a:pt x="278" y="29"/>
                      <a:pt x="279" y="27"/>
                      <a:pt x="280" y="27"/>
                    </a:cubicBezTo>
                    <a:cubicBezTo>
                      <a:pt x="282" y="27"/>
                      <a:pt x="283" y="28"/>
                      <a:pt x="284" y="28"/>
                    </a:cubicBezTo>
                    <a:cubicBezTo>
                      <a:pt x="285" y="28"/>
                      <a:pt x="287" y="29"/>
                      <a:pt x="288" y="29"/>
                    </a:cubicBezTo>
                    <a:cubicBezTo>
                      <a:pt x="289" y="29"/>
                      <a:pt x="290" y="29"/>
                      <a:pt x="290" y="29"/>
                    </a:cubicBezTo>
                    <a:cubicBezTo>
                      <a:pt x="296" y="29"/>
                      <a:pt x="299" y="0"/>
                      <a:pt x="305" y="0"/>
                    </a:cubicBezTo>
                    <a:cubicBezTo>
                      <a:pt x="306" y="0"/>
                      <a:pt x="308" y="0"/>
                      <a:pt x="310" y="0"/>
                    </a:cubicBezTo>
                    <a:cubicBezTo>
                      <a:pt x="325" y="0"/>
                      <a:pt x="332" y="0"/>
                      <a:pt x="346" y="0"/>
                    </a:cubicBezTo>
                    <a:cubicBezTo>
                      <a:pt x="347" y="0"/>
                      <a:pt x="349" y="0"/>
                      <a:pt x="350" y="0"/>
                    </a:cubicBezTo>
                    <a:cubicBezTo>
                      <a:pt x="351" y="0"/>
                      <a:pt x="352" y="0"/>
                      <a:pt x="352" y="0"/>
                    </a:cubicBezTo>
                    <a:cubicBezTo>
                      <a:pt x="354" y="0"/>
                      <a:pt x="356" y="28"/>
                      <a:pt x="361" y="28"/>
                    </a:cubicBezTo>
                    <a:cubicBezTo>
                      <a:pt x="363" y="29"/>
                      <a:pt x="363" y="28"/>
                      <a:pt x="365" y="28"/>
                    </a:cubicBezTo>
                    <a:cubicBezTo>
                      <a:pt x="366" y="28"/>
                      <a:pt x="367" y="21"/>
                      <a:pt x="368" y="21"/>
                    </a:cubicBezTo>
                    <a:cubicBezTo>
                      <a:pt x="369" y="21"/>
                      <a:pt x="371" y="21"/>
                      <a:pt x="372" y="21"/>
                    </a:cubicBezTo>
                    <a:cubicBezTo>
                      <a:pt x="374" y="21"/>
                      <a:pt x="374" y="29"/>
                      <a:pt x="375" y="29"/>
                    </a:cubicBezTo>
                    <a:cubicBezTo>
                      <a:pt x="376" y="29"/>
                      <a:pt x="379" y="28"/>
                      <a:pt x="380" y="28"/>
                    </a:cubicBezTo>
                    <a:cubicBezTo>
                      <a:pt x="384" y="28"/>
                      <a:pt x="385" y="0"/>
                      <a:pt x="389" y="0"/>
                    </a:cubicBezTo>
                    <a:cubicBezTo>
                      <a:pt x="401" y="0"/>
                      <a:pt x="421" y="0"/>
                      <a:pt x="431" y="0"/>
                    </a:cubicBezTo>
                    <a:cubicBezTo>
                      <a:pt x="431" y="0"/>
                      <a:pt x="432" y="0"/>
                      <a:pt x="432" y="0"/>
                    </a:cubicBezTo>
                    <a:cubicBezTo>
                      <a:pt x="437" y="0"/>
                      <a:pt x="434" y="27"/>
                      <a:pt x="439" y="28"/>
                    </a:cubicBezTo>
                    <a:cubicBezTo>
                      <a:pt x="441" y="29"/>
                      <a:pt x="443" y="29"/>
                      <a:pt x="444" y="29"/>
                    </a:cubicBezTo>
                    <a:cubicBezTo>
                      <a:pt x="446" y="29"/>
                      <a:pt x="446" y="15"/>
                      <a:pt x="448" y="16"/>
                    </a:cubicBezTo>
                    <a:cubicBezTo>
                      <a:pt x="449" y="16"/>
                      <a:pt x="452" y="15"/>
                      <a:pt x="453" y="16"/>
                    </a:cubicBezTo>
                    <a:cubicBezTo>
                      <a:pt x="455" y="16"/>
                      <a:pt x="455" y="29"/>
                      <a:pt x="457" y="29"/>
                    </a:cubicBezTo>
                    <a:cubicBezTo>
                      <a:pt x="458" y="29"/>
                      <a:pt x="460" y="30"/>
                      <a:pt x="461" y="28"/>
                    </a:cubicBezTo>
                    <a:cubicBezTo>
                      <a:pt x="463" y="22"/>
                      <a:pt x="463" y="10"/>
                      <a:pt x="466" y="2"/>
                    </a:cubicBezTo>
                    <a:cubicBezTo>
                      <a:pt x="466" y="1"/>
                      <a:pt x="474" y="0"/>
                      <a:pt x="475" y="0"/>
                    </a:cubicBezTo>
                    <a:cubicBezTo>
                      <a:pt x="479" y="0"/>
                      <a:pt x="480" y="0"/>
                      <a:pt x="484" y="0"/>
                    </a:cubicBezTo>
                    <a:cubicBezTo>
                      <a:pt x="488" y="0"/>
                      <a:pt x="491" y="0"/>
                      <a:pt x="495" y="0"/>
                    </a:cubicBezTo>
                    <a:cubicBezTo>
                      <a:pt x="497" y="0"/>
                      <a:pt x="495" y="0"/>
                      <a:pt x="510" y="0"/>
                    </a:cubicBezTo>
                    <a:cubicBezTo>
                      <a:pt x="512" y="0"/>
                      <a:pt x="511" y="23"/>
                      <a:pt x="516" y="28"/>
                    </a:cubicBezTo>
                    <a:cubicBezTo>
                      <a:pt x="516" y="29"/>
                      <a:pt x="520" y="29"/>
                      <a:pt x="521" y="29"/>
                    </a:cubicBezTo>
                    <a:cubicBezTo>
                      <a:pt x="523" y="29"/>
                      <a:pt x="523" y="10"/>
                      <a:pt x="524" y="10"/>
                    </a:cubicBezTo>
                    <a:cubicBezTo>
                      <a:pt x="526" y="10"/>
                      <a:pt x="531" y="10"/>
                      <a:pt x="532" y="10"/>
                    </a:cubicBezTo>
                    <a:cubicBezTo>
                      <a:pt x="534" y="10"/>
                      <a:pt x="534" y="28"/>
                      <a:pt x="536" y="28"/>
                    </a:cubicBezTo>
                    <a:cubicBezTo>
                      <a:pt x="537" y="27"/>
                      <a:pt x="538" y="29"/>
                      <a:pt x="539" y="28"/>
                    </a:cubicBezTo>
                    <a:cubicBezTo>
                      <a:pt x="544" y="23"/>
                      <a:pt x="540" y="3"/>
                      <a:pt x="550" y="1"/>
                    </a:cubicBezTo>
                    <a:cubicBezTo>
                      <a:pt x="554" y="0"/>
                      <a:pt x="559" y="1"/>
                      <a:pt x="563" y="1"/>
                    </a:cubicBezTo>
                    <a:cubicBezTo>
                      <a:pt x="566" y="1"/>
                      <a:pt x="569" y="0"/>
                      <a:pt x="571" y="0"/>
                    </a:cubicBezTo>
                  </a:path>
                </a:pathLst>
              </a:custGeom>
              <a:noFill/>
              <a:ln w="9525">
                <a:solidFill>
                  <a:srgbClr val="24211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 dirty="0"/>
              </a:p>
            </p:txBody>
          </p:sp>
          <p:grpSp>
            <p:nvGrpSpPr>
              <p:cNvPr id="129" name="Grupo 128">
                <a:extLst>
                  <a:ext uri="{FF2B5EF4-FFF2-40B4-BE49-F238E27FC236}">
                    <a16:creationId xmlns="" xmlns:a16="http://schemas.microsoft.com/office/drawing/2014/main" id="{9EE7F03A-E7A3-4783-967E-DF934D40D059}"/>
                  </a:ext>
                </a:extLst>
              </p:cNvPr>
              <p:cNvGrpSpPr/>
              <p:nvPr/>
            </p:nvGrpSpPr>
            <p:grpSpPr>
              <a:xfrm>
                <a:off x="1791199" y="2317461"/>
                <a:ext cx="2518744" cy="0"/>
                <a:chOff x="1062385" y="1268760"/>
                <a:chExt cx="2834080" cy="0"/>
              </a:xfrm>
            </p:grpSpPr>
            <p:cxnSp>
              <p:nvCxnSpPr>
                <p:cNvPr id="130" name="91 Conector recto">
                  <a:extLst>
                    <a:ext uri="{FF2B5EF4-FFF2-40B4-BE49-F238E27FC236}">
                      <a16:creationId xmlns="" xmlns:a16="http://schemas.microsoft.com/office/drawing/2014/main" id="{4C3D8083-E769-446B-B8F0-DE1FBD060205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62385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31" name="91 Conector recto">
                  <a:extLst>
                    <a:ext uri="{FF2B5EF4-FFF2-40B4-BE49-F238E27FC236}">
                      <a16:creationId xmlns="" xmlns:a16="http://schemas.microsoft.com/office/drawing/2014/main" id="{DC185039-5DAC-40EC-ACDA-211861897EE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47680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32" name="91 Conector recto">
                  <a:extLst>
                    <a:ext uri="{FF2B5EF4-FFF2-40B4-BE49-F238E27FC236}">
                      <a16:creationId xmlns="" xmlns:a16="http://schemas.microsoft.com/office/drawing/2014/main" id="{49DAD4D2-355F-4F40-BC61-3F53F865903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979712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33" name="91 Conector recto">
                  <a:extLst>
                    <a:ext uri="{FF2B5EF4-FFF2-40B4-BE49-F238E27FC236}">
                      <a16:creationId xmlns="" xmlns:a16="http://schemas.microsoft.com/office/drawing/2014/main" id="{1E2225B5-362A-472C-8FF7-B7FE5FD2612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396454" y="1268760"/>
                  <a:ext cx="1692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34" name="91 Conector recto">
                  <a:extLst>
                    <a:ext uri="{FF2B5EF4-FFF2-40B4-BE49-F238E27FC236}">
                      <a16:creationId xmlns="" xmlns:a16="http://schemas.microsoft.com/office/drawing/2014/main" id="{61695CE4-7636-4AC8-8178-595BA44CD10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873216" y="1268760"/>
                  <a:ext cx="180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35" name="91 Conector recto">
                  <a:extLst>
                    <a:ext uri="{FF2B5EF4-FFF2-40B4-BE49-F238E27FC236}">
                      <a16:creationId xmlns="" xmlns:a16="http://schemas.microsoft.com/office/drawing/2014/main" id="{5F20F57E-78A1-47EB-A036-427D446B94B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305476" y="1268760"/>
                  <a:ext cx="162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36" name="91 Conector recto">
                  <a:extLst>
                    <a:ext uri="{FF2B5EF4-FFF2-40B4-BE49-F238E27FC236}">
                      <a16:creationId xmlns="" xmlns:a16="http://schemas.microsoft.com/office/drawing/2014/main" id="{86885EC1-694B-44B0-BE6B-3E7872B6635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723665" y="1268760"/>
                  <a:ext cx="1728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137" name="116 Grupo">
                <a:extLst>
                  <a:ext uri="{FF2B5EF4-FFF2-40B4-BE49-F238E27FC236}">
                    <a16:creationId xmlns="" xmlns:a16="http://schemas.microsoft.com/office/drawing/2014/main" id="{8A86DC3F-3DD4-44C4-B8ED-B3EC397A7F4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232696" y="2286255"/>
                <a:ext cx="296441" cy="569948"/>
                <a:chOff x="184357" y="1859058"/>
                <a:chExt cx="488857" cy="569822"/>
              </a:xfrm>
            </p:grpSpPr>
            <p:sp>
              <p:nvSpPr>
                <p:cNvPr id="138" name="117 CuadroTexto">
                  <a:extLst>
                    <a:ext uri="{FF2B5EF4-FFF2-40B4-BE49-F238E27FC236}">
                      <a16:creationId xmlns="" xmlns:a16="http://schemas.microsoft.com/office/drawing/2014/main" id="{D60E34C8-1390-485F-9B5A-A9B1145701B0}"/>
                    </a:ext>
                  </a:extLst>
                </p:cNvPr>
                <p:cNvSpPr txBox="1"/>
                <p:nvPr/>
              </p:nvSpPr>
              <p:spPr>
                <a:xfrm rot="16200000">
                  <a:off x="115403" y="1936161"/>
                  <a:ext cx="458682" cy="304476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75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150 </a:t>
                  </a:r>
                  <a:r>
                    <a:rPr lang="es-ES" sz="750" kern="0" dirty="0" err="1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nA</a:t>
                  </a:r>
                  <a:endParaRPr lang="es-MX" sz="75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grpSp>
              <p:nvGrpSpPr>
                <p:cNvPr id="139" name="118 Grupo">
                  <a:extLst>
                    <a:ext uri="{FF2B5EF4-FFF2-40B4-BE49-F238E27FC236}">
                      <a16:creationId xmlns="" xmlns:a16="http://schemas.microsoft.com/office/drawing/2014/main" id="{0D821260-23CA-46FF-8B4B-E844E6855A9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84357" y="1971775"/>
                  <a:ext cx="488857" cy="457105"/>
                  <a:chOff x="204204" y="1975108"/>
                  <a:chExt cx="488857" cy="457105"/>
                </a:xfrm>
              </p:grpSpPr>
              <p:cxnSp>
                <p:nvCxnSpPr>
                  <p:cNvPr id="140" name="119 Conector recto">
                    <a:extLst>
                      <a:ext uri="{FF2B5EF4-FFF2-40B4-BE49-F238E27FC236}">
                        <a16:creationId xmlns="" xmlns:a16="http://schemas.microsoft.com/office/drawing/2014/main" id="{9C70E19A-FD85-4FF3-9DDE-349B4E3C384A}"/>
                      </a:ext>
                    </a:extLst>
                  </p:cNvPr>
                  <p:cNvCxnSpPr/>
                  <p:nvPr/>
                </p:nvCxnSpPr>
                <p:spPr>
                  <a:xfrm>
                    <a:off x="493589" y="1975108"/>
                    <a:ext cx="0" cy="2856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1" name="120 Conector recto">
                    <a:extLst>
                      <a:ext uri="{FF2B5EF4-FFF2-40B4-BE49-F238E27FC236}">
                        <a16:creationId xmlns="" xmlns:a16="http://schemas.microsoft.com/office/drawing/2014/main" id="{C93FCB73-A66B-4092-9A3E-CCD603096C9C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7956" y="2254138"/>
                    <a:ext cx="385105" cy="0"/>
                  </a:xfrm>
                  <a:prstGeom prst="line">
                    <a:avLst/>
                  </a:prstGeom>
                  <a:noFill/>
                  <a:ln w="9525" algn="ctr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sp>
                <p:nvSpPr>
                  <p:cNvPr id="142" name="121 CuadroTexto">
                    <a:extLst>
                      <a:ext uri="{FF2B5EF4-FFF2-40B4-BE49-F238E27FC236}">
                        <a16:creationId xmlns="" xmlns:a16="http://schemas.microsoft.com/office/drawing/2014/main" id="{B1673C0B-23D2-4848-B572-5C3A52B8C88B}"/>
                      </a:ext>
                    </a:extLst>
                  </p:cNvPr>
                  <p:cNvSpPr txBox="1"/>
                  <p:nvPr/>
                </p:nvSpPr>
                <p:spPr>
                  <a:xfrm>
                    <a:off x="204204" y="2222707"/>
                    <a:ext cx="425423" cy="209506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s-ES" sz="800" kern="0" dirty="0">
                        <a:solidFill>
                          <a:sysClr val="windowText" lastClr="000000"/>
                        </a:solidFill>
                        <a:latin typeface="+mn-lt"/>
                        <a:cs typeface="Arial" pitchFamily="34" charset="0"/>
                      </a:rPr>
                      <a:t>4 min</a:t>
                    </a:r>
                    <a:endParaRPr lang="es-MX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143" name="Grupo 142">
                <a:extLst>
                  <a:ext uri="{FF2B5EF4-FFF2-40B4-BE49-F238E27FC236}">
                    <a16:creationId xmlns="" xmlns:a16="http://schemas.microsoft.com/office/drawing/2014/main" id="{06AE1FBC-B580-4723-A866-17E8B26CED46}"/>
                  </a:ext>
                </a:extLst>
              </p:cNvPr>
              <p:cNvGrpSpPr/>
              <p:nvPr/>
            </p:nvGrpSpPr>
            <p:grpSpPr>
              <a:xfrm>
                <a:off x="2258883" y="2195766"/>
                <a:ext cx="2033130" cy="7648"/>
                <a:chOff x="1605252" y="1127498"/>
                <a:chExt cx="2287669" cy="7648"/>
              </a:xfrm>
            </p:grpSpPr>
            <p:cxnSp>
              <p:nvCxnSpPr>
                <p:cNvPr id="144" name="92 Conector recto">
                  <a:extLst>
                    <a:ext uri="{FF2B5EF4-FFF2-40B4-BE49-F238E27FC236}">
                      <a16:creationId xmlns="" xmlns:a16="http://schemas.microsoft.com/office/drawing/2014/main" id="{6EBA58F8-F266-429C-8E01-8E9FFC710A4F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605252" y="1135146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5" name="94 Conector recto">
                  <a:extLst>
                    <a:ext uri="{FF2B5EF4-FFF2-40B4-BE49-F238E27FC236}">
                      <a16:creationId xmlns="" xmlns:a16="http://schemas.microsoft.com/office/drawing/2014/main" id="{8A24646E-9D1F-4C4C-99DC-3C8C82471D37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036525" y="1135146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6" name="100 Conector recto">
                  <a:extLst>
                    <a:ext uri="{FF2B5EF4-FFF2-40B4-BE49-F238E27FC236}">
                      <a16:creationId xmlns="" xmlns:a16="http://schemas.microsoft.com/office/drawing/2014/main" id="{1FD643F4-5E51-4C76-A6AE-B28D627F048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471070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7" name="101 Conector recto">
                  <a:extLst>
                    <a:ext uri="{FF2B5EF4-FFF2-40B4-BE49-F238E27FC236}">
                      <a16:creationId xmlns="" xmlns:a16="http://schemas.microsoft.com/office/drawing/2014/main" id="{DC01F21F-7835-4A4F-9B81-39672D9E0C99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953267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8" name="102 Conector recto">
                  <a:extLst>
                    <a:ext uri="{FF2B5EF4-FFF2-40B4-BE49-F238E27FC236}">
                      <a16:creationId xmlns="" xmlns:a16="http://schemas.microsoft.com/office/drawing/2014/main" id="{EF4158F6-F39B-4473-A503-48179426C29E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385315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9" name="103 Conector recto">
                  <a:extLst>
                    <a:ext uri="{FF2B5EF4-FFF2-40B4-BE49-F238E27FC236}">
                      <a16:creationId xmlns="" xmlns:a16="http://schemas.microsoft.com/office/drawing/2014/main" id="{028F81E0-67BD-4213-AC78-6AB6591592A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797372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150" name="Grupo 149">
                <a:extLst>
                  <a:ext uri="{FF2B5EF4-FFF2-40B4-BE49-F238E27FC236}">
                    <a16:creationId xmlns="" xmlns:a16="http://schemas.microsoft.com/office/drawing/2014/main" id="{71BD4FFD-8DF5-46D2-8DA8-BD4FC3D35580}"/>
                  </a:ext>
                </a:extLst>
              </p:cNvPr>
              <p:cNvGrpSpPr/>
              <p:nvPr/>
            </p:nvGrpSpPr>
            <p:grpSpPr>
              <a:xfrm>
                <a:off x="2180322" y="2007036"/>
                <a:ext cx="2179186" cy="223455"/>
                <a:chOff x="1475656" y="1003813"/>
                <a:chExt cx="2452010" cy="223455"/>
              </a:xfrm>
            </p:grpSpPr>
            <p:sp>
              <p:nvSpPr>
                <p:cNvPr id="151" name="104 CuadroTexto">
                  <a:extLst>
                    <a:ext uri="{FF2B5EF4-FFF2-40B4-BE49-F238E27FC236}">
                      <a16:creationId xmlns="" xmlns:a16="http://schemas.microsoft.com/office/drawing/2014/main" id="{5A828665-BA07-46A8-8C6C-29205179859E}"/>
                    </a:ext>
                  </a:extLst>
                </p:cNvPr>
                <p:cNvSpPr txBox="1"/>
                <p:nvPr/>
              </p:nvSpPr>
              <p:spPr bwMode="auto">
                <a:xfrm>
                  <a:off x="1475656" y="1010782"/>
                  <a:ext cx="239219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0.3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52" name="105 CuadroTexto">
                  <a:extLst>
                    <a:ext uri="{FF2B5EF4-FFF2-40B4-BE49-F238E27FC236}">
                      <a16:creationId xmlns="" xmlns:a16="http://schemas.microsoft.com/office/drawing/2014/main" id="{B83E43FD-57A7-4B46-BA87-12C7639FF995}"/>
                    </a:ext>
                  </a:extLst>
                </p:cNvPr>
                <p:cNvSpPr txBox="1"/>
                <p:nvPr/>
              </p:nvSpPr>
              <p:spPr bwMode="auto">
                <a:xfrm>
                  <a:off x="1929686" y="1011824"/>
                  <a:ext cx="180395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53" name="106 CuadroTexto">
                  <a:extLst>
                    <a:ext uri="{FF2B5EF4-FFF2-40B4-BE49-F238E27FC236}">
                      <a16:creationId xmlns="" xmlns:a16="http://schemas.microsoft.com/office/drawing/2014/main" id="{076508C2-B8C2-4EB4-BE1D-BC729CACC182}"/>
                    </a:ext>
                  </a:extLst>
                </p:cNvPr>
                <p:cNvSpPr txBox="1"/>
                <p:nvPr/>
              </p:nvSpPr>
              <p:spPr bwMode="auto">
                <a:xfrm>
                  <a:off x="2336455" y="1009129"/>
                  <a:ext cx="219611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54" name="107 CuadroTexto">
                  <a:extLst>
                    <a:ext uri="{FF2B5EF4-FFF2-40B4-BE49-F238E27FC236}">
                      <a16:creationId xmlns="" xmlns:a16="http://schemas.microsoft.com/office/drawing/2014/main" id="{DC4296B0-3FD5-473E-84AF-D59D64512709}"/>
                    </a:ext>
                  </a:extLst>
                </p:cNvPr>
                <p:cNvSpPr txBox="1"/>
                <p:nvPr/>
              </p:nvSpPr>
              <p:spPr bwMode="auto">
                <a:xfrm>
                  <a:off x="2793018" y="1003814"/>
                  <a:ext cx="258827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55" name="108 CuadroTexto">
                  <a:extLst>
                    <a:ext uri="{FF2B5EF4-FFF2-40B4-BE49-F238E27FC236}">
                      <a16:creationId xmlns="" xmlns:a16="http://schemas.microsoft.com/office/drawing/2014/main" id="{13D5DFA0-C566-4C67-83D9-74021A3D65E7}"/>
                    </a:ext>
                  </a:extLst>
                </p:cNvPr>
                <p:cNvSpPr txBox="1"/>
                <p:nvPr/>
              </p:nvSpPr>
              <p:spPr bwMode="auto">
                <a:xfrm>
                  <a:off x="3216871" y="1003813"/>
                  <a:ext cx="298044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56" name="109 CuadroTexto">
                  <a:extLst>
                    <a:ext uri="{FF2B5EF4-FFF2-40B4-BE49-F238E27FC236}">
                      <a16:creationId xmlns="" xmlns:a16="http://schemas.microsoft.com/office/drawing/2014/main" id="{F568E6D1-3E35-4BFE-B1DF-92BC7AE4D060}"/>
                    </a:ext>
                  </a:extLst>
                </p:cNvPr>
                <p:cNvSpPr txBox="1"/>
                <p:nvPr/>
              </p:nvSpPr>
              <p:spPr bwMode="auto">
                <a:xfrm>
                  <a:off x="3590406" y="1003813"/>
                  <a:ext cx="337260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545" name="Grupo 544">
              <a:extLst>
                <a:ext uri="{FF2B5EF4-FFF2-40B4-BE49-F238E27FC236}">
                  <a16:creationId xmlns="" xmlns:a16="http://schemas.microsoft.com/office/drawing/2014/main" id="{5CE070F2-009F-45C2-98F3-1A62555087F0}"/>
                </a:ext>
              </a:extLst>
            </p:cNvPr>
            <p:cNvGrpSpPr/>
            <p:nvPr/>
          </p:nvGrpSpPr>
          <p:grpSpPr>
            <a:xfrm>
              <a:off x="4618617" y="970953"/>
              <a:ext cx="2570181" cy="3084635"/>
              <a:chOff x="4618617" y="970953"/>
              <a:chExt cx="2570181" cy="3084635"/>
            </a:xfrm>
          </p:grpSpPr>
          <p:grpSp>
            <p:nvGrpSpPr>
              <p:cNvPr id="354" name="230 Grupo">
                <a:extLst>
                  <a:ext uri="{FF2B5EF4-FFF2-40B4-BE49-F238E27FC236}">
                    <a16:creationId xmlns="" xmlns:a16="http://schemas.microsoft.com/office/drawing/2014/main" id="{711B8E71-4E80-44FC-AC91-D0D9CF33CB7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5210851" y="3764192"/>
                <a:ext cx="1850159" cy="175769"/>
                <a:chOff x="6192396" y="3107352"/>
                <a:chExt cx="2638234" cy="151071"/>
              </a:xfrm>
            </p:grpSpPr>
            <p:sp>
              <p:nvSpPr>
                <p:cNvPr id="357" name="Rectangle 6">
                  <a:extLst>
                    <a:ext uri="{FF2B5EF4-FFF2-40B4-BE49-F238E27FC236}">
                      <a16:creationId xmlns="" xmlns:a16="http://schemas.microsoft.com/office/drawing/2014/main" id="{380C5309-25F6-4887-94D5-4689CE029B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92396" y="3107383"/>
                  <a:ext cx="202788" cy="1425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ES" sz="9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900" kern="0" baseline="30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6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8" name="Rectangle 6">
                  <a:extLst>
                    <a:ext uri="{FF2B5EF4-FFF2-40B4-BE49-F238E27FC236}">
                      <a16:creationId xmlns="" xmlns:a16="http://schemas.microsoft.com/office/drawing/2014/main" id="{4082896D-8EC5-4A29-9BB4-5892F3CE6B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27072" y="3107383"/>
                  <a:ext cx="308941" cy="119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ES" sz="9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900" kern="0" baseline="30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5  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9" name="Rectangle 6">
                  <a:extLst>
                    <a:ext uri="{FF2B5EF4-FFF2-40B4-BE49-F238E27FC236}">
                      <a16:creationId xmlns="" xmlns:a16="http://schemas.microsoft.com/office/drawing/2014/main" id="{19BF128A-A25D-4BF4-9B6C-E2B1F84D3B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375226" y="3107352"/>
                  <a:ext cx="202788" cy="1425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ES" sz="9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900" kern="0" baseline="30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4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0" name="Rectangle 6">
                  <a:extLst>
                    <a:ext uri="{FF2B5EF4-FFF2-40B4-BE49-F238E27FC236}">
                      <a16:creationId xmlns="" xmlns:a16="http://schemas.microsoft.com/office/drawing/2014/main" id="{F6468717-0E13-47FF-8895-EEFB54F0D9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52642" y="3115857"/>
                  <a:ext cx="223065" cy="1425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ES" sz="9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900" kern="0" baseline="30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3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4" name="Rectangle 6">
                  <a:extLst>
                    <a:ext uri="{FF2B5EF4-FFF2-40B4-BE49-F238E27FC236}">
                      <a16:creationId xmlns="" xmlns:a16="http://schemas.microsoft.com/office/drawing/2014/main" id="{DB884C36-C239-4B69-8F11-1C19024557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49475" y="3115624"/>
                  <a:ext cx="281155" cy="119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ES" sz="900" kern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s-ES" sz="900" kern="0" baseline="30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6" name="Rectangle 181">
                <a:extLst>
                  <a:ext uri="{FF2B5EF4-FFF2-40B4-BE49-F238E27FC236}">
                    <a16:creationId xmlns="" xmlns:a16="http://schemas.microsoft.com/office/drawing/2014/main" id="{CC9CBCC0-041A-4C9C-92E5-55DD519F55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9437" y="3927979"/>
                <a:ext cx="944180" cy="1276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[</a:t>
                </a:r>
                <a:r>
                  <a:rPr kumimoji="0" lang="es-MX" altLang="es-MX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Homotaurine</a:t>
                </a:r>
                <a:r>
                  <a:rPr kumimoji="0" lang="es-MX" altLang="es-MX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] </a:t>
                </a:r>
                <a:r>
                  <a:rPr lang="es-MX" altLang="es-MX" sz="900" dirty="0">
                    <a:solidFill>
                      <a:srgbClr val="000000"/>
                    </a:solidFill>
                  </a:rPr>
                  <a:t>(</a:t>
                </a:r>
                <a:r>
                  <a:rPr kumimoji="0" lang="es-MX" altLang="es-MX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)</a:t>
                </a:r>
                <a:endParaRPr kumimoji="0" lang="es-MX" altLang="es-MX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grpSp>
            <p:nvGrpSpPr>
              <p:cNvPr id="190" name="791 Grupo">
                <a:extLst>
                  <a:ext uri="{FF2B5EF4-FFF2-40B4-BE49-F238E27FC236}">
                    <a16:creationId xmlns="" xmlns:a16="http://schemas.microsoft.com/office/drawing/2014/main" id="{7B87F76B-5729-40AE-9251-3280B632BE05}"/>
                  </a:ext>
                </a:extLst>
              </p:cNvPr>
              <p:cNvGrpSpPr/>
              <p:nvPr/>
            </p:nvGrpSpPr>
            <p:grpSpPr>
              <a:xfrm>
                <a:off x="5081970" y="2738400"/>
                <a:ext cx="1104373" cy="834622"/>
                <a:chOff x="46727" y="1750024"/>
                <a:chExt cx="1531159" cy="696886"/>
              </a:xfrm>
            </p:grpSpPr>
            <p:sp>
              <p:nvSpPr>
                <p:cNvPr id="347" name="Rectangle 219">
                  <a:extLst>
                    <a:ext uri="{FF2B5EF4-FFF2-40B4-BE49-F238E27FC236}">
                      <a16:creationId xmlns="" xmlns:a16="http://schemas.microsoft.com/office/drawing/2014/main" id="{A2B76250-4621-4E6C-A420-DFD5064BB0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8183" y="1983071"/>
                  <a:ext cx="1292177" cy="2055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MX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3 m</a:t>
                  </a: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M </a:t>
                  </a:r>
                  <a:r>
                    <a:rPr lang="es-ES" sz="800" kern="0" dirty="0" err="1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Hypo</a:t>
                  </a:r>
                  <a:r>
                    <a:rPr lang="es-MX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</a:t>
                  </a:r>
                </a:p>
                <a:p>
                  <a:pPr>
                    <a:defRPr/>
                  </a:pP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IC</a:t>
                  </a:r>
                  <a:r>
                    <a:rPr lang="es-ES" sz="800" kern="0" baseline="-2500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50</a:t>
                  </a: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= 160 µM, </a:t>
                  </a:r>
                  <a:r>
                    <a:rPr lang="es-ES" sz="800" kern="0" dirty="0" err="1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nH</a:t>
                  </a: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= 1.0</a:t>
                  </a:r>
                  <a:endParaRPr lang="es-MX" sz="800" kern="0" dirty="0">
                    <a:solidFill>
                      <a:prstClr val="black"/>
                    </a:solidFill>
                    <a:latin typeface="Arial Narrow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" name="Rectangle 219">
                  <a:extLst>
                    <a:ext uri="{FF2B5EF4-FFF2-40B4-BE49-F238E27FC236}">
                      <a16:creationId xmlns="" xmlns:a16="http://schemas.microsoft.com/office/drawing/2014/main" id="{2A2EFBC7-208C-4CC2-B981-DBF56A3605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0967" y="1750024"/>
                  <a:ext cx="1426919" cy="1894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/>
                <a:p>
                  <a:pPr>
                    <a:defRPr/>
                  </a:pPr>
                  <a:r>
                    <a:rPr lang="es-MX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30 </a:t>
                  </a: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µM </a:t>
                  </a:r>
                  <a:r>
                    <a:rPr lang="es-MX" sz="800" kern="0" dirty="0" err="1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Hypo</a:t>
                  </a:r>
                  <a:r>
                    <a:rPr lang="es-MX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</a:t>
                  </a:r>
                </a:p>
                <a:p>
                  <a:pPr>
                    <a:defRPr/>
                  </a:pP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IC</a:t>
                  </a:r>
                  <a:r>
                    <a:rPr lang="es-ES" sz="800" kern="0" baseline="-2500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50</a:t>
                  </a: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 = 100 µM, </a:t>
                  </a:r>
                  <a:r>
                    <a:rPr lang="es-ES" sz="800" kern="0" dirty="0" err="1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nH</a:t>
                  </a:r>
                  <a:r>
                    <a:rPr lang="es-ES" sz="800" kern="0" dirty="0">
                      <a:solidFill>
                        <a:srgbClr val="000000"/>
                      </a:solidFill>
                      <a:latin typeface="Arial Narrow" pitchFamily="34" charset="0"/>
                      <a:cs typeface="Arial" pitchFamily="34" charset="0"/>
                    </a:rPr>
                    <a:t>= 1.6</a:t>
                  </a:r>
                  <a:endParaRPr lang="es-MX" sz="800" kern="0" dirty="0">
                    <a:solidFill>
                      <a:prstClr val="black"/>
                    </a:solidFill>
                    <a:latin typeface="Arial Narrow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351" name="231 Grupo">
                  <a:extLst>
                    <a:ext uri="{FF2B5EF4-FFF2-40B4-BE49-F238E27FC236}">
                      <a16:creationId xmlns="" xmlns:a16="http://schemas.microsoft.com/office/drawing/2014/main" id="{FC8C906F-0E16-427A-B626-EAE4197A561D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46727" y="1998978"/>
                  <a:ext cx="1422943" cy="447932"/>
                  <a:chOff x="6521673" y="718474"/>
                  <a:chExt cx="1463477" cy="461082"/>
                </a:xfrm>
              </p:grpSpPr>
              <p:sp>
                <p:nvSpPr>
                  <p:cNvPr id="352" name="Freeform 218">
                    <a:extLst>
                      <a:ext uri="{FF2B5EF4-FFF2-40B4-BE49-F238E27FC236}">
                        <a16:creationId xmlns="" xmlns:a16="http://schemas.microsoft.com/office/drawing/2014/main" id="{26E90B78-91E2-4F88-B736-D976F3C1DA9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521673" y="718474"/>
                    <a:ext cx="93066" cy="70266"/>
                  </a:xfrm>
                  <a:custGeom>
                    <a:avLst/>
                    <a:gdLst>
                      <a:gd name="T0" fmla="*/ 0 w 133"/>
                      <a:gd name="T1" fmla="*/ 67 h 133"/>
                      <a:gd name="T2" fmla="*/ 67 w 133"/>
                      <a:gd name="T3" fmla="*/ 0 h 133"/>
                      <a:gd name="T4" fmla="*/ 133 w 133"/>
                      <a:gd name="T5" fmla="*/ 67 h 133"/>
                      <a:gd name="T6" fmla="*/ 67 w 133"/>
                      <a:gd name="T7" fmla="*/ 133 h 133"/>
                      <a:gd name="T8" fmla="*/ 0 w 133"/>
                      <a:gd name="T9" fmla="*/ 67 h 13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</a:cxnLst>
                    <a:rect l="0" t="0" r="r" b="b"/>
                    <a:pathLst>
                      <a:path w="133" h="133">
                        <a:moveTo>
                          <a:pt x="0" y="67"/>
                        </a:moveTo>
                        <a:lnTo>
                          <a:pt x="67" y="0"/>
                        </a:lnTo>
                        <a:lnTo>
                          <a:pt x="133" y="67"/>
                        </a:lnTo>
                        <a:lnTo>
                          <a:pt x="67" y="133"/>
                        </a:lnTo>
                        <a:lnTo>
                          <a:pt x="0" y="67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s-MX" sz="800" kern="0">
                      <a:solidFill>
                        <a:sysClr val="windowText" lastClr="000000"/>
                      </a:solidFill>
                      <a:latin typeface="Arial Narrow" panose="020B0606020202030204" pitchFamily="34" charset="0"/>
                      <a:cs typeface="+mn-cs"/>
                    </a:endParaRPr>
                  </a:p>
                </p:txBody>
              </p:sp>
              <p:sp>
                <p:nvSpPr>
                  <p:cNvPr id="353" name="Rectangle 219">
                    <a:extLst>
                      <a:ext uri="{FF2B5EF4-FFF2-40B4-BE49-F238E27FC236}">
                        <a16:creationId xmlns="" xmlns:a16="http://schemas.microsoft.com/office/drawing/2014/main" id="{CE5613C6-62F8-45C6-9CB9-467B5C801F9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670843" y="967932"/>
                    <a:ext cx="1314307" cy="21162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 lIns="0" tIns="0" rIns="0" bIns="0">
                    <a:spAutoFit/>
                  </a:bodyPr>
                  <a:lstStyle/>
                  <a:p>
                    <a:pPr>
                      <a:defRPr/>
                    </a:pPr>
                    <a:r>
                      <a:rPr lang="es-MX" sz="800" kern="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 30 </a:t>
                    </a:r>
                    <a:r>
                      <a:rPr lang="es-ES" sz="800" kern="0" dirty="0" err="1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mM</a:t>
                    </a:r>
                    <a:r>
                      <a:rPr lang="es-ES" sz="800" kern="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 </a:t>
                    </a:r>
                    <a:r>
                      <a:rPr lang="es-MX" sz="800" kern="0" dirty="0" err="1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Hypo</a:t>
                    </a:r>
                    <a:r>
                      <a:rPr lang="es-MX" sz="800" kern="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 </a:t>
                    </a:r>
                  </a:p>
                  <a:p>
                    <a:pPr>
                      <a:defRPr/>
                    </a:pPr>
                    <a:r>
                      <a:rPr lang="es-ES" sz="800" kern="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 IC</a:t>
                    </a:r>
                    <a:r>
                      <a:rPr lang="es-ES" sz="800" kern="0" baseline="-2500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50</a:t>
                    </a:r>
                    <a:r>
                      <a:rPr lang="es-ES" sz="800" kern="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 = 230 µM, </a:t>
                    </a:r>
                    <a:r>
                      <a:rPr lang="es-ES" sz="800" kern="0" dirty="0" err="1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nH</a:t>
                    </a:r>
                    <a:r>
                      <a:rPr lang="es-ES" sz="800" kern="0" dirty="0">
                        <a:solidFill>
                          <a:srgbClr val="000000"/>
                        </a:solidFill>
                        <a:latin typeface="Arial Narrow" pitchFamily="34" charset="0"/>
                        <a:cs typeface="Arial" pitchFamily="34" charset="0"/>
                      </a:rPr>
                      <a:t>= 1.9</a:t>
                    </a:r>
                    <a:endParaRPr lang="es-MX" sz="800" kern="0" dirty="0">
                      <a:solidFill>
                        <a:prstClr val="black"/>
                      </a:solidFill>
                      <a:latin typeface="Arial Narrow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339" name="Grupo 338">
                <a:extLst>
                  <a:ext uri="{FF2B5EF4-FFF2-40B4-BE49-F238E27FC236}">
                    <a16:creationId xmlns="" xmlns:a16="http://schemas.microsoft.com/office/drawing/2014/main" id="{412668BD-006D-48B3-BBEA-36921457C7C3}"/>
                  </a:ext>
                </a:extLst>
              </p:cNvPr>
              <p:cNvGrpSpPr/>
              <p:nvPr/>
            </p:nvGrpSpPr>
            <p:grpSpPr>
              <a:xfrm>
                <a:off x="4769972" y="1130356"/>
                <a:ext cx="143126" cy="2450724"/>
                <a:chOff x="5056580" y="1054484"/>
                <a:chExt cx="224216" cy="2263733"/>
              </a:xfrm>
            </p:grpSpPr>
            <p:sp>
              <p:nvSpPr>
                <p:cNvPr id="341" name="Rectangle 12">
                  <a:extLst>
                    <a:ext uri="{FF2B5EF4-FFF2-40B4-BE49-F238E27FC236}">
                      <a16:creationId xmlns="" xmlns:a16="http://schemas.microsoft.com/office/drawing/2014/main" id="{CF221C33-E22B-4416-BF90-3B36A61F9E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64204" y="3167184"/>
                  <a:ext cx="105831" cy="1510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altLang="es-MX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es-MX" altLang="es-MX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2" name="Rectangle 13">
                  <a:extLst>
                    <a:ext uri="{FF2B5EF4-FFF2-40B4-BE49-F238E27FC236}">
                      <a16:creationId xmlns="" xmlns:a16="http://schemas.microsoft.com/office/drawing/2014/main" id="{76F9F260-AB8D-4195-AE0B-1873098126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10395" y="2743941"/>
                  <a:ext cx="165024" cy="1510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altLang="es-MX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</a:t>
                  </a:r>
                  <a:endParaRPr kumimoji="0" lang="es-MX" altLang="es-MX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3" name="Rectangle 14">
                  <a:extLst>
                    <a:ext uri="{FF2B5EF4-FFF2-40B4-BE49-F238E27FC236}">
                      <a16:creationId xmlns="" xmlns:a16="http://schemas.microsoft.com/office/drawing/2014/main" id="{983E4548-24AD-4562-857B-ED19721DFC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10395" y="2322454"/>
                  <a:ext cx="165024" cy="1510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altLang="es-MX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</a:t>
                  </a:r>
                  <a:endParaRPr kumimoji="0" lang="es-MX" altLang="es-MX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4" name="Rectangle 15">
                  <a:extLst>
                    <a:ext uri="{FF2B5EF4-FFF2-40B4-BE49-F238E27FC236}">
                      <a16:creationId xmlns="" xmlns:a16="http://schemas.microsoft.com/office/drawing/2014/main" id="{0D7695A7-59A8-4149-BCE5-E9936FCF4B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10395" y="1899213"/>
                  <a:ext cx="165024" cy="1510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altLang="es-MX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</a:t>
                  </a:r>
                  <a:endParaRPr kumimoji="0" lang="es-MX" altLang="es-MX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5" name="Rectangle 16">
                  <a:extLst>
                    <a:ext uri="{FF2B5EF4-FFF2-40B4-BE49-F238E27FC236}">
                      <a16:creationId xmlns="" xmlns:a16="http://schemas.microsoft.com/office/drawing/2014/main" id="{5ED8D5C4-2051-45C1-A274-3DB6505E377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10395" y="1477726"/>
                  <a:ext cx="165024" cy="1510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altLang="es-MX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</a:t>
                  </a:r>
                  <a:endParaRPr kumimoji="0" lang="es-MX" altLang="es-MX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6" name="Rectangle 17">
                  <a:extLst>
                    <a:ext uri="{FF2B5EF4-FFF2-40B4-BE49-F238E27FC236}">
                      <a16:creationId xmlns="" xmlns:a16="http://schemas.microsoft.com/office/drawing/2014/main" id="{A604F23F-2262-4DF0-A8E2-95AF72FD9F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56580" y="1054484"/>
                  <a:ext cx="224216" cy="1510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altLang="es-MX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</a:t>
                  </a:r>
                  <a:endParaRPr kumimoji="0" lang="es-MX" altLang="es-MX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40" name="Rectangle 346">
                <a:extLst>
                  <a:ext uri="{FF2B5EF4-FFF2-40B4-BE49-F238E27FC236}">
                    <a16:creationId xmlns="" xmlns:a16="http://schemas.microsoft.com/office/drawing/2014/main" id="{0492658E-949D-4CF3-9385-FAB898802A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180869" y="2210816"/>
                <a:ext cx="1016146" cy="14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urrent</a:t>
                </a:r>
                <a:r>
                  <a:rPr kumimoji="0" lang="es-MX" altLang="es-MX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% of control)</a:t>
                </a:r>
                <a:endParaRPr kumimoji="0" lang="es-MX" altLang="es-MX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6" name="Line 33">
                <a:extLst>
                  <a:ext uri="{FF2B5EF4-FFF2-40B4-BE49-F238E27FC236}">
                    <a16:creationId xmlns="" xmlns:a16="http://schemas.microsoft.com/office/drawing/2014/main" id="{F82F3236-2B1E-4A7F-812C-6063E3A6D9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89901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77" name="Line 34">
                <a:extLst>
                  <a:ext uri="{FF2B5EF4-FFF2-40B4-BE49-F238E27FC236}">
                    <a16:creationId xmlns="" xmlns:a16="http://schemas.microsoft.com/office/drawing/2014/main" id="{B213E3D1-5F84-42A9-94B3-92C3CFD108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3341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78" name="Line 35">
                <a:extLst>
                  <a:ext uri="{FF2B5EF4-FFF2-40B4-BE49-F238E27FC236}">
                    <a16:creationId xmlns="" xmlns:a16="http://schemas.microsoft.com/office/drawing/2014/main" id="{C8ED33AA-DD05-43F3-8C37-73D68533CD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5182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79" name="Line 36">
                <a:extLst>
                  <a:ext uri="{FF2B5EF4-FFF2-40B4-BE49-F238E27FC236}">
                    <a16:creationId xmlns="" xmlns:a16="http://schemas.microsoft.com/office/drawing/2014/main" id="{10B27FB2-DBF5-4CB1-A4A2-CE06417198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4063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0" name="Line 37">
                <a:extLst>
                  <a:ext uri="{FF2B5EF4-FFF2-40B4-BE49-F238E27FC236}">
                    <a16:creationId xmlns="" xmlns:a16="http://schemas.microsoft.com/office/drawing/2014/main" id="{68E8D734-54B2-4F13-88F7-A99E3C1813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87182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1" name="Line 38">
                <a:extLst>
                  <a:ext uri="{FF2B5EF4-FFF2-40B4-BE49-F238E27FC236}">
                    <a16:creationId xmlns="" xmlns:a16="http://schemas.microsoft.com/office/drawing/2014/main" id="{71312EE4-C28B-4800-BB3E-13F584D362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14543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2" name="Line 39">
                <a:extLst>
                  <a:ext uri="{FF2B5EF4-FFF2-40B4-BE49-F238E27FC236}">
                    <a16:creationId xmlns="" xmlns:a16="http://schemas.microsoft.com/office/drawing/2014/main" id="{4BA62AF1-CE4B-4A94-9564-6C1573AADA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39023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3" name="Line 40">
                <a:extLst>
                  <a:ext uri="{FF2B5EF4-FFF2-40B4-BE49-F238E27FC236}">
                    <a16:creationId xmlns="" xmlns:a16="http://schemas.microsoft.com/office/drawing/2014/main" id="{753A5A94-8484-44E3-B757-E321F1ABDE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60623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4" name="Line 41">
                <a:extLst>
                  <a:ext uri="{FF2B5EF4-FFF2-40B4-BE49-F238E27FC236}">
                    <a16:creationId xmlns="" xmlns:a16="http://schemas.microsoft.com/office/drawing/2014/main" id="{AB7B7C8F-B792-4DD6-8C88-2A4CDF4DE7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79343" y="3690340"/>
                <a:ext cx="0" cy="539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5" name="Line 42">
                <a:extLst>
                  <a:ext uri="{FF2B5EF4-FFF2-40B4-BE49-F238E27FC236}">
                    <a16:creationId xmlns="" xmlns:a16="http://schemas.microsoft.com/office/drawing/2014/main" id="{AF0C2665-85A9-400E-8DD2-BDD52F6D9A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04624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6" name="Line 43">
                <a:extLst>
                  <a:ext uri="{FF2B5EF4-FFF2-40B4-BE49-F238E27FC236}">
                    <a16:creationId xmlns="" xmlns:a16="http://schemas.microsoft.com/office/drawing/2014/main" id="{07DC19A1-FD15-4DCA-A91F-73DBDCE246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662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7" name="Line 44">
                <a:extLst>
                  <a:ext uri="{FF2B5EF4-FFF2-40B4-BE49-F238E27FC236}">
                    <a16:creationId xmlns="" xmlns:a16="http://schemas.microsoft.com/office/drawing/2014/main" id="{12BDEDC5-F904-4885-9C33-A97FA171BB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2846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8" name="Line 45">
                <a:extLst>
                  <a:ext uri="{FF2B5EF4-FFF2-40B4-BE49-F238E27FC236}">
                    <a16:creationId xmlns="" xmlns:a16="http://schemas.microsoft.com/office/drawing/2014/main" id="{18AAAE40-EA3D-4154-86FD-4EFE11A2B2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7022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89" name="Line 46">
                <a:extLst>
                  <a:ext uri="{FF2B5EF4-FFF2-40B4-BE49-F238E27FC236}">
                    <a16:creationId xmlns="" xmlns:a16="http://schemas.microsoft.com/office/drawing/2014/main" id="{C6792D31-28FB-4A0F-B094-37FB8E59DA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01906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0" name="Line 47">
                <a:extLst>
                  <a:ext uri="{FF2B5EF4-FFF2-40B4-BE49-F238E27FC236}">
                    <a16:creationId xmlns="" xmlns:a16="http://schemas.microsoft.com/office/drawing/2014/main" id="{F8D4B86B-0FE6-4844-9BAD-875FA0E8E1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30706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1" name="Line 48">
                <a:extLst>
                  <a:ext uri="{FF2B5EF4-FFF2-40B4-BE49-F238E27FC236}">
                    <a16:creationId xmlns="" xmlns:a16="http://schemas.microsoft.com/office/drawing/2014/main" id="{6C16C0C6-5E80-41CE-82C8-7EFA9DB052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53746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2" name="Line 49">
                <a:extLst>
                  <a:ext uri="{FF2B5EF4-FFF2-40B4-BE49-F238E27FC236}">
                    <a16:creationId xmlns="" xmlns:a16="http://schemas.microsoft.com/office/drawing/2014/main" id="{06157C1F-73E9-49B3-B8FC-D620E0963C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75347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3" name="Line 50">
                <a:extLst>
                  <a:ext uri="{FF2B5EF4-FFF2-40B4-BE49-F238E27FC236}">
                    <a16:creationId xmlns="" xmlns:a16="http://schemas.microsoft.com/office/drawing/2014/main" id="{38BAA62C-0121-47E3-9E72-1DDD3C4010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94066" y="3690340"/>
                <a:ext cx="0" cy="539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4" name="Line 51">
                <a:extLst>
                  <a:ext uri="{FF2B5EF4-FFF2-40B4-BE49-F238E27FC236}">
                    <a16:creationId xmlns="" xmlns:a16="http://schemas.microsoft.com/office/drawing/2014/main" id="{0B925243-41FC-45E1-ABC6-25C6D96B11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19348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5" name="Line 52">
                <a:extLst>
                  <a:ext uri="{FF2B5EF4-FFF2-40B4-BE49-F238E27FC236}">
                    <a16:creationId xmlns="" xmlns:a16="http://schemas.microsoft.com/office/drawing/2014/main" id="{93DBDF6A-753A-41F4-9600-97930D8D9C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92788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6" name="Line 53">
                <a:extLst>
                  <a:ext uri="{FF2B5EF4-FFF2-40B4-BE49-F238E27FC236}">
                    <a16:creationId xmlns="" xmlns:a16="http://schemas.microsoft.com/office/drawing/2014/main" id="{941E241C-810D-4630-A4E4-5D23E8AB29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43189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7" name="Line 54">
                <a:extLst>
                  <a:ext uri="{FF2B5EF4-FFF2-40B4-BE49-F238E27FC236}">
                    <a16:creationId xmlns="" xmlns:a16="http://schemas.microsoft.com/office/drawing/2014/main" id="{B80AB96A-8FA6-4D24-B3E8-B5231B9078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83509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8" name="Line 55">
                <a:extLst>
                  <a:ext uri="{FF2B5EF4-FFF2-40B4-BE49-F238E27FC236}">
                    <a16:creationId xmlns="" xmlns:a16="http://schemas.microsoft.com/office/drawing/2014/main" id="{6D647937-DECA-423D-8E79-00DD7005C8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16629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399" name="Line 56">
                <a:extLst>
                  <a:ext uri="{FF2B5EF4-FFF2-40B4-BE49-F238E27FC236}">
                    <a16:creationId xmlns="" xmlns:a16="http://schemas.microsoft.com/office/drawing/2014/main" id="{496B6583-25EA-46A5-B07B-0A0A605B79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43989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0" name="Line 57">
                <a:extLst>
                  <a:ext uri="{FF2B5EF4-FFF2-40B4-BE49-F238E27FC236}">
                    <a16:creationId xmlns="" xmlns:a16="http://schemas.microsoft.com/office/drawing/2014/main" id="{5BC39DD7-3360-48E4-982B-EF2DA1E161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68469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1" name="Line 58">
                <a:extLst>
                  <a:ext uri="{FF2B5EF4-FFF2-40B4-BE49-F238E27FC236}">
                    <a16:creationId xmlns="" xmlns:a16="http://schemas.microsoft.com/office/drawing/2014/main" id="{A17481E1-7959-49C0-9446-8E28AC1063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90070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2" name="Line 59">
                <a:extLst>
                  <a:ext uri="{FF2B5EF4-FFF2-40B4-BE49-F238E27FC236}">
                    <a16:creationId xmlns="" xmlns:a16="http://schemas.microsoft.com/office/drawing/2014/main" id="{6CE54056-170E-4F3A-BE0E-BB5FEEB6AE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108789" y="3690340"/>
                <a:ext cx="0" cy="539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3" name="Line 60">
                <a:extLst>
                  <a:ext uri="{FF2B5EF4-FFF2-40B4-BE49-F238E27FC236}">
                    <a16:creationId xmlns="" xmlns:a16="http://schemas.microsoft.com/office/drawing/2014/main" id="{4D1924CF-005A-49B4-99F8-2D9F05A0D0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34071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4" name="Line 61">
                <a:extLst>
                  <a:ext uri="{FF2B5EF4-FFF2-40B4-BE49-F238E27FC236}">
                    <a16:creationId xmlns="" xmlns:a16="http://schemas.microsoft.com/office/drawing/2014/main" id="{BB650B53-6FB2-4BA8-BF08-457AD40695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06071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5" name="Line 62">
                <a:extLst>
                  <a:ext uri="{FF2B5EF4-FFF2-40B4-BE49-F238E27FC236}">
                    <a16:creationId xmlns="" xmlns:a16="http://schemas.microsoft.com/office/drawing/2014/main" id="{C3B1859E-54A1-407E-90F4-F01470ABF8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59351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6" name="Line 63">
                <a:extLst>
                  <a:ext uri="{FF2B5EF4-FFF2-40B4-BE49-F238E27FC236}">
                    <a16:creationId xmlns="" xmlns:a16="http://schemas.microsoft.com/office/drawing/2014/main" id="{C26A2F64-8F17-443A-AE62-FFD99941BE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99672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7" name="Line 64">
                <a:extLst>
                  <a:ext uri="{FF2B5EF4-FFF2-40B4-BE49-F238E27FC236}">
                    <a16:creationId xmlns="" xmlns:a16="http://schemas.microsoft.com/office/drawing/2014/main" id="{52510E04-55FA-424F-9BB5-1D91DC1578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31352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8" name="Line 65">
                <a:extLst>
                  <a:ext uri="{FF2B5EF4-FFF2-40B4-BE49-F238E27FC236}">
                    <a16:creationId xmlns="" xmlns:a16="http://schemas.microsoft.com/office/drawing/2014/main" id="{3AF1BFEE-2A55-4FEE-BA12-1A1A4779BC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60152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09" name="Line 66">
                <a:extLst>
                  <a:ext uri="{FF2B5EF4-FFF2-40B4-BE49-F238E27FC236}">
                    <a16:creationId xmlns="" xmlns:a16="http://schemas.microsoft.com/office/drawing/2014/main" id="{5B39FC37-C13B-48AC-ABE0-19FD03F13A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83192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0" name="Line 67">
                <a:extLst>
                  <a:ext uri="{FF2B5EF4-FFF2-40B4-BE49-F238E27FC236}">
                    <a16:creationId xmlns="" xmlns:a16="http://schemas.microsoft.com/office/drawing/2014/main" id="{41E9F548-F53B-4190-B45F-A6320654BA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504793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1" name="Line 68">
                <a:extLst>
                  <a:ext uri="{FF2B5EF4-FFF2-40B4-BE49-F238E27FC236}">
                    <a16:creationId xmlns="" xmlns:a16="http://schemas.microsoft.com/office/drawing/2014/main" id="{67138E07-C7CE-46CF-A988-10106BCD43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523513" y="3690340"/>
                <a:ext cx="0" cy="539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2" name="Line 69">
                <a:extLst>
                  <a:ext uri="{FF2B5EF4-FFF2-40B4-BE49-F238E27FC236}">
                    <a16:creationId xmlns="" xmlns:a16="http://schemas.microsoft.com/office/drawing/2014/main" id="{DBA6210B-D2B8-452B-B569-02EF9C93F9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648794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3" name="Line 70">
                <a:extLst>
                  <a:ext uri="{FF2B5EF4-FFF2-40B4-BE49-F238E27FC236}">
                    <a16:creationId xmlns="" xmlns:a16="http://schemas.microsoft.com/office/drawing/2014/main" id="{28A06DFE-1C6F-42B7-81BF-F9E54C55FE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722234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4" name="Line 71">
                <a:extLst>
                  <a:ext uri="{FF2B5EF4-FFF2-40B4-BE49-F238E27FC236}">
                    <a16:creationId xmlns="" xmlns:a16="http://schemas.microsoft.com/office/drawing/2014/main" id="{C31048DC-9FF5-4F34-BFA8-B2AFAFDA59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77263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5" name="Line 72">
                <a:extLst>
                  <a:ext uri="{FF2B5EF4-FFF2-40B4-BE49-F238E27FC236}">
                    <a16:creationId xmlns="" xmlns:a16="http://schemas.microsoft.com/office/drawing/2014/main" id="{4A2A88A5-73E4-4696-A512-64E16B4631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81295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6" name="Line 73">
                <a:extLst>
                  <a:ext uri="{FF2B5EF4-FFF2-40B4-BE49-F238E27FC236}">
                    <a16:creationId xmlns="" xmlns:a16="http://schemas.microsoft.com/office/drawing/2014/main" id="{77BC1455-989B-4205-B200-B98258402C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84607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7" name="Line 74">
                <a:extLst>
                  <a:ext uri="{FF2B5EF4-FFF2-40B4-BE49-F238E27FC236}">
                    <a16:creationId xmlns="" xmlns:a16="http://schemas.microsoft.com/office/drawing/2014/main" id="{B7C35400-A117-4AE2-B4BA-600C24994C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873436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8" name="Line 75">
                <a:extLst>
                  <a:ext uri="{FF2B5EF4-FFF2-40B4-BE49-F238E27FC236}">
                    <a16:creationId xmlns="" xmlns:a16="http://schemas.microsoft.com/office/drawing/2014/main" id="{50FDF5DE-0EDF-425F-9164-7D3A4C4504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897915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19" name="Line 76">
                <a:extLst>
                  <a:ext uri="{FF2B5EF4-FFF2-40B4-BE49-F238E27FC236}">
                    <a16:creationId xmlns="" xmlns:a16="http://schemas.microsoft.com/office/drawing/2014/main" id="{00C5EAF9-068C-4B21-8DF5-C288A6D5C5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19516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20" name="Line 77">
                <a:extLst>
                  <a:ext uri="{FF2B5EF4-FFF2-40B4-BE49-F238E27FC236}">
                    <a16:creationId xmlns="" xmlns:a16="http://schemas.microsoft.com/office/drawing/2014/main" id="{B375A869-4558-46AF-BEF0-7F0D154346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38236" y="3690340"/>
                <a:ext cx="0" cy="539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21" name="Line 78">
                <a:extLst>
                  <a:ext uri="{FF2B5EF4-FFF2-40B4-BE49-F238E27FC236}">
                    <a16:creationId xmlns="" xmlns:a16="http://schemas.microsoft.com/office/drawing/2014/main" id="{3EAE8DC4-276C-4DB9-9269-65DFA7132F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063517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22" name="Line 79">
                <a:extLst>
                  <a:ext uri="{FF2B5EF4-FFF2-40B4-BE49-F238E27FC236}">
                    <a16:creationId xmlns="" xmlns:a16="http://schemas.microsoft.com/office/drawing/2014/main" id="{2DA955E5-AC0E-47DB-9E98-BD49475273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135518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23" name="Line 80">
                <a:extLst>
                  <a:ext uri="{FF2B5EF4-FFF2-40B4-BE49-F238E27FC236}">
                    <a16:creationId xmlns="" xmlns:a16="http://schemas.microsoft.com/office/drawing/2014/main" id="{36D007ED-8668-45DA-987B-C46D7E224B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188798" y="3690340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0" name="Line 87">
                <a:extLst>
                  <a:ext uri="{FF2B5EF4-FFF2-40B4-BE49-F238E27FC236}">
                    <a16:creationId xmlns="" xmlns:a16="http://schemas.microsoft.com/office/drawing/2014/main" id="{EA1EB9D3-43AF-4244-B451-8EC682D6AD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89901" y="3690340"/>
                <a:ext cx="219600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1" name="Line 88">
                <a:extLst>
                  <a:ext uri="{FF2B5EF4-FFF2-40B4-BE49-F238E27FC236}">
                    <a16:creationId xmlns="" xmlns:a16="http://schemas.microsoft.com/office/drawing/2014/main" id="{3A886981-0FC0-4BC9-814A-758B7C20CC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3690340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2" name="Line 89">
                <a:extLst>
                  <a:ext uri="{FF2B5EF4-FFF2-40B4-BE49-F238E27FC236}">
                    <a16:creationId xmlns="" xmlns:a16="http://schemas.microsoft.com/office/drawing/2014/main" id="{393647CC-8316-47D4-9F6F-83DA6DEC7F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5341" y="3464915"/>
                <a:ext cx="3456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3" name="Line 90">
                <a:extLst>
                  <a:ext uri="{FF2B5EF4-FFF2-40B4-BE49-F238E27FC236}">
                    <a16:creationId xmlns="" xmlns:a16="http://schemas.microsoft.com/office/drawing/2014/main" id="{7F944FDB-1E93-413B-A6F5-B25969BF91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3237903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4" name="Line 91">
                <a:extLst>
                  <a:ext uri="{FF2B5EF4-FFF2-40B4-BE49-F238E27FC236}">
                    <a16:creationId xmlns="" xmlns:a16="http://schemas.microsoft.com/office/drawing/2014/main" id="{A056BB31-0A4D-4240-BC4C-7CB53ABBD5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5341" y="3010890"/>
                <a:ext cx="3456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5" name="Line 92">
                <a:extLst>
                  <a:ext uri="{FF2B5EF4-FFF2-40B4-BE49-F238E27FC236}">
                    <a16:creationId xmlns="" xmlns:a16="http://schemas.microsoft.com/office/drawing/2014/main" id="{2CF422D5-FB9F-4683-B7A8-644F404291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2785465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6" name="Line 93">
                <a:extLst>
                  <a:ext uri="{FF2B5EF4-FFF2-40B4-BE49-F238E27FC236}">
                    <a16:creationId xmlns="" xmlns:a16="http://schemas.microsoft.com/office/drawing/2014/main" id="{BBC5A561-5DDE-4E9F-B5F5-F7C207DE6E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5341" y="2558453"/>
                <a:ext cx="3456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7" name="Line 94">
                <a:extLst>
                  <a:ext uri="{FF2B5EF4-FFF2-40B4-BE49-F238E27FC236}">
                    <a16:creationId xmlns="" xmlns:a16="http://schemas.microsoft.com/office/drawing/2014/main" id="{3B390763-39AF-42C3-AA6D-296DA69BFE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2331440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8" name="Line 95">
                <a:extLst>
                  <a:ext uri="{FF2B5EF4-FFF2-40B4-BE49-F238E27FC236}">
                    <a16:creationId xmlns="" xmlns:a16="http://schemas.microsoft.com/office/drawing/2014/main" id="{2222553C-9451-4F4E-A322-029EF1FE98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5341" y="2104428"/>
                <a:ext cx="3456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39" name="Line 96">
                <a:extLst>
                  <a:ext uri="{FF2B5EF4-FFF2-40B4-BE49-F238E27FC236}">
                    <a16:creationId xmlns="" xmlns:a16="http://schemas.microsoft.com/office/drawing/2014/main" id="{BF8E9F40-0280-419F-B46E-F84AC50D72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1877415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0" name="Line 97">
                <a:extLst>
                  <a:ext uri="{FF2B5EF4-FFF2-40B4-BE49-F238E27FC236}">
                    <a16:creationId xmlns="" xmlns:a16="http://schemas.microsoft.com/office/drawing/2014/main" id="{575E3CDD-7807-4E7F-8177-EFB68DA877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5341" y="1650403"/>
                <a:ext cx="3456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1" name="Line 98">
                <a:extLst>
                  <a:ext uri="{FF2B5EF4-FFF2-40B4-BE49-F238E27FC236}">
                    <a16:creationId xmlns="" xmlns:a16="http://schemas.microsoft.com/office/drawing/2014/main" id="{7DCA703D-1D35-44AB-A9B9-C1D6EB761F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1423390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2" name="Line 99">
                <a:extLst>
                  <a:ext uri="{FF2B5EF4-FFF2-40B4-BE49-F238E27FC236}">
                    <a16:creationId xmlns="" xmlns:a16="http://schemas.microsoft.com/office/drawing/2014/main" id="{EBF23396-7B62-45E7-A30D-C03748545E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55341" y="1197965"/>
                <a:ext cx="3456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3" name="Line 100">
                <a:extLst>
                  <a:ext uri="{FF2B5EF4-FFF2-40B4-BE49-F238E27FC236}">
                    <a16:creationId xmlns="" xmlns:a16="http://schemas.microsoft.com/office/drawing/2014/main" id="{C7ED2844-2D07-4D7B-9977-2FB920C2E7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2621" y="970953"/>
                <a:ext cx="1728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4" name="Line 101">
                <a:extLst>
                  <a:ext uri="{FF2B5EF4-FFF2-40B4-BE49-F238E27FC236}">
                    <a16:creationId xmlns="" xmlns:a16="http://schemas.microsoft.com/office/drawing/2014/main" id="{1F25AC30-7882-466D-9D65-7543B37A38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89901" y="970953"/>
                <a:ext cx="0" cy="271938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5" name="Freeform 102">
                <a:extLst>
                  <a:ext uri="{FF2B5EF4-FFF2-40B4-BE49-F238E27FC236}">
                    <a16:creationId xmlns="" xmlns:a16="http://schemas.microsoft.com/office/drawing/2014/main" id="{FFD79F4F-F6B2-45E2-BECC-B2F98B6EE9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40301" y="1161453"/>
                <a:ext cx="44641" cy="71438"/>
              </a:xfrm>
              <a:custGeom>
                <a:avLst/>
                <a:gdLst>
                  <a:gd name="T0" fmla="*/ 0 w 31"/>
                  <a:gd name="T1" fmla="*/ 23 h 45"/>
                  <a:gd name="T2" fmla="*/ 16 w 31"/>
                  <a:gd name="T3" fmla="*/ 0 h 45"/>
                  <a:gd name="T4" fmla="*/ 31 w 31"/>
                  <a:gd name="T5" fmla="*/ 23 h 45"/>
                  <a:gd name="T6" fmla="*/ 16 w 31"/>
                  <a:gd name="T7" fmla="*/ 45 h 45"/>
                  <a:gd name="T8" fmla="*/ 0 w 31"/>
                  <a:gd name="T9" fmla="*/ 23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3"/>
                    </a:moveTo>
                    <a:lnTo>
                      <a:pt x="16" y="0"/>
                    </a:lnTo>
                    <a:lnTo>
                      <a:pt x="31" y="23"/>
                    </a:lnTo>
                    <a:lnTo>
                      <a:pt x="16" y="45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6" name="Freeform 103">
                <a:extLst>
                  <a:ext uri="{FF2B5EF4-FFF2-40B4-BE49-F238E27FC236}">
                    <a16:creationId xmlns="" xmlns:a16="http://schemas.microsoft.com/office/drawing/2014/main" id="{F52F338A-47E3-4A04-9AD5-5FBECB7A8DF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55024" y="1196378"/>
                <a:ext cx="44641" cy="69850"/>
              </a:xfrm>
              <a:custGeom>
                <a:avLst/>
                <a:gdLst>
                  <a:gd name="T0" fmla="*/ 0 w 31"/>
                  <a:gd name="T1" fmla="*/ 22 h 44"/>
                  <a:gd name="T2" fmla="*/ 15 w 31"/>
                  <a:gd name="T3" fmla="*/ 0 h 44"/>
                  <a:gd name="T4" fmla="*/ 31 w 31"/>
                  <a:gd name="T5" fmla="*/ 22 h 44"/>
                  <a:gd name="T6" fmla="*/ 15 w 31"/>
                  <a:gd name="T7" fmla="*/ 44 h 44"/>
                  <a:gd name="T8" fmla="*/ 0 w 31"/>
                  <a:gd name="T9" fmla="*/ 22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4">
                    <a:moveTo>
                      <a:pt x="0" y="22"/>
                    </a:moveTo>
                    <a:lnTo>
                      <a:pt x="15" y="0"/>
                    </a:lnTo>
                    <a:lnTo>
                      <a:pt x="31" y="22"/>
                    </a:lnTo>
                    <a:lnTo>
                      <a:pt x="15" y="44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7" name="Freeform 104">
                <a:extLst>
                  <a:ext uri="{FF2B5EF4-FFF2-40B4-BE49-F238E27FC236}">
                    <a16:creationId xmlns="" xmlns:a16="http://schemas.microsoft.com/office/drawing/2014/main" id="{8A624F59-5DB2-4BBF-BD21-398452E628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69748" y="1507528"/>
                <a:ext cx="44641" cy="71438"/>
              </a:xfrm>
              <a:custGeom>
                <a:avLst/>
                <a:gdLst>
                  <a:gd name="T0" fmla="*/ 0 w 31"/>
                  <a:gd name="T1" fmla="*/ 22 h 45"/>
                  <a:gd name="T2" fmla="*/ 16 w 31"/>
                  <a:gd name="T3" fmla="*/ 0 h 45"/>
                  <a:gd name="T4" fmla="*/ 31 w 31"/>
                  <a:gd name="T5" fmla="*/ 22 h 45"/>
                  <a:gd name="T6" fmla="*/ 16 w 31"/>
                  <a:gd name="T7" fmla="*/ 45 h 45"/>
                  <a:gd name="T8" fmla="*/ 0 w 31"/>
                  <a:gd name="T9" fmla="*/ 22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2"/>
                    </a:moveTo>
                    <a:lnTo>
                      <a:pt x="16" y="0"/>
                    </a:lnTo>
                    <a:lnTo>
                      <a:pt x="31" y="22"/>
                    </a:lnTo>
                    <a:lnTo>
                      <a:pt x="16" y="45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8" name="Freeform 105">
                <a:extLst>
                  <a:ext uri="{FF2B5EF4-FFF2-40B4-BE49-F238E27FC236}">
                    <a16:creationId xmlns="" xmlns:a16="http://schemas.microsoft.com/office/drawing/2014/main" id="{92B5D981-3394-47DE-B26F-070B514016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84471" y="2952153"/>
                <a:ext cx="44641" cy="71438"/>
              </a:xfrm>
              <a:custGeom>
                <a:avLst/>
                <a:gdLst>
                  <a:gd name="T0" fmla="*/ 0 w 31"/>
                  <a:gd name="T1" fmla="*/ 22 h 45"/>
                  <a:gd name="T2" fmla="*/ 15 w 31"/>
                  <a:gd name="T3" fmla="*/ 0 h 45"/>
                  <a:gd name="T4" fmla="*/ 31 w 31"/>
                  <a:gd name="T5" fmla="*/ 22 h 45"/>
                  <a:gd name="T6" fmla="*/ 15 w 31"/>
                  <a:gd name="T7" fmla="*/ 45 h 45"/>
                  <a:gd name="T8" fmla="*/ 0 w 31"/>
                  <a:gd name="T9" fmla="*/ 22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2"/>
                    </a:moveTo>
                    <a:lnTo>
                      <a:pt x="15" y="0"/>
                    </a:lnTo>
                    <a:lnTo>
                      <a:pt x="31" y="22"/>
                    </a:lnTo>
                    <a:lnTo>
                      <a:pt x="15" y="45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49" name="Freeform 106">
                <a:extLst>
                  <a:ext uri="{FF2B5EF4-FFF2-40B4-BE49-F238E27FC236}">
                    <a16:creationId xmlns="" xmlns:a16="http://schemas.microsoft.com/office/drawing/2014/main" id="{BDE578CF-01B9-4F7C-B596-871521EBCA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99194" y="3299815"/>
                <a:ext cx="44641" cy="69850"/>
              </a:xfrm>
              <a:custGeom>
                <a:avLst/>
                <a:gdLst>
                  <a:gd name="T0" fmla="*/ 0 w 31"/>
                  <a:gd name="T1" fmla="*/ 22 h 44"/>
                  <a:gd name="T2" fmla="*/ 16 w 31"/>
                  <a:gd name="T3" fmla="*/ 0 h 44"/>
                  <a:gd name="T4" fmla="*/ 31 w 31"/>
                  <a:gd name="T5" fmla="*/ 22 h 44"/>
                  <a:gd name="T6" fmla="*/ 16 w 31"/>
                  <a:gd name="T7" fmla="*/ 44 h 44"/>
                  <a:gd name="T8" fmla="*/ 0 w 31"/>
                  <a:gd name="T9" fmla="*/ 22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4">
                    <a:moveTo>
                      <a:pt x="0" y="22"/>
                    </a:moveTo>
                    <a:lnTo>
                      <a:pt x="16" y="0"/>
                    </a:lnTo>
                    <a:lnTo>
                      <a:pt x="31" y="22"/>
                    </a:lnTo>
                    <a:lnTo>
                      <a:pt x="16" y="44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0" name="Freeform 107">
                <a:extLst>
                  <a:ext uri="{FF2B5EF4-FFF2-40B4-BE49-F238E27FC236}">
                    <a16:creationId xmlns="" xmlns:a16="http://schemas.microsoft.com/office/drawing/2014/main" id="{C961E7A3-ABD5-4E92-936F-65B24C0720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13917" y="3399828"/>
                <a:ext cx="44641" cy="71438"/>
              </a:xfrm>
              <a:custGeom>
                <a:avLst/>
                <a:gdLst>
                  <a:gd name="T0" fmla="*/ 0 w 31"/>
                  <a:gd name="T1" fmla="*/ 23 h 45"/>
                  <a:gd name="T2" fmla="*/ 15 w 31"/>
                  <a:gd name="T3" fmla="*/ 0 h 45"/>
                  <a:gd name="T4" fmla="*/ 31 w 31"/>
                  <a:gd name="T5" fmla="*/ 23 h 45"/>
                  <a:gd name="T6" fmla="*/ 15 w 31"/>
                  <a:gd name="T7" fmla="*/ 45 h 45"/>
                  <a:gd name="T8" fmla="*/ 0 w 31"/>
                  <a:gd name="T9" fmla="*/ 23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3"/>
                    </a:moveTo>
                    <a:lnTo>
                      <a:pt x="15" y="0"/>
                    </a:lnTo>
                    <a:lnTo>
                      <a:pt x="31" y="23"/>
                    </a:lnTo>
                    <a:lnTo>
                      <a:pt x="15" y="45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1" name="Freeform 108">
                <a:extLst>
                  <a:ext uri="{FF2B5EF4-FFF2-40B4-BE49-F238E27FC236}">
                    <a16:creationId xmlns="" xmlns:a16="http://schemas.microsoft.com/office/drawing/2014/main" id="{F287D5E0-86A8-47E2-8A1A-D59D6DAD4C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40301" y="1161453"/>
                <a:ext cx="44641" cy="71438"/>
              </a:xfrm>
              <a:custGeom>
                <a:avLst/>
                <a:gdLst>
                  <a:gd name="T0" fmla="*/ 0 w 31"/>
                  <a:gd name="T1" fmla="*/ 23 h 45"/>
                  <a:gd name="T2" fmla="*/ 16 w 31"/>
                  <a:gd name="T3" fmla="*/ 0 h 45"/>
                  <a:gd name="T4" fmla="*/ 31 w 31"/>
                  <a:gd name="T5" fmla="*/ 23 h 45"/>
                  <a:gd name="T6" fmla="*/ 16 w 31"/>
                  <a:gd name="T7" fmla="*/ 45 h 45"/>
                  <a:gd name="T8" fmla="*/ 0 w 31"/>
                  <a:gd name="T9" fmla="*/ 23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3"/>
                    </a:moveTo>
                    <a:lnTo>
                      <a:pt x="16" y="0"/>
                    </a:lnTo>
                    <a:lnTo>
                      <a:pt x="31" y="23"/>
                    </a:lnTo>
                    <a:lnTo>
                      <a:pt x="16" y="45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2" name="Freeform 109">
                <a:extLst>
                  <a:ext uri="{FF2B5EF4-FFF2-40B4-BE49-F238E27FC236}">
                    <a16:creationId xmlns="" xmlns:a16="http://schemas.microsoft.com/office/drawing/2014/main" id="{2C12689C-E654-4201-A390-E16C62C68B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55024" y="1213840"/>
                <a:ext cx="44641" cy="71438"/>
              </a:xfrm>
              <a:custGeom>
                <a:avLst/>
                <a:gdLst>
                  <a:gd name="T0" fmla="*/ 0 w 31"/>
                  <a:gd name="T1" fmla="*/ 23 h 45"/>
                  <a:gd name="T2" fmla="*/ 15 w 31"/>
                  <a:gd name="T3" fmla="*/ 0 h 45"/>
                  <a:gd name="T4" fmla="*/ 31 w 31"/>
                  <a:gd name="T5" fmla="*/ 23 h 45"/>
                  <a:gd name="T6" fmla="*/ 15 w 31"/>
                  <a:gd name="T7" fmla="*/ 45 h 45"/>
                  <a:gd name="T8" fmla="*/ 0 w 31"/>
                  <a:gd name="T9" fmla="*/ 23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3"/>
                    </a:moveTo>
                    <a:lnTo>
                      <a:pt x="15" y="0"/>
                    </a:lnTo>
                    <a:lnTo>
                      <a:pt x="31" y="23"/>
                    </a:lnTo>
                    <a:lnTo>
                      <a:pt x="15" y="45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3" name="Freeform 110">
                <a:extLst>
                  <a:ext uri="{FF2B5EF4-FFF2-40B4-BE49-F238E27FC236}">
                    <a16:creationId xmlns="" xmlns:a16="http://schemas.microsoft.com/office/drawing/2014/main" id="{34FD7C72-0992-44F6-BBAB-2C1A786A3E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69748" y="1375765"/>
                <a:ext cx="44641" cy="69850"/>
              </a:xfrm>
              <a:custGeom>
                <a:avLst/>
                <a:gdLst>
                  <a:gd name="T0" fmla="*/ 0 w 31"/>
                  <a:gd name="T1" fmla="*/ 22 h 44"/>
                  <a:gd name="T2" fmla="*/ 16 w 31"/>
                  <a:gd name="T3" fmla="*/ 0 h 44"/>
                  <a:gd name="T4" fmla="*/ 31 w 31"/>
                  <a:gd name="T5" fmla="*/ 22 h 44"/>
                  <a:gd name="T6" fmla="*/ 16 w 31"/>
                  <a:gd name="T7" fmla="*/ 44 h 44"/>
                  <a:gd name="T8" fmla="*/ 0 w 31"/>
                  <a:gd name="T9" fmla="*/ 22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4">
                    <a:moveTo>
                      <a:pt x="0" y="22"/>
                    </a:moveTo>
                    <a:lnTo>
                      <a:pt x="16" y="0"/>
                    </a:lnTo>
                    <a:lnTo>
                      <a:pt x="31" y="22"/>
                    </a:lnTo>
                    <a:lnTo>
                      <a:pt x="16" y="44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4" name="Freeform 111">
                <a:extLst>
                  <a:ext uri="{FF2B5EF4-FFF2-40B4-BE49-F238E27FC236}">
                    <a16:creationId xmlns="" xmlns:a16="http://schemas.microsoft.com/office/drawing/2014/main" id="{1500C546-F05E-4DAF-A209-6D32924619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84471" y="2702915"/>
                <a:ext cx="44641" cy="71438"/>
              </a:xfrm>
              <a:custGeom>
                <a:avLst/>
                <a:gdLst>
                  <a:gd name="T0" fmla="*/ 0 w 31"/>
                  <a:gd name="T1" fmla="*/ 23 h 45"/>
                  <a:gd name="T2" fmla="*/ 15 w 31"/>
                  <a:gd name="T3" fmla="*/ 0 h 45"/>
                  <a:gd name="T4" fmla="*/ 31 w 31"/>
                  <a:gd name="T5" fmla="*/ 23 h 45"/>
                  <a:gd name="T6" fmla="*/ 15 w 31"/>
                  <a:gd name="T7" fmla="*/ 45 h 45"/>
                  <a:gd name="T8" fmla="*/ 0 w 31"/>
                  <a:gd name="T9" fmla="*/ 23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5">
                    <a:moveTo>
                      <a:pt x="0" y="23"/>
                    </a:moveTo>
                    <a:lnTo>
                      <a:pt x="15" y="0"/>
                    </a:lnTo>
                    <a:lnTo>
                      <a:pt x="31" y="23"/>
                    </a:lnTo>
                    <a:lnTo>
                      <a:pt x="15" y="45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5" name="Freeform 112">
                <a:extLst>
                  <a:ext uri="{FF2B5EF4-FFF2-40B4-BE49-F238E27FC236}">
                    <a16:creationId xmlns="" xmlns:a16="http://schemas.microsoft.com/office/drawing/2014/main" id="{E4148B23-5145-4518-B50A-CAAF240A88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99194" y="3353790"/>
                <a:ext cx="44641" cy="69850"/>
              </a:xfrm>
              <a:custGeom>
                <a:avLst/>
                <a:gdLst>
                  <a:gd name="T0" fmla="*/ 0 w 31"/>
                  <a:gd name="T1" fmla="*/ 22 h 44"/>
                  <a:gd name="T2" fmla="*/ 16 w 31"/>
                  <a:gd name="T3" fmla="*/ 0 h 44"/>
                  <a:gd name="T4" fmla="*/ 31 w 31"/>
                  <a:gd name="T5" fmla="*/ 22 h 44"/>
                  <a:gd name="T6" fmla="*/ 16 w 31"/>
                  <a:gd name="T7" fmla="*/ 44 h 44"/>
                  <a:gd name="T8" fmla="*/ 0 w 31"/>
                  <a:gd name="T9" fmla="*/ 22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4">
                    <a:moveTo>
                      <a:pt x="0" y="22"/>
                    </a:moveTo>
                    <a:lnTo>
                      <a:pt x="16" y="0"/>
                    </a:lnTo>
                    <a:lnTo>
                      <a:pt x="31" y="22"/>
                    </a:lnTo>
                    <a:lnTo>
                      <a:pt x="16" y="44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6" name="Freeform 113">
                <a:extLst>
                  <a:ext uri="{FF2B5EF4-FFF2-40B4-BE49-F238E27FC236}">
                    <a16:creationId xmlns="" xmlns:a16="http://schemas.microsoft.com/office/drawing/2014/main" id="{95E094B6-05FF-4A44-8DF2-65DE1C3E3F0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13917" y="3396653"/>
                <a:ext cx="44641" cy="69850"/>
              </a:xfrm>
              <a:custGeom>
                <a:avLst/>
                <a:gdLst>
                  <a:gd name="T0" fmla="*/ 0 w 31"/>
                  <a:gd name="T1" fmla="*/ 22 h 44"/>
                  <a:gd name="T2" fmla="*/ 15 w 31"/>
                  <a:gd name="T3" fmla="*/ 0 h 44"/>
                  <a:gd name="T4" fmla="*/ 31 w 31"/>
                  <a:gd name="T5" fmla="*/ 22 h 44"/>
                  <a:gd name="T6" fmla="*/ 15 w 31"/>
                  <a:gd name="T7" fmla="*/ 44 h 44"/>
                  <a:gd name="T8" fmla="*/ 0 w 31"/>
                  <a:gd name="T9" fmla="*/ 22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1" h="44">
                    <a:moveTo>
                      <a:pt x="0" y="22"/>
                    </a:moveTo>
                    <a:lnTo>
                      <a:pt x="15" y="0"/>
                    </a:lnTo>
                    <a:lnTo>
                      <a:pt x="31" y="22"/>
                    </a:lnTo>
                    <a:lnTo>
                      <a:pt x="15" y="44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7" name="Freeform 114">
                <a:extLst>
                  <a:ext uri="{FF2B5EF4-FFF2-40B4-BE49-F238E27FC236}">
                    <a16:creationId xmlns="" xmlns:a16="http://schemas.microsoft.com/office/drawing/2014/main" id="{338573CF-DCF9-4E39-AB0D-F029E3F912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40301" y="1161453"/>
                <a:ext cx="44641" cy="36513"/>
              </a:xfrm>
              <a:custGeom>
                <a:avLst/>
                <a:gdLst>
                  <a:gd name="T0" fmla="*/ 0 w 31"/>
                  <a:gd name="T1" fmla="*/ 23 h 23"/>
                  <a:gd name="T2" fmla="*/ 31 w 31"/>
                  <a:gd name="T3" fmla="*/ 23 h 23"/>
                  <a:gd name="T4" fmla="*/ 16 w 31"/>
                  <a:gd name="T5" fmla="*/ 0 h 23"/>
                  <a:gd name="T6" fmla="*/ 0 w 31"/>
                  <a:gd name="T7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3">
                    <a:moveTo>
                      <a:pt x="0" y="23"/>
                    </a:moveTo>
                    <a:lnTo>
                      <a:pt x="31" y="23"/>
                    </a:lnTo>
                    <a:lnTo>
                      <a:pt x="16" y="0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8" name="Freeform 115">
                <a:extLst>
                  <a:ext uri="{FF2B5EF4-FFF2-40B4-BE49-F238E27FC236}">
                    <a16:creationId xmlns="" xmlns:a16="http://schemas.microsoft.com/office/drawing/2014/main" id="{91ABCEFE-9AEB-4F99-9653-A03C9C8B24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40301" y="1197965"/>
                <a:ext cx="44641" cy="34925"/>
              </a:xfrm>
              <a:custGeom>
                <a:avLst/>
                <a:gdLst>
                  <a:gd name="T0" fmla="*/ 0 w 31"/>
                  <a:gd name="T1" fmla="*/ 0 h 22"/>
                  <a:gd name="T2" fmla="*/ 31 w 31"/>
                  <a:gd name="T3" fmla="*/ 0 h 22"/>
                  <a:gd name="T4" fmla="*/ 16 w 31"/>
                  <a:gd name="T5" fmla="*/ 22 h 22"/>
                  <a:gd name="T6" fmla="*/ 0 w 31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0"/>
                    </a:moveTo>
                    <a:lnTo>
                      <a:pt x="31" y="0"/>
                    </a:lnTo>
                    <a:lnTo>
                      <a:pt x="16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59" name="Freeform 116">
                <a:extLst>
                  <a:ext uri="{FF2B5EF4-FFF2-40B4-BE49-F238E27FC236}">
                    <a16:creationId xmlns="" xmlns:a16="http://schemas.microsoft.com/office/drawing/2014/main" id="{C28E69A2-E6CB-46D1-8CA4-A59B8A4A3B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55024" y="1178915"/>
                <a:ext cx="44641" cy="34925"/>
              </a:xfrm>
              <a:custGeom>
                <a:avLst/>
                <a:gdLst>
                  <a:gd name="T0" fmla="*/ 0 w 31"/>
                  <a:gd name="T1" fmla="*/ 22 h 22"/>
                  <a:gd name="T2" fmla="*/ 31 w 31"/>
                  <a:gd name="T3" fmla="*/ 22 h 22"/>
                  <a:gd name="T4" fmla="*/ 15 w 31"/>
                  <a:gd name="T5" fmla="*/ 0 h 22"/>
                  <a:gd name="T6" fmla="*/ 0 w 31"/>
                  <a:gd name="T7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22"/>
                    </a:moveTo>
                    <a:lnTo>
                      <a:pt x="31" y="22"/>
                    </a:lnTo>
                    <a:lnTo>
                      <a:pt x="15" y="0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0" name="Freeform 117">
                <a:extLst>
                  <a:ext uri="{FF2B5EF4-FFF2-40B4-BE49-F238E27FC236}">
                    <a16:creationId xmlns="" xmlns:a16="http://schemas.microsoft.com/office/drawing/2014/main" id="{22DE2DF0-01AA-4FF6-84CF-F2FE38F1E6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55024" y="1213840"/>
                <a:ext cx="44641" cy="36513"/>
              </a:xfrm>
              <a:custGeom>
                <a:avLst/>
                <a:gdLst>
                  <a:gd name="T0" fmla="*/ 0 w 31"/>
                  <a:gd name="T1" fmla="*/ 0 h 23"/>
                  <a:gd name="T2" fmla="*/ 31 w 31"/>
                  <a:gd name="T3" fmla="*/ 0 h 23"/>
                  <a:gd name="T4" fmla="*/ 15 w 31"/>
                  <a:gd name="T5" fmla="*/ 23 h 23"/>
                  <a:gd name="T6" fmla="*/ 0 w 31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3">
                    <a:moveTo>
                      <a:pt x="0" y="0"/>
                    </a:moveTo>
                    <a:lnTo>
                      <a:pt x="31" y="0"/>
                    </a:lnTo>
                    <a:lnTo>
                      <a:pt x="15" y="2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1" name="Freeform 118">
                <a:extLst>
                  <a:ext uri="{FF2B5EF4-FFF2-40B4-BE49-F238E27FC236}">
                    <a16:creationId xmlns="" xmlns:a16="http://schemas.microsoft.com/office/drawing/2014/main" id="{CF33A13B-993C-4721-B131-418A0F8A6C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69748" y="1382115"/>
                <a:ext cx="44641" cy="34925"/>
              </a:xfrm>
              <a:custGeom>
                <a:avLst/>
                <a:gdLst>
                  <a:gd name="T0" fmla="*/ 0 w 31"/>
                  <a:gd name="T1" fmla="*/ 22 h 22"/>
                  <a:gd name="T2" fmla="*/ 31 w 31"/>
                  <a:gd name="T3" fmla="*/ 22 h 22"/>
                  <a:gd name="T4" fmla="*/ 16 w 31"/>
                  <a:gd name="T5" fmla="*/ 0 h 22"/>
                  <a:gd name="T6" fmla="*/ 0 w 31"/>
                  <a:gd name="T7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22"/>
                    </a:moveTo>
                    <a:lnTo>
                      <a:pt x="31" y="22"/>
                    </a:lnTo>
                    <a:lnTo>
                      <a:pt x="16" y="0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2" name="Freeform 119">
                <a:extLst>
                  <a:ext uri="{FF2B5EF4-FFF2-40B4-BE49-F238E27FC236}">
                    <a16:creationId xmlns="" xmlns:a16="http://schemas.microsoft.com/office/drawing/2014/main" id="{AC429A70-6E66-4386-81A9-880C9C2C05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69748" y="1417040"/>
                <a:ext cx="44641" cy="34925"/>
              </a:xfrm>
              <a:custGeom>
                <a:avLst/>
                <a:gdLst>
                  <a:gd name="T0" fmla="*/ 0 w 31"/>
                  <a:gd name="T1" fmla="*/ 0 h 22"/>
                  <a:gd name="T2" fmla="*/ 31 w 31"/>
                  <a:gd name="T3" fmla="*/ 0 h 22"/>
                  <a:gd name="T4" fmla="*/ 16 w 31"/>
                  <a:gd name="T5" fmla="*/ 22 h 22"/>
                  <a:gd name="T6" fmla="*/ 0 w 31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0"/>
                    </a:moveTo>
                    <a:lnTo>
                      <a:pt x="31" y="0"/>
                    </a:lnTo>
                    <a:lnTo>
                      <a:pt x="16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3" name="Freeform 120">
                <a:extLst>
                  <a:ext uri="{FF2B5EF4-FFF2-40B4-BE49-F238E27FC236}">
                    <a16:creationId xmlns="" xmlns:a16="http://schemas.microsoft.com/office/drawing/2014/main" id="{02B4D412-2ABA-49C6-8722-DB1DF3585C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84471" y="2433040"/>
                <a:ext cx="44641" cy="36513"/>
              </a:xfrm>
              <a:custGeom>
                <a:avLst/>
                <a:gdLst>
                  <a:gd name="T0" fmla="*/ 0 w 31"/>
                  <a:gd name="T1" fmla="*/ 23 h 23"/>
                  <a:gd name="T2" fmla="*/ 31 w 31"/>
                  <a:gd name="T3" fmla="*/ 23 h 23"/>
                  <a:gd name="T4" fmla="*/ 15 w 31"/>
                  <a:gd name="T5" fmla="*/ 0 h 23"/>
                  <a:gd name="T6" fmla="*/ 0 w 31"/>
                  <a:gd name="T7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3">
                    <a:moveTo>
                      <a:pt x="0" y="23"/>
                    </a:moveTo>
                    <a:lnTo>
                      <a:pt x="31" y="23"/>
                    </a:lnTo>
                    <a:lnTo>
                      <a:pt x="15" y="0"/>
                    </a:lnTo>
                    <a:lnTo>
                      <a:pt x="0" y="23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4" name="Freeform 121">
                <a:extLst>
                  <a:ext uri="{FF2B5EF4-FFF2-40B4-BE49-F238E27FC236}">
                    <a16:creationId xmlns="" xmlns:a16="http://schemas.microsoft.com/office/drawing/2014/main" id="{7241ACFA-B2DE-4B91-A096-18154738EA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84471" y="2469553"/>
                <a:ext cx="44641" cy="34925"/>
              </a:xfrm>
              <a:custGeom>
                <a:avLst/>
                <a:gdLst>
                  <a:gd name="T0" fmla="*/ 0 w 31"/>
                  <a:gd name="T1" fmla="*/ 0 h 22"/>
                  <a:gd name="T2" fmla="*/ 31 w 31"/>
                  <a:gd name="T3" fmla="*/ 0 h 22"/>
                  <a:gd name="T4" fmla="*/ 15 w 31"/>
                  <a:gd name="T5" fmla="*/ 22 h 22"/>
                  <a:gd name="T6" fmla="*/ 0 w 31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0"/>
                    </a:moveTo>
                    <a:lnTo>
                      <a:pt x="31" y="0"/>
                    </a:lnTo>
                    <a:lnTo>
                      <a:pt x="15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5" name="Freeform 122">
                <a:extLst>
                  <a:ext uri="{FF2B5EF4-FFF2-40B4-BE49-F238E27FC236}">
                    <a16:creationId xmlns="" xmlns:a16="http://schemas.microsoft.com/office/drawing/2014/main" id="{69C821E5-EBC2-4176-9944-364F43CA838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99194" y="3334740"/>
                <a:ext cx="44641" cy="34925"/>
              </a:xfrm>
              <a:custGeom>
                <a:avLst/>
                <a:gdLst>
                  <a:gd name="T0" fmla="*/ 0 w 31"/>
                  <a:gd name="T1" fmla="*/ 22 h 22"/>
                  <a:gd name="T2" fmla="*/ 31 w 31"/>
                  <a:gd name="T3" fmla="*/ 22 h 22"/>
                  <a:gd name="T4" fmla="*/ 16 w 31"/>
                  <a:gd name="T5" fmla="*/ 0 h 22"/>
                  <a:gd name="T6" fmla="*/ 0 w 31"/>
                  <a:gd name="T7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22"/>
                    </a:moveTo>
                    <a:lnTo>
                      <a:pt x="31" y="22"/>
                    </a:lnTo>
                    <a:lnTo>
                      <a:pt x="16" y="0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6" name="Freeform 123">
                <a:extLst>
                  <a:ext uri="{FF2B5EF4-FFF2-40B4-BE49-F238E27FC236}">
                    <a16:creationId xmlns="" xmlns:a16="http://schemas.microsoft.com/office/drawing/2014/main" id="{058D59DF-8D9D-4F8A-8953-ECF61E2DF6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99194" y="3369665"/>
                <a:ext cx="44641" cy="36513"/>
              </a:xfrm>
              <a:custGeom>
                <a:avLst/>
                <a:gdLst>
                  <a:gd name="T0" fmla="*/ 0 w 31"/>
                  <a:gd name="T1" fmla="*/ 0 h 23"/>
                  <a:gd name="T2" fmla="*/ 31 w 31"/>
                  <a:gd name="T3" fmla="*/ 0 h 23"/>
                  <a:gd name="T4" fmla="*/ 16 w 31"/>
                  <a:gd name="T5" fmla="*/ 23 h 23"/>
                  <a:gd name="T6" fmla="*/ 0 w 31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3">
                    <a:moveTo>
                      <a:pt x="0" y="0"/>
                    </a:moveTo>
                    <a:lnTo>
                      <a:pt x="31" y="0"/>
                    </a:lnTo>
                    <a:lnTo>
                      <a:pt x="16" y="2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7" name="Freeform 124">
                <a:extLst>
                  <a:ext uri="{FF2B5EF4-FFF2-40B4-BE49-F238E27FC236}">
                    <a16:creationId xmlns="" xmlns:a16="http://schemas.microsoft.com/office/drawing/2014/main" id="{E8F7985C-8144-49A9-A302-7F7BB91800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13917" y="3396653"/>
                <a:ext cx="44641" cy="34925"/>
              </a:xfrm>
              <a:custGeom>
                <a:avLst/>
                <a:gdLst>
                  <a:gd name="T0" fmla="*/ 0 w 31"/>
                  <a:gd name="T1" fmla="*/ 22 h 22"/>
                  <a:gd name="T2" fmla="*/ 31 w 31"/>
                  <a:gd name="T3" fmla="*/ 22 h 22"/>
                  <a:gd name="T4" fmla="*/ 15 w 31"/>
                  <a:gd name="T5" fmla="*/ 0 h 22"/>
                  <a:gd name="T6" fmla="*/ 0 w 31"/>
                  <a:gd name="T7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22"/>
                    </a:moveTo>
                    <a:lnTo>
                      <a:pt x="31" y="22"/>
                    </a:lnTo>
                    <a:lnTo>
                      <a:pt x="15" y="0"/>
                    </a:lnTo>
                    <a:lnTo>
                      <a:pt x="0" y="22"/>
                    </a:lnTo>
                    <a:close/>
                  </a:path>
                </a:pathLst>
              </a:cu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8" name="Freeform 125">
                <a:extLst>
                  <a:ext uri="{FF2B5EF4-FFF2-40B4-BE49-F238E27FC236}">
                    <a16:creationId xmlns="" xmlns:a16="http://schemas.microsoft.com/office/drawing/2014/main" id="{5F28EE94-EE54-4E32-B9DD-83AFA38D15E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13917" y="3431578"/>
                <a:ext cx="44641" cy="34925"/>
              </a:xfrm>
              <a:custGeom>
                <a:avLst/>
                <a:gdLst>
                  <a:gd name="T0" fmla="*/ 0 w 31"/>
                  <a:gd name="T1" fmla="*/ 0 h 22"/>
                  <a:gd name="T2" fmla="*/ 31 w 31"/>
                  <a:gd name="T3" fmla="*/ 0 h 22"/>
                  <a:gd name="T4" fmla="*/ 15 w 31"/>
                  <a:gd name="T5" fmla="*/ 22 h 22"/>
                  <a:gd name="T6" fmla="*/ 0 w 31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2">
                    <a:moveTo>
                      <a:pt x="0" y="0"/>
                    </a:moveTo>
                    <a:lnTo>
                      <a:pt x="31" y="0"/>
                    </a:lnTo>
                    <a:lnTo>
                      <a:pt x="15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69" name="Line 126">
                <a:extLst>
                  <a:ext uri="{FF2B5EF4-FFF2-40B4-BE49-F238E27FC236}">
                    <a16:creationId xmlns="" xmlns:a16="http://schemas.microsoft.com/office/drawing/2014/main" id="{7778236A-4370-41D0-A930-181589AAE1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6625" y="1142403"/>
                <a:ext cx="0" cy="5397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0" name="Line 127">
                <a:extLst>
                  <a:ext uri="{FF2B5EF4-FFF2-40B4-BE49-F238E27FC236}">
                    <a16:creationId xmlns="" xmlns:a16="http://schemas.microsoft.com/office/drawing/2014/main" id="{38AC16CB-270C-4005-BF01-0B608C8501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59345" y="11424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1" name="Line 128">
                <a:extLst>
                  <a:ext uri="{FF2B5EF4-FFF2-40B4-BE49-F238E27FC236}">
                    <a16:creationId xmlns="" xmlns:a16="http://schemas.microsoft.com/office/drawing/2014/main" id="{424272F8-1F9A-4B2D-A9EF-B8786772F8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6625" y="1266228"/>
                <a:ext cx="0" cy="5397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2" name="Line 129">
                <a:extLst>
                  <a:ext uri="{FF2B5EF4-FFF2-40B4-BE49-F238E27FC236}">
                    <a16:creationId xmlns="" xmlns:a16="http://schemas.microsoft.com/office/drawing/2014/main" id="{CABFCCCF-2D21-4591-853E-800F8FF74B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59345" y="13202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3" name="Line 130">
                <a:extLst>
                  <a:ext uri="{FF2B5EF4-FFF2-40B4-BE49-F238E27FC236}">
                    <a16:creationId xmlns="" xmlns:a16="http://schemas.microsoft.com/office/drawing/2014/main" id="{09F742DB-4A6B-4BA0-B2EB-65FDF521A6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92788" y="1447203"/>
                <a:ext cx="0" cy="6032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4" name="Line 131">
                <a:extLst>
                  <a:ext uri="{FF2B5EF4-FFF2-40B4-BE49-F238E27FC236}">
                    <a16:creationId xmlns="" xmlns:a16="http://schemas.microsoft.com/office/drawing/2014/main" id="{674809A4-1903-4B9F-ADE9-B2AE52007F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68" y="14472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5" name="Line 132">
                <a:extLst>
                  <a:ext uri="{FF2B5EF4-FFF2-40B4-BE49-F238E27FC236}">
                    <a16:creationId xmlns="" xmlns:a16="http://schemas.microsoft.com/office/drawing/2014/main" id="{871905F0-1EE8-4ADB-8B5F-987DA22E83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92788" y="1578965"/>
                <a:ext cx="0" cy="587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6" name="Line 133">
                <a:extLst>
                  <a:ext uri="{FF2B5EF4-FFF2-40B4-BE49-F238E27FC236}">
                    <a16:creationId xmlns="" xmlns:a16="http://schemas.microsoft.com/office/drawing/2014/main" id="{5AA9035D-E6DC-4D4D-A2E0-D85EFF40B7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68" y="16377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7" name="Line 134">
                <a:extLst>
                  <a:ext uri="{FF2B5EF4-FFF2-40B4-BE49-F238E27FC236}">
                    <a16:creationId xmlns="" xmlns:a16="http://schemas.microsoft.com/office/drawing/2014/main" id="{412932F9-E544-4E42-AF15-F1E21456DE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06071" y="2875953"/>
                <a:ext cx="0" cy="762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8" name="Line 135">
                <a:extLst>
                  <a:ext uri="{FF2B5EF4-FFF2-40B4-BE49-F238E27FC236}">
                    <a16:creationId xmlns="" xmlns:a16="http://schemas.microsoft.com/office/drawing/2014/main" id="{B78679FF-5A30-4C00-B76B-053ACC9760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791" y="28759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79" name="Line 136">
                <a:extLst>
                  <a:ext uri="{FF2B5EF4-FFF2-40B4-BE49-F238E27FC236}">
                    <a16:creationId xmlns="" xmlns:a16="http://schemas.microsoft.com/office/drawing/2014/main" id="{98C51B9C-0B6A-4D31-B028-FA8B2B5E94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06071" y="3023590"/>
                <a:ext cx="0" cy="746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0" name="Line 137">
                <a:extLst>
                  <a:ext uri="{FF2B5EF4-FFF2-40B4-BE49-F238E27FC236}">
                    <a16:creationId xmlns="" xmlns:a16="http://schemas.microsoft.com/office/drawing/2014/main" id="{64F375F3-F53F-4BBA-837C-4392664133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791" y="30982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1" name="Line 138">
                <a:extLst>
                  <a:ext uri="{FF2B5EF4-FFF2-40B4-BE49-F238E27FC236}">
                    <a16:creationId xmlns="" xmlns:a16="http://schemas.microsoft.com/office/drawing/2014/main" id="{A6D65A1E-43F5-4DA5-B632-C0089A7496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22234" y="3234728"/>
                <a:ext cx="0" cy="650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2" name="Line 139">
                <a:extLst>
                  <a:ext uri="{FF2B5EF4-FFF2-40B4-BE49-F238E27FC236}">
                    <a16:creationId xmlns="" xmlns:a16="http://schemas.microsoft.com/office/drawing/2014/main" id="{E78998C7-F2A3-484A-975F-EFE12DE7FA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3514" y="3234728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3" name="Line 140">
                <a:extLst>
                  <a:ext uri="{FF2B5EF4-FFF2-40B4-BE49-F238E27FC236}">
                    <a16:creationId xmlns="" xmlns:a16="http://schemas.microsoft.com/office/drawing/2014/main" id="{B45D1780-F024-4863-AFC9-26C79D365E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722234" y="3369665"/>
                <a:ext cx="0" cy="635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4" name="Line 141">
                <a:extLst>
                  <a:ext uri="{FF2B5EF4-FFF2-40B4-BE49-F238E27FC236}">
                    <a16:creationId xmlns="" xmlns:a16="http://schemas.microsoft.com/office/drawing/2014/main" id="{FE79C769-BE12-4B59-A1A7-E54117127A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3514" y="3433165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5" name="Line 142">
                <a:extLst>
                  <a:ext uri="{FF2B5EF4-FFF2-40B4-BE49-F238E27FC236}">
                    <a16:creationId xmlns="" xmlns:a16="http://schemas.microsoft.com/office/drawing/2014/main" id="{E14BBB7D-01DA-402C-B0CE-AD1C148A35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35518" y="3350615"/>
                <a:ext cx="0" cy="492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6" name="Line 143">
                <a:extLst>
                  <a:ext uri="{FF2B5EF4-FFF2-40B4-BE49-F238E27FC236}">
                    <a16:creationId xmlns="" xmlns:a16="http://schemas.microsoft.com/office/drawing/2014/main" id="{E97C7EB0-76F9-4C76-A8B3-601B4FE668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8238" y="3350615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7" name="Line 144">
                <a:extLst>
                  <a:ext uri="{FF2B5EF4-FFF2-40B4-BE49-F238E27FC236}">
                    <a16:creationId xmlns="" xmlns:a16="http://schemas.microsoft.com/office/drawing/2014/main" id="{16745501-E19C-49DA-A197-EE91D3AB2A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135518" y="3471265"/>
                <a:ext cx="0" cy="508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8" name="Line 145">
                <a:extLst>
                  <a:ext uri="{FF2B5EF4-FFF2-40B4-BE49-F238E27FC236}">
                    <a16:creationId xmlns="" xmlns:a16="http://schemas.microsoft.com/office/drawing/2014/main" id="{B959F5E7-2722-481F-8932-3D8D8041C3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8238" y="3522065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89" name="Line 146">
                <a:extLst>
                  <a:ext uri="{FF2B5EF4-FFF2-40B4-BE49-F238E27FC236}">
                    <a16:creationId xmlns="" xmlns:a16="http://schemas.microsoft.com/office/drawing/2014/main" id="{96A05560-196C-4234-A1E0-24FF1CCA9E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6625" y="1161453"/>
                <a:ext cx="0" cy="523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0" name="Line 147">
                <a:extLst>
                  <a:ext uri="{FF2B5EF4-FFF2-40B4-BE49-F238E27FC236}">
                    <a16:creationId xmlns="" xmlns:a16="http://schemas.microsoft.com/office/drawing/2014/main" id="{0DFB0418-9B21-434F-9B78-2B0A92C27B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59345" y="11614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1" name="Line 148">
                <a:extLst>
                  <a:ext uri="{FF2B5EF4-FFF2-40B4-BE49-F238E27FC236}">
                    <a16:creationId xmlns="" xmlns:a16="http://schemas.microsoft.com/office/drawing/2014/main" id="{43E4B442-146F-4666-909E-AE8325B465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6625" y="1285278"/>
                <a:ext cx="0" cy="5397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2" name="Line 149">
                <a:extLst>
                  <a:ext uri="{FF2B5EF4-FFF2-40B4-BE49-F238E27FC236}">
                    <a16:creationId xmlns="" xmlns:a16="http://schemas.microsoft.com/office/drawing/2014/main" id="{D598F56A-AB0C-4966-93A9-69CDEB8F0C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59345" y="13392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3" name="Line 150">
                <a:extLst>
                  <a:ext uri="{FF2B5EF4-FFF2-40B4-BE49-F238E27FC236}">
                    <a16:creationId xmlns="" xmlns:a16="http://schemas.microsoft.com/office/drawing/2014/main" id="{5C6C6E3E-DE59-44EF-8D9E-BDDE56936A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92788" y="1339253"/>
                <a:ext cx="0" cy="365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4" name="Line 151">
                <a:extLst>
                  <a:ext uri="{FF2B5EF4-FFF2-40B4-BE49-F238E27FC236}">
                    <a16:creationId xmlns="" xmlns:a16="http://schemas.microsoft.com/office/drawing/2014/main" id="{754F66C6-4B16-4FEB-95CD-D9B98C7244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68" y="13392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5" name="Line 152">
                <a:extLst>
                  <a:ext uri="{FF2B5EF4-FFF2-40B4-BE49-F238E27FC236}">
                    <a16:creationId xmlns="" xmlns:a16="http://schemas.microsoft.com/office/drawing/2014/main" id="{51DC7D99-BF89-4E69-9793-A335070D03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92788" y="1445615"/>
                <a:ext cx="0" cy="365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6" name="Line 153">
                <a:extLst>
                  <a:ext uri="{FF2B5EF4-FFF2-40B4-BE49-F238E27FC236}">
                    <a16:creationId xmlns="" xmlns:a16="http://schemas.microsoft.com/office/drawing/2014/main" id="{A9D4EA25-507C-4F37-A13C-90419473E4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68" y="1482128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7" name="Line 154">
                <a:extLst>
                  <a:ext uri="{FF2B5EF4-FFF2-40B4-BE49-F238E27FC236}">
                    <a16:creationId xmlns="" xmlns:a16="http://schemas.microsoft.com/office/drawing/2014/main" id="{00A0C02C-EDD8-4205-B3F0-3318A0DBB9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06071" y="2628303"/>
                <a:ext cx="0" cy="746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8" name="Line 155">
                <a:extLst>
                  <a:ext uri="{FF2B5EF4-FFF2-40B4-BE49-F238E27FC236}">
                    <a16:creationId xmlns="" xmlns:a16="http://schemas.microsoft.com/office/drawing/2014/main" id="{AAFB6899-F193-436D-AE76-10A2F3064D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791" y="26283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499" name="Line 156">
                <a:extLst>
                  <a:ext uri="{FF2B5EF4-FFF2-40B4-BE49-F238E27FC236}">
                    <a16:creationId xmlns="" xmlns:a16="http://schemas.microsoft.com/office/drawing/2014/main" id="{C42CF648-F765-4B7E-97B9-C9D77E0646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06071" y="2774353"/>
                <a:ext cx="0" cy="762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0" name="Line 157">
                <a:extLst>
                  <a:ext uri="{FF2B5EF4-FFF2-40B4-BE49-F238E27FC236}">
                    <a16:creationId xmlns="" xmlns:a16="http://schemas.microsoft.com/office/drawing/2014/main" id="{14900E34-67E6-4906-8A37-D12EE70647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791" y="28505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1" name="Line 158">
                <a:extLst>
                  <a:ext uri="{FF2B5EF4-FFF2-40B4-BE49-F238E27FC236}">
                    <a16:creationId xmlns="" xmlns:a16="http://schemas.microsoft.com/office/drawing/2014/main" id="{B0AA8059-4168-4808-ADE4-6F796A9BC2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22234" y="3288703"/>
                <a:ext cx="0" cy="650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2" name="Line 159">
                <a:extLst>
                  <a:ext uri="{FF2B5EF4-FFF2-40B4-BE49-F238E27FC236}">
                    <a16:creationId xmlns="" xmlns:a16="http://schemas.microsoft.com/office/drawing/2014/main" id="{07E1D618-ECF0-45C6-827E-5D471EF1F7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3514" y="32887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3" name="Line 160">
                <a:extLst>
                  <a:ext uri="{FF2B5EF4-FFF2-40B4-BE49-F238E27FC236}">
                    <a16:creationId xmlns="" xmlns:a16="http://schemas.microsoft.com/office/drawing/2014/main" id="{A5EA0651-D3D1-4440-89BA-74268274E6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722234" y="3423640"/>
                <a:ext cx="0" cy="650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4" name="Line 161">
                <a:extLst>
                  <a:ext uri="{FF2B5EF4-FFF2-40B4-BE49-F238E27FC236}">
                    <a16:creationId xmlns="" xmlns:a16="http://schemas.microsoft.com/office/drawing/2014/main" id="{26A4929A-BC7D-43DB-B25A-DC179ED0B7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3514" y="3488728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5" name="Line 162">
                <a:extLst>
                  <a:ext uri="{FF2B5EF4-FFF2-40B4-BE49-F238E27FC236}">
                    <a16:creationId xmlns="" xmlns:a16="http://schemas.microsoft.com/office/drawing/2014/main" id="{164F9E38-FED5-4EDB-AAA8-1B652B7337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35518" y="3345853"/>
                <a:ext cx="0" cy="508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6" name="Line 163">
                <a:extLst>
                  <a:ext uri="{FF2B5EF4-FFF2-40B4-BE49-F238E27FC236}">
                    <a16:creationId xmlns="" xmlns:a16="http://schemas.microsoft.com/office/drawing/2014/main" id="{CC406DC2-0A5A-4613-8477-C8C898981B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8238" y="33458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7" name="Line 164">
                <a:extLst>
                  <a:ext uri="{FF2B5EF4-FFF2-40B4-BE49-F238E27FC236}">
                    <a16:creationId xmlns="" xmlns:a16="http://schemas.microsoft.com/office/drawing/2014/main" id="{5C99E3FE-13D8-4A85-93F1-1101CC2DC5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135518" y="3466503"/>
                <a:ext cx="0" cy="523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8" name="Line 165">
                <a:extLst>
                  <a:ext uri="{FF2B5EF4-FFF2-40B4-BE49-F238E27FC236}">
                    <a16:creationId xmlns="" xmlns:a16="http://schemas.microsoft.com/office/drawing/2014/main" id="{F6625CFA-50D0-42C4-A322-B1451D093C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8238" y="3518890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09" name="Line 166">
                <a:extLst>
                  <a:ext uri="{FF2B5EF4-FFF2-40B4-BE49-F238E27FC236}">
                    <a16:creationId xmlns="" xmlns:a16="http://schemas.microsoft.com/office/drawing/2014/main" id="{7898B2EE-5F12-4329-99B1-F2EC42A06A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6625" y="1136053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0" name="Line 167">
                <a:extLst>
                  <a:ext uri="{FF2B5EF4-FFF2-40B4-BE49-F238E27FC236}">
                    <a16:creationId xmlns="" xmlns:a16="http://schemas.microsoft.com/office/drawing/2014/main" id="{7310102C-C9D9-4EAA-916C-AF33528932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59345" y="11360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1" name="Line 168">
                <a:extLst>
                  <a:ext uri="{FF2B5EF4-FFF2-40B4-BE49-F238E27FC236}">
                    <a16:creationId xmlns="" xmlns:a16="http://schemas.microsoft.com/office/drawing/2014/main" id="{99F5DA11-997A-4E03-815D-31603735A2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76625" y="1250353"/>
                <a:ext cx="0" cy="4445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2" name="Line 169">
                <a:extLst>
                  <a:ext uri="{FF2B5EF4-FFF2-40B4-BE49-F238E27FC236}">
                    <a16:creationId xmlns="" xmlns:a16="http://schemas.microsoft.com/office/drawing/2014/main" id="{583D3748-D598-447F-A964-D76DFB1524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59345" y="129480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3" name="Line 170">
                <a:extLst>
                  <a:ext uri="{FF2B5EF4-FFF2-40B4-BE49-F238E27FC236}">
                    <a16:creationId xmlns="" xmlns:a16="http://schemas.microsoft.com/office/drawing/2014/main" id="{9093C031-4CCC-4388-9726-1905454BE6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92788" y="1340840"/>
                <a:ext cx="0" cy="4127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4" name="Line 171">
                <a:extLst>
                  <a:ext uri="{FF2B5EF4-FFF2-40B4-BE49-F238E27FC236}">
                    <a16:creationId xmlns="" xmlns:a16="http://schemas.microsoft.com/office/drawing/2014/main" id="{46AD67EB-0D62-41BB-97E9-32F496110C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68" y="1340840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5" name="Line 172">
                <a:extLst>
                  <a:ext uri="{FF2B5EF4-FFF2-40B4-BE49-F238E27FC236}">
                    <a16:creationId xmlns="" xmlns:a16="http://schemas.microsoft.com/office/drawing/2014/main" id="{5DCDA97B-CA65-4D57-8373-F73250CF69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92788" y="1451965"/>
                <a:ext cx="0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6" name="Line 173">
                <a:extLst>
                  <a:ext uri="{FF2B5EF4-FFF2-40B4-BE49-F238E27FC236}">
                    <a16:creationId xmlns="" xmlns:a16="http://schemas.microsoft.com/office/drawing/2014/main" id="{632DE764-484D-4D0F-9129-6E2FCA4F57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74068" y="1494828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7" name="Line 174">
                <a:extLst>
                  <a:ext uri="{FF2B5EF4-FFF2-40B4-BE49-F238E27FC236}">
                    <a16:creationId xmlns="" xmlns:a16="http://schemas.microsoft.com/office/drawing/2014/main" id="{7F95B39B-DD6F-4AD2-A615-22C1C1C167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06071" y="2313978"/>
                <a:ext cx="0" cy="1190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8" name="Line 175">
                <a:extLst>
                  <a:ext uri="{FF2B5EF4-FFF2-40B4-BE49-F238E27FC236}">
                    <a16:creationId xmlns="" xmlns:a16="http://schemas.microsoft.com/office/drawing/2014/main" id="{17F4E0E8-FA47-499C-B09F-07ACDA08AB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791" y="2313978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19" name="Line 176">
                <a:extLst>
                  <a:ext uri="{FF2B5EF4-FFF2-40B4-BE49-F238E27FC236}">
                    <a16:creationId xmlns="" xmlns:a16="http://schemas.microsoft.com/office/drawing/2014/main" id="{C653380E-C384-462F-90D6-7BEA2E3712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06071" y="2504478"/>
                <a:ext cx="0" cy="1222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0" name="Line 177">
                <a:extLst>
                  <a:ext uri="{FF2B5EF4-FFF2-40B4-BE49-F238E27FC236}">
                    <a16:creationId xmlns="" xmlns:a16="http://schemas.microsoft.com/office/drawing/2014/main" id="{B6BE0264-6493-4A7C-B07E-77FA5120FC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791" y="2626715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1" name="Line 178">
                <a:extLst>
                  <a:ext uri="{FF2B5EF4-FFF2-40B4-BE49-F238E27FC236}">
                    <a16:creationId xmlns="" xmlns:a16="http://schemas.microsoft.com/office/drawing/2014/main" id="{6E218B9D-F30E-48A9-B07C-B1D3B22C09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22234" y="3271240"/>
                <a:ext cx="0" cy="635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2" name="Line 179">
                <a:extLst>
                  <a:ext uri="{FF2B5EF4-FFF2-40B4-BE49-F238E27FC236}">
                    <a16:creationId xmlns="" xmlns:a16="http://schemas.microsoft.com/office/drawing/2014/main" id="{C219210D-0280-458C-9817-C5F001E027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3514" y="3271240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3" name="Line 180">
                <a:extLst>
                  <a:ext uri="{FF2B5EF4-FFF2-40B4-BE49-F238E27FC236}">
                    <a16:creationId xmlns="" xmlns:a16="http://schemas.microsoft.com/office/drawing/2014/main" id="{68AA71B6-C68B-486B-BEAE-A1792AD3F7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722234" y="3406178"/>
                <a:ext cx="0" cy="635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4" name="Line 181">
                <a:extLst>
                  <a:ext uri="{FF2B5EF4-FFF2-40B4-BE49-F238E27FC236}">
                    <a16:creationId xmlns="" xmlns:a16="http://schemas.microsoft.com/office/drawing/2014/main" id="{EA549DA3-50A7-480D-8601-FC5653B23B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3514" y="3469678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5" name="Line 182">
                <a:extLst>
                  <a:ext uri="{FF2B5EF4-FFF2-40B4-BE49-F238E27FC236}">
                    <a16:creationId xmlns="" xmlns:a16="http://schemas.microsoft.com/office/drawing/2014/main" id="{6FDDCE17-AC6A-4CBE-844B-551BF56423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35518" y="3345853"/>
                <a:ext cx="0" cy="508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6" name="Line 183">
                <a:extLst>
                  <a:ext uri="{FF2B5EF4-FFF2-40B4-BE49-F238E27FC236}">
                    <a16:creationId xmlns="" xmlns:a16="http://schemas.microsoft.com/office/drawing/2014/main" id="{43143FEB-FB74-4FB5-80ED-6130861400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8238" y="3345853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7" name="Line 184">
                <a:extLst>
                  <a:ext uri="{FF2B5EF4-FFF2-40B4-BE49-F238E27FC236}">
                    <a16:creationId xmlns="" xmlns:a16="http://schemas.microsoft.com/office/drawing/2014/main" id="{23E6292A-BE3F-411B-9761-021D1B4AD8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135518" y="3466503"/>
                <a:ext cx="0" cy="523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8" name="Line 185">
                <a:extLst>
                  <a:ext uri="{FF2B5EF4-FFF2-40B4-BE49-F238E27FC236}">
                    <a16:creationId xmlns="" xmlns:a16="http://schemas.microsoft.com/office/drawing/2014/main" id="{E6D5EBA1-9519-4A83-95FF-FBA613FCD3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8238" y="3518890"/>
                <a:ext cx="36001" cy="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29" name="Freeform 186">
                <a:extLst>
                  <a:ext uri="{FF2B5EF4-FFF2-40B4-BE49-F238E27FC236}">
                    <a16:creationId xmlns="" xmlns:a16="http://schemas.microsoft.com/office/drawing/2014/main" id="{943DC31B-B4A3-4D21-A512-A33B63D099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63341" y="1204315"/>
                <a:ext cx="2072176" cy="2200275"/>
              </a:xfrm>
              <a:custGeom>
                <a:avLst/>
                <a:gdLst>
                  <a:gd name="T0" fmla="*/ 0 w 1439"/>
                  <a:gd name="T1" fmla="*/ 0 h 1386"/>
                  <a:gd name="T2" fmla="*/ 24 w 1439"/>
                  <a:gd name="T3" fmla="*/ 1 h 1386"/>
                  <a:gd name="T4" fmla="*/ 49 w 1439"/>
                  <a:gd name="T5" fmla="*/ 1 h 1386"/>
                  <a:gd name="T6" fmla="*/ 73 w 1439"/>
                  <a:gd name="T7" fmla="*/ 1 h 1386"/>
                  <a:gd name="T8" fmla="*/ 97 w 1439"/>
                  <a:gd name="T9" fmla="*/ 1 h 1386"/>
                  <a:gd name="T10" fmla="*/ 122 w 1439"/>
                  <a:gd name="T11" fmla="*/ 1 h 1386"/>
                  <a:gd name="T12" fmla="*/ 146 w 1439"/>
                  <a:gd name="T13" fmla="*/ 2 h 1386"/>
                  <a:gd name="T14" fmla="*/ 171 w 1439"/>
                  <a:gd name="T15" fmla="*/ 3 h 1386"/>
                  <a:gd name="T16" fmla="*/ 195 w 1439"/>
                  <a:gd name="T17" fmla="*/ 4 h 1386"/>
                  <a:gd name="T18" fmla="*/ 219 w 1439"/>
                  <a:gd name="T19" fmla="*/ 5 h 1386"/>
                  <a:gd name="T20" fmla="*/ 244 w 1439"/>
                  <a:gd name="T21" fmla="*/ 6 h 1386"/>
                  <a:gd name="T22" fmla="*/ 268 w 1439"/>
                  <a:gd name="T23" fmla="*/ 9 h 1386"/>
                  <a:gd name="T24" fmla="*/ 293 w 1439"/>
                  <a:gd name="T25" fmla="*/ 11 h 1386"/>
                  <a:gd name="T26" fmla="*/ 316 w 1439"/>
                  <a:gd name="T27" fmla="*/ 15 h 1386"/>
                  <a:gd name="T28" fmla="*/ 341 w 1439"/>
                  <a:gd name="T29" fmla="*/ 20 h 1386"/>
                  <a:gd name="T30" fmla="*/ 366 w 1439"/>
                  <a:gd name="T31" fmla="*/ 25 h 1386"/>
                  <a:gd name="T32" fmla="*/ 390 w 1439"/>
                  <a:gd name="T33" fmla="*/ 34 h 1386"/>
                  <a:gd name="T34" fmla="*/ 415 w 1439"/>
                  <a:gd name="T35" fmla="*/ 43 h 1386"/>
                  <a:gd name="T36" fmla="*/ 439 w 1439"/>
                  <a:gd name="T37" fmla="*/ 56 h 1386"/>
                  <a:gd name="T38" fmla="*/ 463 w 1439"/>
                  <a:gd name="T39" fmla="*/ 72 h 1386"/>
                  <a:gd name="T40" fmla="*/ 487 w 1439"/>
                  <a:gd name="T41" fmla="*/ 92 h 1386"/>
                  <a:gd name="T42" fmla="*/ 512 w 1439"/>
                  <a:gd name="T43" fmla="*/ 118 h 1386"/>
                  <a:gd name="T44" fmla="*/ 537 w 1439"/>
                  <a:gd name="T45" fmla="*/ 150 h 1386"/>
                  <a:gd name="T46" fmla="*/ 561 w 1439"/>
                  <a:gd name="T47" fmla="*/ 189 h 1386"/>
                  <a:gd name="T48" fmla="*/ 585 w 1439"/>
                  <a:gd name="T49" fmla="*/ 237 h 1386"/>
                  <a:gd name="T50" fmla="*/ 609 w 1439"/>
                  <a:gd name="T51" fmla="*/ 293 h 1386"/>
                  <a:gd name="T52" fmla="*/ 634 w 1439"/>
                  <a:gd name="T53" fmla="*/ 358 h 1386"/>
                  <a:gd name="T54" fmla="*/ 658 w 1439"/>
                  <a:gd name="T55" fmla="*/ 433 h 1386"/>
                  <a:gd name="T56" fmla="*/ 683 w 1439"/>
                  <a:gd name="T57" fmla="*/ 515 h 1386"/>
                  <a:gd name="T58" fmla="*/ 708 w 1439"/>
                  <a:gd name="T59" fmla="*/ 603 h 1386"/>
                  <a:gd name="T60" fmla="*/ 731 w 1439"/>
                  <a:gd name="T61" fmla="*/ 694 h 1386"/>
                  <a:gd name="T62" fmla="*/ 756 w 1439"/>
                  <a:gd name="T63" fmla="*/ 784 h 1386"/>
                  <a:gd name="T64" fmla="*/ 780 w 1439"/>
                  <a:gd name="T65" fmla="*/ 873 h 1386"/>
                  <a:gd name="T66" fmla="*/ 805 w 1439"/>
                  <a:gd name="T67" fmla="*/ 954 h 1386"/>
                  <a:gd name="T68" fmla="*/ 829 w 1439"/>
                  <a:gd name="T69" fmla="*/ 1029 h 1386"/>
                  <a:gd name="T70" fmla="*/ 853 w 1439"/>
                  <a:gd name="T71" fmla="*/ 1095 h 1386"/>
                  <a:gd name="T72" fmla="*/ 878 w 1439"/>
                  <a:gd name="T73" fmla="*/ 1151 h 1386"/>
                  <a:gd name="T74" fmla="*/ 902 w 1439"/>
                  <a:gd name="T75" fmla="*/ 1198 h 1386"/>
                  <a:gd name="T76" fmla="*/ 927 w 1439"/>
                  <a:gd name="T77" fmla="*/ 1236 h 1386"/>
                  <a:gd name="T78" fmla="*/ 951 w 1439"/>
                  <a:gd name="T79" fmla="*/ 1269 h 1386"/>
                  <a:gd name="T80" fmla="*/ 976 w 1439"/>
                  <a:gd name="T81" fmla="*/ 1294 h 1386"/>
                  <a:gd name="T82" fmla="*/ 1000 w 1439"/>
                  <a:gd name="T83" fmla="*/ 1314 h 1386"/>
                  <a:gd name="T84" fmla="*/ 1024 w 1439"/>
                  <a:gd name="T85" fmla="*/ 1330 h 1386"/>
                  <a:gd name="T86" fmla="*/ 1049 w 1439"/>
                  <a:gd name="T87" fmla="*/ 1343 h 1386"/>
                  <a:gd name="T88" fmla="*/ 1073 w 1439"/>
                  <a:gd name="T89" fmla="*/ 1353 h 1386"/>
                  <a:gd name="T90" fmla="*/ 1098 w 1439"/>
                  <a:gd name="T91" fmla="*/ 1360 h 1386"/>
                  <a:gd name="T92" fmla="*/ 1122 w 1439"/>
                  <a:gd name="T93" fmla="*/ 1367 h 1386"/>
                  <a:gd name="T94" fmla="*/ 1146 w 1439"/>
                  <a:gd name="T95" fmla="*/ 1371 h 1386"/>
                  <a:gd name="T96" fmla="*/ 1171 w 1439"/>
                  <a:gd name="T97" fmla="*/ 1374 h 1386"/>
                  <a:gd name="T98" fmla="*/ 1195 w 1439"/>
                  <a:gd name="T99" fmla="*/ 1377 h 1386"/>
                  <a:gd name="T100" fmla="*/ 1220 w 1439"/>
                  <a:gd name="T101" fmla="*/ 1379 h 1386"/>
                  <a:gd name="T102" fmla="*/ 1244 w 1439"/>
                  <a:gd name="T103" fmla="*/ 1381 h 1386"/>
                  <a:gd name="T104" fmla="*/ 1268 w 1439"/>
                  <a:gd name="T105" fmla="*/ 1382 h 1386"/>
                  <a:gd name="T106" fmla="*/ 1293 w 1439"/>
                  <a:gd name="T107" fmla="*/ 1383 h 1386"/>
                  <a:gd name="T108" fmla="*/ 1317 w 1439"/>
                  <a:gd name="T109" fmla="*/ 1384 h 1386"/>
                  <a:gd name="T110" fmla="*/ 1342 w 1439"/>
                  <a:gd name="T111" fmla="*/ 1385 h 1386"/>
                  <a:gd name="T112" fmla="*/ 1366 w 1439"/>
                  <a:gd name="T113" fmla="*/ 1385 h 1386"/>
                  <a:gd name="T114" fmla="*/ 1390 w 1439"/>
                  <a:gd name="T115" fmla="*/ 1385 h 1386"/>
                  <a:gd name="T116" fmla="*/ 1415 w 1439"/>
                  <a:gd name="T117" fmla="*/ 1386 h 1386"/>
                  <a:gd name="T118" fmla="*/ 1439 w 1439"/>
                  <a:gd name="T119" fmla="*/ 1386 h 13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439" h="1386">
                    <a:moveTo>
                      <a:pt x="0" y="0"/>
                    </a:moveTo>
                    <a:lnTo>
                      <a:pt x="24" y="1"/>
                    </a:lnTo>
                    <a:lnTo>
                      <a:pt x="49" y="1"/>
                    </a:lnTo>
                    <a:lnTo>
                      <a:pt x="73" y="1"/>
                    </a:lnTo>
                    <a:lnTo>
                      <a:pt x="97" y="1"/>
                    </a:lnTo>
                    <a:lnTo>
                      <a:pt x="122" y="1"/>
                    </a:lnTo>
                    <a:lnTo>
                      <a:pt x="146" y="2"/>
                    </a:lnTo>
                    <a:lnTo>
                      <a:pt x="171" y="3"/>
                    </a:lnTo>
                    <a:lnTo>
                      <a:pt x="195" y="4"/>
                    </a:lnTo>
                    <a:lnTo>
                      <a:pt x="219" y="5"/>
                    </a:lnTo>
                    <a:lnTo>
                      <a:pt x="244" y="6"/>
                    </a:lnTo>
                    <a:lnTo>
                      <a:pt x="268" y="9"/>
                    </a:lnTo>
                    <a:lnTo>
                      <a:pt x="293" y="11"/>
                    </a:lnTo>
                    <a:lnTo>
                      <a:pt x="316" y="15"/>
                    </a:lnTo>
                    <a:lnTo>
                      <a:pt x="341" y="20"/>
                    </a:lnTo>
                    <a:lnTo>
                      <a:pt x="366" y="25"/>
                    </a:lnTo>
                    <a:lnTo>
                      <a:pt x="390" y="34"/>
                    </a:lnTo>
                    <a:lnTo>
                      <a:pt x="415" y="43"/>
                    </a:lnTo>
                    <a:lnTo>
                      <a:pt x="439" y="56"/>
                    </a:lnTo>
                    <a:lnTo>
                      <a:pt x="463" y="72"/>
                    </a:lnTo>
                    <a:lnTo>
                      <a:pt x="487" y="92"/>
                    </a:lnTo>
                    <a:lnTo>
                      <a:pt x="512" y="118"/>
                    </a:lnTo>
                    <a:lnTo>
                      <a:pt x="537" y="150"/>
                    </a:lnTo>
                    <a:lnTo>
                      <a:pt x="561" y="189"/>
                    </a:lnTo>
                    <a:lnTo>
                      <a:pt x="585" y="237"/>
                    </a:lnTo>
                    <a:lnTo>
                      <a:pt x="609" y="293"/>
                    </a:lnTo>
                    <a:lnTo>
                      <a:pt x="634" y="358"/>
                    </a:lnTo>
                    <a:lnTo>
                      <a:pt x="658" y="433"/>
                    </a:lnTo>
                    <a:lnTo>
                      <a:pt x="683" y="515"/>
                    </a:lnTo>
                    <a:lnTo>
                      <a:pt x="708" y="603"/>
                    </a:lnTo>
                    <a:lnTo>
                      <a:pt x="731" y="694"/>
                    </a:lnTo>
                    <a:lnTo>
                      <a:pt x="756" y="784"/>
                    </a:lnTo>
                    <a:lnTo>
                      <a:pt x="780" y="873"/>
                    </a:lnTo>
                    <a:lnTo>
                      <a:pt x="805" y="954"/>
                    </a:lnTo>
                    <a:lnTo>
                      <a:pt x="829" y="1029"/>
                    </a:lnTo>
                    <a:lnTo>
                      <a:pt x="853" y="1095"/>
                    </a:lnTo>
                    <a:lnTo>
                      <a:pt x="878" y="1151"/>
                    </a:lnTo>
                    <a:lnTo>
                      <a:pt x="902" y="1198"/>
                    </a:lnTo>
                    <a:lnTo>
                      <a:pt x="927" y="1236"/>
                    </a:lnTo>
                    <a:lnTo>
                      <a:pt x="951" y="1269"/>
                    </a:lnTo>
                    <a:lnTo>
                      <a:pt x="976" y="1294"/>
                    </a:lnTo>
                    <a:lnTo>
                      <a:pt x="1000" y="1314"/>
                    </a:lnTo>
                    <a:lnTo>
                      <a:pt x="1024" y="1330"/>
                    </a:lnTo>
                    <a:lnTo>
                      <a:pt x="1049" y="1343"/>
                    </a:lnTo>
                    <a:lnTo>
                      <a:pt x="1073" y="1353"/>
                    </a:lnTo>
                    <a:lnTo>
                      <a:pt x="1098" y="1360"/>
                    </a:lnTo>
                    <a:lnTo>
                      <a:pt x="1122" y="1367"/>
                    </a:lnTo>
                    <a:lnTo>
                      <a:pt x="1146" y="1371"/>
                    </a:lnTo>
                    <a:lnTo>
                      <a:pt x="1171" y="1374"/>
                    </a:lnTo>
                    <a:lnTo>
                      <a:pt x="1195" y="1377"/>
                    </a:lnTo>
                    <a:lnTo>
                      <a:pt x="1220" y="1379"/>
                    </a:lnTo>
                    <a:lnTo>
                      <a:pt x="1244" y="1381"/>
                    </a:lnTo>
                    <a:lnTo>
                      <a:pt x="1268" y="1382"/>
                    </a:lnTo>
                    <a:lnTo>
                      <a:pt x="1293" y="1383"/>
                    </a:lnTo>
                    <a:lnTo>
                      <a:pt x="1317" y="1384"/>
                    </a:lnTo>
                    <a:lnTo>
                      <a:pt x="1342" y="1385"/>
                    </a:lnTo>
                    <a:lnTo>
                      <a:pt x="1366" y="1385"/>
                    </a:lnTo>
                    <a:lnTo>
                      <a:pt x="1390" y="1385"/>
                    </a:lnTo>
                    <a:lnTo>
                      <a:pt x="1415" y="1386"/>
                    </a:lnTo>
                    <a:lnTo>
                      <a:pt x="1439" y="1386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30" name="Freeform 187">
                <a:extLst>
                  <a:ext uri="{FF2B5EF4-FFF2-40B4-BE49-F238E27FC236}">
                    <a16:creationId xmlns="" xmlns:a16="http://schemas.microsoft.com/office/drawing/2014/main" id="{27CC5F20-D355-4799-A66E-B8DB21DC2A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63341" y="1217015"/>
                <a:ext cx="2072176" cy="2214563"/>
              </a:xfrm>
              <a:custGeom>
                <a:avLst/>
                <a:gdLst>
                  <a:gd name="T0" fmla="*/ 0 w 1439"/>
                  <a:gd name="T1" fmla="*/ 0 h 1395"/>
                  <a:gd name="T2" fmla="*/ 24 w 1439"/>
                  <a:gd name="T3" fmla="*/ 0 h 1395"/>
                  <a:gd name="T4" fmla="*/ 49 w 1439"/>
                  <a:gd name="T5" fmla="*/ 0 h 1395"/>
                  <a:gd name="T6" fmla="*/ 73 w 1439"/>
                  <a:gd name="T7" fmla="*/ 0 h 1395"/>
                  <a:gd name="T8" fmla="*/ 97 w 1439"/>
                  <a:gd name="T9" fmla="*/ 1 h 1395"/>
                  <a:gd name="T10" fmla="*/ 122 w 1439"/>
                  <a:gd name="T11" fmla="*/ 1 h 1395"/>
                  <a:gd name="T12" fmla="*/ 146 w 1439"/>
                  <a:gd name="T13" fmla="*/ 1 h 1395"/>
                  <a:gd name="T14" fmla="*/ 171 w 1439"/>
                  <a:gd name="T15" fmla="*/ 2 h 1395"/>
                  <a:gd name="T16" fmla="*/ 195 w 1439"/>
                  <a:gd name="T17" fmla="*/ 2 h 1395"/>
                  <a:gd name="T18" fmla="*/ 219 w 1439"/>
                  <a:gd name="T19" fmla="*/ 2 h 1395"/>
                  <a:gd name="T20" fmla="*/ 244 w 1439"/>
                  <a:gd name="T21" fmla="*/ 3 h 1395"/>
                  <a:gd name="T22" fmla="*/ 268 w 1439"/>
                  <a:gd name="T23" fmla="*/ 5 h 1395"/>
                  <a:gd name="T24" fmla="*/ 293 w 1439"/>
                  <a:gd name="T25" fmla="*/ 6 h 1395"/>
                  <a:gd name="T26" fmla="*/ 316 w 1439"/>
                  <a:gd name="T27" fmla="*/ 8 h 1395"/>
                  <a:gd name="T28" fmla="*/ 341 w 1439"/>
                  <a:gd name="T29" fmla="*/ 11 h 1395"/>
                  <a:gd name="T30" fmla="*/ 366 w 1439"/>
                  <a:gd name="T31" fmla="*/ 13 h 1395"/>
                  <a:gd name="T32" fmla="*/ 390 w 1439"/>
                  <a:gd name="T33" fmla="*/ 17 h 1395"/>
                  <a:gd name="T34" fmla="*/ 415 w 1439"/>
                  <a:gd name="T35" fmla="*/ 23 h 1395"/>
                  <a:gd name="T36" fmla="*/ 439 w 1439"/>
                  <a:gd name="T37" fmla="*/ 30 h 1395"/>
                  <a:gd name="T38" fmla="*/ 463 w 1439"/>
                  <a:gd name="T39" fmla="*/ 39 h 1395"/>
                  <a:gd name="T40" fmla="*/ 487 w 1439"/>
                  <a:gd name="T41" fmla="*/ 50 h 1395"/>
                  <a:gd name="T42" fmla="*/ 512 w 1439"/>
                  <a:gd name="T43" fmla="*/ 64 h 1395"/>
                  <a:gd name="T44" fmla="*/ 537 w 1439"/>
                  <a:gd name="T45" fmla="*/ 82 h 1395"/>
                  <a:gd name="T46" fmla="*/ 561 w 1439"/>
                  <a:gd name="T47" fmla="*/ 106 h 1395"/>
                  <a:gd name="T48" fmla="*/ 585 w 1439"/>
                  <a:gd name="T49" fmla="*/ 135 h 1395"/>
                  <a:gd name="T50" fmla="*/ 609 w 1439"/>
                  <a:gd name="T51" fmla="*/ 171 h 1395"/>
                  <a:gd name="T52" fmla="*/ 634 w 1439"/>
                  <a:gd name="T53" fmla="*/ 215 h 1395"/>
                  <a:gd name="T54" fmla="*/ 658 w 1439"/>
                  <a:gd name="T55" fmla="*/ 267 h 1395"/>
                  <a:gd name="T56" fmla="*/ 683 w 1439"/>
                  <a:gd name="T57" fmla="*/ 330 h 1395"/>
                  <a:gd name="T58" fmla="*/ 708 w 1439"/>
                  <a:gd name="T59" fmla="*/ 401 h 1395"/>
                  <a:gd name="T60" fmla="*/ 731 w 1439"/>
                  <a:gd name="T61" fmla="*/ 480 h 1395"/>
                  <a:gd name="T62" fmla="*/ 756 w 1439"/>
                  <a:gd name="T63" fmla="*/ 567 h 1395"/>
                  <a:gd name="T64" fmla="*/ 780 w 1439"/>
                  <a:gd name="T65" fmla="*/ 658 h 1395"/>
                  <a:gd name="T66" fmla="*/ 805 w 1439"/>
                  <a:gd name="T67" fmla="*/ 750 h 1395"/>
                  <a:gd name="T68" fmla="*/ 829 w 1439"/>
                  <a:gd name="T69" fmla="*/ 840 h 1395"/>
                  <a:gd name="T70" fmla="*/ 853 w 1439"/>
                  <a:gd name="T71" fmla="*/ 926 h 1395"/>
                  <a:gd name="T72" fmla="*/ 878 w 1439"/>
                  <a:gd name="T73" fmla="*/ 1004 h 1395"/>
                  <a:gd name="T74" fmla="*/ 902 w 1439"/>
                  <a:gd name="T75" fmla="*/ 1074 h 1395"/>
                  <a:gd name="T76" fmla="*/ 927 w 1439"/>
                  <a:gd name="T77" fmla="*/ 1135 h 1395"/>
                  <a:gd name="T78" fmla="*/ 951 w 1439"/>
                  <a:gd name="T79" fmla="*/ 1186 h 1395"/>
                  <a:gd name="T80" fmla="*/ 976 w 1439"/>
                  <a:gd name="T81" fmla="*/ 1229 h 1395"/>
                  <a:gd name="T82" fmla="*/ 1000 w 1439"/>
                  <a:gd name="T83" fmla="*/ 1265 h 1395"/>
                  <a:gd name="T84" fmla="*/ 1024 w 1439"/>
                  <a:gd name="T85" fmla="*/ 1293 h 1395"/>
                  <a:gd name="T86" fmla="*/ 1049 w 1439"/>
                  <a:gd name="T87" fmla="*/ 1315 h 1395"/>
                  <a:gd name="T88" fmla="*/ 1073 w 1439"/>
                  <a:gd name="T89" fmla="*/ 1333 h 1395"/>
                  <a:gd name="T90" fmla="*/ 1098 w 1439"/>
                  <a:gd name="T91" fmla="*/ 1347 h 1395"/>
                  <a:gd name="T92" fmla="*/ 1122 w 1439"/>
                  <a:gd name="T93" fmla="*/ 1358 h 1395"/>
                  <a:gd name="T94" fmla="*/ 1146 w 1439"/>
                  <a:gd name="T95" fmla="*/ 1367 h 1395"/>
                  <a:gd name="T96" fmla="*/ 1171 w 1439"/>
                  <a:gd name="T97" fmla="*/ 1374 h 1395"/>
                  <a:gd name="T98" fmla="*/ 1195 w 1439"/>
                  <a:gd name="T99" fmla="*/ 1379 h 1395"/>
                  <a:gd name="T100" fmla="*/ 1220 w 1439"/>
                  <a:gd name="T101" fmla="*/ 1383 h 1395"/>
                  <a:gd name="T102" fmla="*/ 1244 w 1439"/>
                  <a:gd name="T103" fmla="*/ 1386 h 1395"/>
                  <a:gd name="T104" fmla="*/ 1268 w 1439"/>
                  <a:gd name="T105" fmla="*/ 1388 h 1395"/>
                  <a:gd name="T106" fmla="*/ 1293 w 1439"/>
                  <a:gd name="T107" fmla="*/ 1390 h 1395"/>
                  <a:gd name="T108" fmla="*/ 1317 w 1439"/>
                  <a:gd name="T109" fmla="*/ 1391 h 1395"/>
                  <a:gd name="T110" fmla="*/ 1342 w 1439"/>
                  <a:gd name="T111" fmla="*/ 1393 h 1395"/>
                  <a:gd name="T112" fmla="*/ 1366 w 1439"/>
                  <a:gd name="T113" fmla="*/ 1393 h 1395"/>
                  <a:gd name="T114" fmla="*/ 1390 w 1439"/>
                  <a:gd name="T115" fmla="*/ 1394 h 1395"/>
                  <a:gd name="T116" fmla="*/ 1415 w 1439"/>
                  <a:gd name="T117" fmla="*/ 1394 h 1395"/>
                  <a:gd name="T118" fmla="*/ 1439 w 1439"/>
                  <a:gd name="T119" fmla="*/ 1395 h 13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439" h="1395">
                    <a:moveTo>
                      <a:pt x="0" y="0"/>
                    </a:moveTo>
                    <a:lnTo>
                      <a:pt x="24" y="0"/>
                    </a:lnTo>
                    <a:lnTo>
                      <a:pt x="49" y="0"/>
                    </a:lnTo>
                    <a:lnTo>
                      <a:pt x="73" y="0"/>
                    </a:lnTo>
                    <a:lnTo>
                      <a:pt x="97" y="1"/>
                    </a:lnTo>
                    <a:lnTo>
                      <a:pt x="122" y="1"/>
                    </a:lnTo>
                    <a:lnTo>
                      <a:pt x="146" y="1"/>
                    </a:lnTo>
                    <a:lnTo>
                      <a:pt x="171" y="2"/>
                    </a:lnTo>
                    <a:lnTo>
                      <a:pt x="195" y="2"/>
                    </a:lnTo>
                    <a:lnTo>
                      <a:pt x="219" y="2"/>
                    </a:lnTo>
                    <a:lnTo>
                      <a:pt x="244" y="3"/>
                    </a:lnTo>
                    <a:lnTo>
                      <a:pt x="268" y="5"/>
                    </a:lnTo>
                    <a:lnTo>
                      <a:pt x="293" y="6"/>
                    </a:lnTo>
                    <a:lnTo>
                      <a:pt x="316" y="8"/>
                    </a:lnTo>
                    <a:lnTo>
                      <a:pt x="341" y="11"/>
                    </a:lnTo>
                    <a:lnTo>
                      <a:pt x="366" y="13"/>
                    </a:lnTo>
                    <a:lnTo>
                      <a:pt x="390" y="17"/>
                    </a:lnTo>
                    <a:lnTo>
                      <a:pt x="415" y="23"/>
                    </a:lnTo>
                    <a:lnTo>
                      <a:pt x="439" y="30"/>
                    </a:lnTo>
                    <a:lnTo>
                      <a:pt x="463" y="39"/>
                    </a:lnTo>
                    <a:lnTo>
                      <a:pt x="487" y="50"/>
                    </a:lnTo>
                    <a:lnTo>
                      <a:pt x="512" y="64"/>
                    </a:lnTo>
                    <a:lnTo>
                      <a:pt x="537" y="82"/>
                    </a:lnTo>
                    <a:lnTo>
                      <a:pt x="561" y="106"/>
                    </a:lnTo>
                    <a:lnTo>
                      <a:pt x="585" y="135"/>
                    </a:lnTo>
                    <a:lnTo>
                      <a:pt x="609" y="171"/>
                    </a:lnTo>
                    <a:lnTo>
                      <a:pt x="634" y="215"/>
                    </a:lnTo>
                    <a:lnTo>
                      <a:pt x="658" y="267"/>
                    </a:lnTo>
                    <a:lnTo>
                      <a:pt x="683" y="330"/>
                    </a:lnTo>
                    <a:lnTo>
                      <a:pt x="708" y="401"/>
                    </a:lnTo>
                    <a:lnTo>
                      <a:pt x="731" y="480"/>
                    </a:lnTo>
                    <a:lnTo>
                      <a:pt x="756" y="567"/>
                    </a:lnTo>
                    <a:lnTo>
                      <a:pt x="780" y="658"/>
                    </a:lnTo>
                    <a:lnTo>
                      <a:pt x="805" y="750"/>
                    </a:lnTo>
                    <a:lnTo>
                      <a:pt x="829" y="840"/>
                    </a:lnTo>
                    <a:lnTo>
                      <a:pt x="853" y="926"/>
                    </a:lnTo>
                    <a:lnTo>
                      <a:pt x="878" y="1004"/>
                    </a:lnTo>
                    <a:lnTo>
                      <a:pt x="902" y="1074"/>
                    </a:lnTo>
                    <a:lnTo>
                      <a:pt x="927" y="1135"/>
                    </a:lnTo>
                    <a:lnTo>
                      <a:pt x="951" y="1186"/>
                    </a:lnTo>
                    <a:lnTo>
                      <a:pt x="976" y="1229"/>
                    </a:lnTo>
                    <a:lnTo>
                      <a:pt x="1000" y="1265"/>
                    </a:lnTo>
                    <a:lnTo>
                      <a:pt x="1024" y="1293"/>
                    </a:lnTo>
                    <a:lnTo>
                      <a:pt x="1049" y="1315"/>
                    </a:lnTo>
                    <a:lnTo>
                      <a:pt x="1073" y="1333"/>
                    </a:lnTo>
                    <a:lnTo>
                      <a:pt x="1098" y="1347"/>
                    </a:lnTo>
                    <a:lnTo>
                      <a:pt x="1122" y="1358"/>
                    </a:lnTo>
                    <a:lnTo>
                      <a:pt x="1146" y="1367"/>
                    </a:lnTo>
                    <a:lnTo>
                      <a:pt x="1171" y="1374"/>
                    </a:lnTo>
                    <a:lnTo>
                      <a:pt x="1195" y="1379"/>
                    </a:lnTo>
                    <a:lnTo>
                      <a:pt x="1220" y="1383"/>
                    </a:lnTo>
                    <a:lnTo>
                      <a:pt x="1244" y="1386"/>
                    </a:lnTo>
                    <a:lnTo>
                      <a:pt x="1268" y="1388"/>
                    </a:lnTo>
                    <a:lnTo>
                      <a:pt x="1293" y="1390"/>
                    </a:lnTo>
                    <a:lnTo>
                      <a:pt x="1317" y="1391"/>
                    </a:lnTo>
                    <a:lnTo>
                      <a:pt x="1342" y="1393"/>
                    </a:lnTo>
                    <a:lnTo>
                      <a:pt x="1366" y="1393"/>
                    </a:lnTo>
                    <a:lnTo>
                      <a:pt x="1390" y="1394"/>
                    </a:lnTo>
                    <a:lnTo>
                      <a:pt x="1415" y="1394"/>
                    </a:lnTo>
                    <a:lnTo>
                      <a:pt x="1439" y="139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31" name="Freeform 188">
                <a:extLst>
                  <a:ext uri="{FF2B5EF4-FFF2-40B4-BE49-F238E27FC236}">
                    <a16:creationId xmlns="" xmlns:a16="http://schemas.microsoft.com/office/drawing/2014/main" id="{ECC3DF38-8257-4534-A157-C447D46357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63341" y="1202728"/>
                <a:ext cx="2072176" cy="2247900"/>
              </a:xfrm>
              <a:custGeom>
                <a:avLst/>
                <a:gdLst>
                  <a:gd name="T0" fmla="*/ 0 w 1439"/>
                  <a:gd name="T1" fmla="*/ 0 h 1416"/>
                  <a:gd name="T2" fmla="*/ 24 w 1439"/>
                  <a:gd name="T3" fmla="*/ 0 h 1416"/>
                  <a:gd name="T4" fmla="*/ 49 w 1439"/>
                  <a:gd name="T5" fmla="*/ 0 h 1416"/>
                  <a:gd name="T6" fmla="*/ 73 w 1439"/>
                  <a:gd name="T7" fmla="*/ 1 h 1416"/>
                  <a:gd name="T8" fmla="*/ 97 w 1439"/>
                  <a:gd name="T9" fmla="*/ 1 h 1416"/>
                  <a:gd name="T10" fmla="*/ 122 w 1439"/>
                  <a:gd name="T11" fmla="*/ 2 h 1416"/>
                  <a:gd name="T12" fmla="*/ 146 w 1439"/>
                  <a:gd name="T13" fmla="*/ 2 h 1416"/>
                  <a:gd name="T14" fmla="*/ 171 w 1439"/>
                  <a:gd name="T15" fmla="*/ 2 h 1416"/>
                  <a:gd name="T16" fmla="*/ 195 w 1439"/>
                  <a:gd name="T17" fmla="*/ 3 h 1416"/>
                  <a:gd name="T18" fmla="*/ 219 w 1439"/>
                  <a:gd name="T19" fmla="*/ 5 h 1416"/>
                  <a:gd name="T20" fmla="*/ 244 w 1439"/>
                  <a:gd name="T21" fmla="*/ 7 h 1416"/>
                  <a:gd name="T22" fmla="*/ 268 w 1439"/>
                  <a:gd name="T23" fmla="*/ 8 h 1416"/>
                  <a:gd name="T24" fmla="*/ 293 w 1439"/>
                  <a:gd name="T25" fmla="*/ 10 h 1416"/>
                  <a:gd name="T26" fmla="*/ 316 w 1439"/>
                  <a:gd name="T27" fmla="*/ 13 h 1416"/>
                  <a:gd name="T28" fmla="*/ 341 w 1439"/>
                  <a:gd name="T29" fmla="*/ 16 h 1416"/>
                  <a:gd name="T30" fmla="*/ 366 w 1439"/>
                  <a:gd name="T31" fmla="*/ 21 h 1416"/>
                  <a:gd name="T32" fmla="*/ 390 w 1439"/>
                  <a:gd name="T33" fmla="*/ 25 h 1416"/>
                  <a:gd name="T34" fmla="*/ 415 w 1439"/>
                  <a:gd name="T35" fmla="*/ 32 h 1416"/>
                  <a:gd name="T36" fmla="*/ 439 w 1439"/>
                  <a:gd name="T37" fmla="*/ 40 h 1416"/>
                  <a:gd name="T38" fmla="*/ 463 w 1439"/>
                  <a:gd name="T39" fmla="*/ 49 h 1416"/>
                  <a:gd name="T40" fmla="*/ 487 w 1439"/>
                  <a:gd name="T41" fmla="*/ 61 h 1416"/>
                  <a:gd name="T42" fmla="*/ 512 w 1439"/>
                  <a:gd name="T43" fmla="*/ 76 h 1416"/>
                  <a:gd name="T44" fmla="*/ 537 w 1439"/>
                  <a:gd name="T45" fmla="*/ 93 h 1416"/>
                  <a:gd name="T46" fmla="*/ 561 w 1439"/>
                  <a:gd name="T47" fmla="*/ 115 h 1416"/>
                  <a:gd name="T48" fmla="*/ 585 w 1439"/>
                  <a:gd name="T49" fmla="*/ 140 h 1416"/>
                  <a:gd name="T50" fmla="*/ 609 w 1439"/>
                  <a:gd name="T51" fmla="*/ 170 h 1416"/>
                  <a:gd name="T52" fmla="*/ 634 w 1439"/>
                  <a:gd name="T53" fmla="*/ 206 h 1416"/>
                  <a:gd name="T54" fmla="*/ 658 w 1439"/>
                  <a:gd name="T55" fmla="*/ 248 h 1416"/>
                  <a:gd name="T56" fmla="*/ 683 w 1439"/>
                  <a:gd name="T57" fmla="*/ 297 h 1416"/>
                  <a:gd name="T58" fmla="*/ 708 w 1439"/>
                  <a:gd name="T59" fmla="*/ 351 h 1416"/>
                  <a:gd name="T60" fmla="*/ 731 w 1439"/>
                  <a:gd name="T61" fmla="*/ 413 h 1416"/>
                  <a:gd name="T62" fmla="*/ 756 w 1439"/>
                  <a:gd name="T63" fmla="*/ 481 h 1416"/>
                  <a:gd name="T64" fmla="*/ 780 w 1439"/>
                  <a:gd name="T65" fmla="*/ 553 h 1416"/>
                  <a:gd name="T66" fmla="*/ 805 w 1439"/>
                  <a:gd name="T67" fmla="*/ 629 h 1416"/>
                  <a:gd name="T68" fmla="*/ 829 w 1439"/>
                  <a:gd name="T69" fmla="*/ 707 h 1416"/>
                  <a:gd name="T70" fmla="*/ 853 w 1439"/>
                  <a:gd name="T71" fmla="*/ 784 h 1416"/>
                  <a:gd name="T72" fmla="*/ 878 w 1439"/>
                  <a:gd name="T73" fmla="*/ 860 h 1416"/>
                  <a:gd name="T74" fmla="*/ 902 w 1439"/>
                  <a:gd name="T75" fmla="*/ 933 h 1416"/>
                  <a:gd name="T76" fmla="*/ 927 w 1439"/>
                  <a:gd name="T77" fmla="*/ 1001 h 1416"/>
                  <a:gd name="T78" fmla="*/ 951 w 1439"/>
                  <a:gd name="T79" fmla="*/ 1063 h 1416"/>
                  <a:gd name="T80" fmla="*/ 976 w 1439"/>
                  <a:gd name="T81" fmla="*/ 1119 h 1416"/>
                  <a:gd name="T82" fmla="*/ 1000 w 1439"/>
                  <a:gd name="T83" fmla="*/ 1168 h 1416"/>
                  <a:gd name="T84" fmla="*/ 1024 w 1439"/>
                  <a:gd name="T85" fmla="*/ 1210 h 1416"/>
                  <a:gd name="T86" fmla="*/ 1049 w 1439"/>
                  <a:gd name="T87" fmla="*/ 1247 h 1416"/>
                  <a:gd name="T88" fmla="*/ 1073 w 1439"/>
                  <a:gd name="T89" fmla="*/ 1278 h 1416"/>
                  <a:gd name="T90" fmla="*/ 1098 w 1439"/>
                  <a:gd name="T91" fmla="*/ 1304 h 1416"/>
                  <a:gd name="T92" fmla="*/ 1122 w 1439"/>
                  <a:gd name="T93" fmla="*/ 1326 h 1416"/>
                  <a:gd name="T94" fmla="*/ 1146 w 1439"/>
                  <a:gd name="T95" fmla="*/ 1343 h 1416"/>
                  <a:gd name="T96" fmla="*/ 1171 w 1439"/>
                  <a:gd name="T97" fmla="*/ 1358 h 1416"/>
                  <a:gd name="T98" fmla="*/ 1195 w 1439"/>
                  <a:gd name="T99" fmla="*/ 1370 h 1416"/>
                  <a:gd name="T100" fmla="*/ 1220 w 1439"/>
                  <a:gd name="T101" fmla="*/ 1380 h 1416"/>
                  <a:gd name="T102" fmla="*/ 1244 w 1439"/>
                  <a:gd name="T103" fmla="*/ 1388 h 1416"/>
                  <a:gd name="T104" fmla="*/ 1268 w 1439"/>
                  <a:gd name="T105" fmla="*/ 1394 h 1416"/>
                  <a:gd name="T106" fmla="*/ 1293 w 1439"/>
                  <a:gd name="T107" fmla="*/ 1400 h 1416"/>
                  <a:gd name="T108" fmla="*/ 1317 w 1439"/>
                  <a:gd name="T109" fmla="*/ 1404 h 1416"/>
                  <a:gd name="T110" fmla="*/ 1342 w 1439"/>
                  <a:gd name="T111" fmla="*/ 1407 h 1416"/>
                  <a:gd name="T112" fmla="*/ 1366 w 1439"/>
                  <a:gd name="T113" fmla="*/ 1410 h 1416"/>
                  <a:gd name="T114" fmla="*/ 1390 w 1439"/>
                  <a:gd name="T115" fmla="*/ 1412 h 1416"/>
                  <a:gd name="T116" fmla="*/ 1415 w 1439"/>
                  <a:gd name="T117" fmla="*/ 1414 h 1416"/>
                  <a:gd name="T118" fmla="*/ 1439 w 1439"/>
                  <a:gd name="T119" fmla="*/ 1416 h 1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439" h="1416">
                    <a:moveTo>
                      <a:pt x="0" y="0"/>
                    </a:moveTo>
                    <a:lnTo>
                      <a:pt x="24" y="0"/>
                    </a:lnTo>
                    <a:lnTo>
                      <a:pt x="49" y="0"/>
                    </a:lnTo>
                    <a:lnTo>
                      <a:pt x="73" y="1"/>
                    </a:lnTo>
                    <a:lnTo>
                      <a:pt x="97" y="1"/>
                    </a:lnTo>
                    <a:lnTo>
                      <a:pt x="122" y="2"/>
                    </a:lnTo>
                    <a:lnTo>
                      <a:pt x="146" y="2"/>
                    </a:lnTo>
                    <a:lnTo>
                      <a:pt x="171" y="2"/>
                    </a:lnTo>
                    <a:lnTo>
                      <a:pt x="195" y="3"/>
                    </a:lnTo>
                    <a:lnTo>
                      <a:pt x="219" y="5"/>
                    </a:lnTo>
                    <a:lnTo>
                      <a:pt x="244" y="7"/>
                    </a:lnTo>
                    <a:lnTo>
                      <a:pt x="268" y="8"/>
                    </a:lnTo>
                    <a:lnTo>
                      <a:pt x="293" y="10"/>
                    </a:lnTo>
                    <a:lnTo>
                      <a:pt x="316" y="13"/>
                    </a:lnTo>
                    <a:lnTo>
                      <a:pt x="341" y="16"/>
                    </a:lnTo>
                    <a:lnTo>
                      <a:pt x="366" y="21"/>
                    </a:lnTo>
                    <a:lnTo>
                      <a:pt x="390" y="25"/>
                    </a:lnTo>
                    <a:lnTo>
                      <a:pt x="415" y="32"/>
                    </a:lnTo>
                    <a:lnTo>
                      <a:pt x="439" y="40"/>
                    </a:lnTo>
                    <a:lnTo>
                      <a:pt x="463" y="49"/>
                    </a:lnTo>
                    <a:lnTo>
                      <a:pt x="487" y="61"/>
                    </a:lnTo>
                    <a:lnTo>
                      <a:pt x="512" y="76"/>
                    </a:lnTo>
                    <a:lnTo>
                      <a:pt x="537" y="93"/>
                    </a:lnTo>
                    <a:lnTo>
                      <a:pt x="561" y="115"/>
                    </a:lnTo>
                    <a:lnTo>
                      <a:pt x="585" y="140"/>
                    </a:lnTo>
                    <a:lnTo>
                      <a:pt x="609" y="170"/>
                    </a:lnTo>
                    <a:lnTo>
                      <a:pt x="634" y="206"/>
                    </a:lnTo>
                    <a:lnTo>
                      <a:pt x="658" y="248"/>
                    </a:lnTo>
                    <a:lnTo>
                      <a:pt x="683" y="297"/>
                    </a:lnTo>
                    <a:lnTo>
                      <a:pt x="708" y="351"/>
                    </a:lnTo>
                    <a:lnTo>
                      <a:pt x="731" y="413"/>
                    </a:lnTo>
                    <a:lnTo>
                      <a:pt x="756" y="481"/>
                    </a:lnTo>
                    <a:lnTo>
                      <a:pt x="780" y="553"/>
                    </a:lnTo>
                    <a:lnTo>
                      <a:pt x="805" y="629"/>
                    </a:lnTo>
                    <a:lnTo>
                      <a:pt x="829" y="707"/>
                    </a:lnTo>
                    <a:lnTo>
                      <a:pt x="853" y="784"/>
                    </a:lnTo>
                    <a:lnTo>
                      <a:pt x="878" y="860"/>
                    </a:lnTo>
                    <a:lnTo>
                      <a:pt x="902" y="933"/>
                    </a:lnTo>
                    <a:lnTo>
                      <a:pt x="927" y="1001"/>
                    </a:lnTo>
                    <a:lnTo>
                      <a:pt x="951" y="1063"/>
                    </a:lnTo>
                    <a:lnTo>
                      <a:pt x="976" y="1119"/>
                    </a:lnTo>
                    <a:lnTo>
                      <a:pt x="1000" y="1168"/>
                    </a:lnTo>
                    <a:lnTo>
                      <a:pt x="1024" y="1210"/>
                    </a:lnTo>
                    <a:lnTo>
                      <a:pt x="1049" y="1247"/>
                    </a:lnTo>
                    <a:lnTo>
                      <a:pt x="1073" y="1278"/>
                    </a:lnTo>
                    <a:lnTo>
                      <a:pt x="1098" y="1304"/>
                    </a:lnTo>
                    <a:lnTo>
                      <a:pt x="1122" y="1326"/>
                    </a:lnTo>
                    <a:lnTo>
                      <a:pt x="1146" y="1343"/>
                    </a:lnTo>
                    <a:lnTo>
                      <a:pt x="1171" y="1358"/>
                    </a:lnTo>
                    <a:lnTo>
                      <a:pt x="1195" y="1370"/>
                    </a:lnTo>
                    <a:lnTo>
                      <a:pt x="1220" y="1380"/>
                    </a:lnTo>
                    <a:lnTo>
                      <a:pt x="1244" y="1388"/>
                    </a:lnTo>
                    <a:lnTo>
                      <a:pt x="1268" y="1394"/>
                    </a:lnTo>
                    <a:lnTo>
                      <a:pt x="1293" y="1400"/>
                    </a:lnTo>
                    <a:lnTo>
                      <a:pt x="1317" y="1404"/>
                    </a:lnTo>
                    <a:lnTo>
                      <a:pt x="1342" y="1407"/>
                    </a:lnTo>
                    <a:lnTo>
                      <a:pt x="1366" y="1410"/>
                    </a:lnTo>
                    <a:lnTo>
                      <a:pt x="1390" y="1412"/>
                    </a:lnTo>
                    <a:lnTo>
                      <a:pt x="1415" y="1414"/>
                    </a:lnTo>
                    <a:lnTo>
                      <a:pt x="1439" y="1416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35" name="Freeform 192">
                <a:extLst>
                  <a:ext uri="{FF2B5EF4-FFF2-40B4-BE49-F238E27FC236}">
                    <a16:creationId xmlns="" xmlns:a16="http://schemas.microsoft.com/office/drawing/2014/main" id="{CDB059A5-74A4-4980-99E8-203AF291EF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87088" y="2755144"/>
                <a:ext cx="57600" cy="92075"/>
              </a:xfrm>
              <a:custGeom>
                <a:avLst/>
                <a:gdLst>
                  <a:gd name="T0" fmla="*/ 0 w 40"/>
                  <a:gd name="T1" fmla="*/ 29 h 58"/>
                  <a:gd name="T2" fmla="*/ 20 w 40"/>
                  <a:gd name="T3" fmla="*/ 0 h 58"/>
                  <a:gd name="T4" fmla="*/ 40 w 40"/>
                  <a:gd name="T5" fmla="*/ 29 h 58"/>
                  <a:gd name="T6" fmla="*/ 20 w 40"/>
                  <a:gd name="T7" fmla="*/ 58 h 58"/>
                  <a:gd name="T8" fmla="*/ 0 w 40"/>
                  <a:gd name="T9" fmla="*/ 29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40" h="58">
                    <a:moveTo>
                      <a:pt x="0" y="29"/>
                    </a:moveTo>
                    <a:lnTo>
                      <a:pt x="20" y="0"/>
                    </a:lnTo>
                    <a:lnTo>
                      <a:pt x="40" y="29"/>
                    </a:lnTo>
                    <a:lnTo>
                      <a:pt x="20" y="58"/>
                    </a:lnTo>
                    <a:lnTo>
                      <a:pt x="0" y="29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grpSp>
            <p:nvGrpSpPr>
              <p:cNvPr id="542" name="Grupo 541">
                <a:extLst>
                  <a:ext uri="{FF2B5EF4-FFF2-40B4-BE49-F238E27FC236}">
                    <a16:creationId xmlns="" xmlns:a16="http://schemas.microsoft.com/office/drawing/2014/main" id="{E4454A5D-C150-42BE-9CA7-E99AC9BD9EE3}"/>
                  </a:ext>
                </a:extLst>
              </p:cNvPr>
              <p:cNvGrpSpPr/>
              <p:nvPr/>
            </p:nvGrpSpPr>
            <p:grpSpPr>
              <a:xfrm>
                <a:off x="5088360" y="3344253"/>
                <a:ext cx="57602" cy="92076"/>
                <a:chOff x="1067176" y="5311926"/>
                <a:chExt cx="63502" cy="92076"/>
              </a:xfrm>
            </p:grpSpPr>
            <p:sp>
              <p:nvSpPr>
                <p:cNvPr id="539" name="Freeform 196">
                  <a:extLst>
                    <a:ext uri="{FF2B5EF4-FFF2-40B4-BE49-F238E27FC236}">
                      <a16:creationId xmlns="" xmlns:a16="http://schemas.microsoft.com/office/drawing/2014/main" id="{27EA830E-BF64-4F9E-917E-7F23A5B8EC8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7179" y="5311926"/>
                  <a:ext cx="63499" cy="46038"/>
                </a:xfrm>
                <a:custGeom>
                  <a:avLst/>
                  <a:gdLst>
                    <a:gd name="T0" fmla="*/ 0 w 40"/>
                    <a:gd name="T1" fmla="*/ 29 h 29"/>
                    <a:gd name="T2" fmla="*/ 40 w 40"/>
                    <a:gd name="T3" fmla="*/ 29 h 29"/>
                    <a:gd name="T4" fmla="*/ 20 w 40"/>
                    <a:gd name="T5" fmla="*/ 0 h 29"/>
                    <a:gd name="T6" fmla="*/ 0 w 40"/>
                    <a:gd name="T7" fmla="*/ 29 h 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0" h="29">
                      <a:moveTo>
                        <a:pt x="0" y="29"/>
                      </a:moveTo>
                      <a:lnTo>
                        <a:pt x="40" y="29"/>
                      </a:lnTo>
                      <a:lnTo>
                        <a:pt x="20" y="0"/>
                      </a:lnTo>
                      <a:lnTo>
                        <a:pt x="0" y="2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MX"/>
                </a:p>
              </p:txBody>
            </p:sp>
            <p:sp>
              <p:nvSpPr>
                <p:cNvPr id="540" name="Freeform 197">
                  <a:extLst>
                    <a:ext uri="{FF2B5EF4-FFF2-40B4-BE49-F238E27FC236}">
                      <a16:creationId xmlns="" xmlns:a16="http://schemas.microsoft.com/office/drawing/2014/main" id="{278B527E-95C3-4405-BC3F-D9F29009DA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7176" y="5357964"/>
                  <a:ext cx="63500" cy="46038"/>
                </a:xfrm>
                <a:custGeom>
                  <a:avLst/>
                  <a:gdLst>
                    <a:gd name="T0" fmla="*/ 0 w 40"/>
                    <a:gd name="T1" fmla="*/ 0 h 29"/>
                    <a:gd name="T2" fmla="*/ 40 w 40"/>
                    <a:gd name="T3" fmla="*/ 0 h 29"/>
                    <a:gd name="T4" fmla="*/ 20 w 40"/>
                    <a:gd name="T5" fmla="*/ 29 h 29"/>
                    <a:gd name="T6" fmla="*/ 0 w 40"/>
                    <a:gd name="T7" fmla="*/ 0 h 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0" h="29">
                      <a:moveTo>
                        <a:pt x="0" y="0"/>
                      </a:moveTo>
                      <a:lnTo>
                        <a:pt x="40" y="0"/>
                      </a:lnTo>
                      <a:lnTo>
                        <a:pt x="20" y="29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MX"/>
                </a:p>
              </p:txBody>
            </p:sp>
          </p:grpSp>
        </p:grpSp>
        <p:grpSp>
          <p:nvGrpSpPr>
            <p:cNvPr id="4" name="3 Grupo"/>
            <p:cNvGrpSpPr/>
            <p:nvPr/>
          </p:nvGrpSpPr>
          <p:grpSpPr>
            <a:xfrm>
              <a:off x="998068" y="2994876"/>
              <a:ext cx="3456457" cy="919522"/>
              <a:chOff x="998068" y="2994876"/>
              <a:chExt cx="3456457" cy="919522"/>
            </a:xfrm>
          </p:grpSpPr>
          <p:grpSp>
            <p:nvGrpSpPr>
              <p:cNvPr id="87" name="169 Grupo">
                <a:extLst>
                  <a:ext uri="{FF2B5EF4-FFF2-40B4-BE49-F238E27FC236}">
                    <a16:creationId xmlns="" xmlns:a16="http://schemas.microsoft.com/office/drawing/2014/main" id="{0A5A6E97-12C6-49E9-99F5-248B3D2F91C7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998068" y="2994876"/>
                <a:ext cx="744279" cy="366707"/>
                <a:chOff x="-806073" y="1205728"/>
                <a:chExt cx="1227396" cy="366601"/>
              </a:xfrm>
            </p:grpSpPr>
            <p:sp>
              <p:nvSpPr>
                <p:cNvPr id="94" name="170 CuadroTexto">
                  <a:extLst>
                    <a:ext uri="{FF2B5EF4-FFF2-40B4-BE49-F238E27FC236}">
                      <a16:creationId xmlns="" xmlns:a16="http://schemas.microsoft.com/office/drawing/2014/main" id="{E77653D7-AC20-47E7-BB94-F7D79D9828C6}"/>
                    </a:ext>
                  </a:extLst>
                </p:cNvPr>
                <p:cNvSpPr txBox="1"/>
                <p:nvPr/>
              </p:nvSpPr>
              <p:spPr>
                <a:xfrm>
                  <a:off x="-806073" y="1341562"/>
                  <a:ext cx="1224502" cy="230767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900" kern="0" dirty="0" err="1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Hypo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 (30mM)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95" name="171 CuadroTexto">
                  <a:extLst>
                    <a:ext uri="{FF2B5EF4-FFF2-40B4-BE49-F238E27FC236}">
                      <a16:creationId xmlns="" xmlns:a16="http://schemas.microsoft.com/office/drawing/2014/main" id="{53584BBF-D686-4386-8485-44000317A7B8}"/>
                    </a:ext>
                  </a:extLst>
                </p:cNvPr>
                <p:cNvSpPr txBox="1"/>
                <p:nvPr/>
              </p:nvSpPr>
              <p:spPr>
                <a:xfrm>
                  <a:off x="-800830" y="1205728"/>
                  <a:ext cx="1222153" cy="230767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Homo     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cs typeface="Arial" pitchFamily="34" charset="0"/>
                    </a:rPr>
                    <a:t>(µM)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</p:grpSp>
          <p:grpSp>
            <p:nvGrpSpPr>
              <p:cNvPr id="158" name="Grupo 157">
                <a:extLst>
                  <a:ext uri="{FF2B5EF4-FFF2-40B4-BE49-F238E27FC236}">
                    <a16:creationId xmlns="" xmlns:a16="http://schemas.microsoft.com/office/drawing/2014/main" id="{29F179FB-0ADE-489C-96E6-D4F048FA0D46}"/>
                  </a:ext>
                </a:extLst>
              </p:cNvPr>
              <p:cNvGrpSpPr/>
              <p:nvPr/>
            </p:nvGrpSpPr>
            <p:grpSpPr>
              <a:xfrm>
                <a:off x="1804690" y="3284984"/>
                <a:ext cx="2497687" cy="0"/>
                <a:chOff x="1062385" y="1268760"/>
                <a:chExt cx="2810386" cy="0"/>
              </a:xfrm>
            </p:grpSpPr>
            <p:cxnSp>
              <p:nvCxnSpPr>
                <p:cNvPr id="159" name="91 Conector recto">
                  <a:extLst>
                    <a:ext uri="{FF2B5EF4-FFF2-40B4-BE49-F238E27FC236}">
                      <a16:creationId xmlns="" xmlns:a16="http://schemas.microsoft.com/office/drawing/2014/main" id="{5D56190D-46F4-4131-A9F2-43F03DD12AC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62385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0" name="91 Conector recto">
                  <a:extLst>
                    <a:ext uri="{FF2B5EF4-FFF2-40B4-BE49-F238E27FC236}">
                      <a16:creationId xmlns="" xmlns:a16="http://schemas.microsoft.com/office/drawing/2014/main" id="{DB6DA8B9-7532-400C-8DCA-8E6EF9FDBBAD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47680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1" name="91 Conector recto">
                  <a:extLst>
                    <a:ext uri="{FF2B5EF4-FFF2-40B4-BE49-F238E27FC236}">
                      <a16:creationId xmlns="" xmlns:a16="http://schemas.microsoft.com/office/drawing/2014/main" id="{1141068B-8324-42AA-BCB7-574C21D416D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938771" y="1268760"/>
                  <a:ext cx="1728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2" name="91 Conector recto">
                  <a:extLst>
                    <a:ext uri="{FF2B5EF4-FFF2-40B4-BE49-F238E27FC236}">
                      <a16:creationId xmlns="" xmlns:a16="http://schemas.microsoft.com/office/drawing/2014/main" id="{ACC41658-C4BD-44A0-81BB-1175241D59D1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373709" y="1268760"/>
                  <a:ext cx="180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3" name="91 Conector recto">
                  <a:extLst>
                    <a:ext uri="{FF2B5EF4-FFF2-40B4-BE49-F238E27FC236}">
                      <a16:creationId xmlns="" xmlns:a16="http://schemas.microsoft.com/office/drawing/2014/main" id="{64ED13E8-F4AD-4E0A-9BD6-751E307CEC06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855020" y="1268760"/>
                  <a:ext cx="1728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4" name="91 Conector recto">
                  <a:extLst>
                    <a:ext uri="{FF2B5EF4-FFF2-40B4-BE49-F238E27FC236}">
                      <a16:creationId xmlns="" xmlns:a16="http://schemas.microsoft.com/office/drawing/2014/main" id="{3C6D3E24-E900-40B1-97D5-CB5F02AA928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282731" y="1268760"/>
                  <a:ext cx="162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5" name="91 Conector recto">
                  <a:extLst>
                    <a:ext uri="{FF2B5EF4-FFF2-40B4-BE49-F238E27FC236}">
                      <a16:creationId xmlns="" xmlns:a16="http://schemas.microsoft.com/office/drawing/2014/main" id="{1EB57BB8-0E02-45D0-908E-9FFEAF6177B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696371" y="1268760"/>
                  <a:ext cx="1764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166" name="Grupo 165">
                <a:extLst>
                  <a:ext uri="{FF2B5EF4-FFF2-40B4-BE49-F238E27FC236}">
                    <a16:creationId xmlns="" xmlns:a16="http://schemas.microsoft.com/office/drawing/2014/main" id="{A037CBAA-EF4F-4CE1-8441-252DC7E3F518}"/>
                  </a:ext>
                </a:extLst>
              </p:cNvPr>
              <p:cNvGrpSpPr/>
              <p:nvPr/>
            </p:nvGrpSpPr>
            <p:grpSpPr>
              <a:xfrm>
                <a:off x="2272136" y="3178034"/>
                <a:ext cx="2004830" cy="7648"/>
                <a:chOff x="1637095" y="1127498"/>
                <a:chExt cx="2255826" cy="7648"/>
              </a:xfrm>
            </p:grpSpPr>
            <p:cxnSp>
              <p:nvCxnSpPr>
                <p:cNvPr id="167" name="92 Conector recto">
                  <a:extLst>
                    <a:ext uri="{FF2B5EF4-FFF2-40B4-BE49-F238E27FC236}">
                      <a16:creationId xmlns="" xmlns:a16="http://schemas.microsoft.com/office/drawing/2014/main" id="{2F059ABC-6A52-4315-883F-5772F62DB10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637095" y="1135146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8" name="94 Conector recto">
                  <a:extLst>
                    <a:ext uri="{FF2B5EF4-FFF2-40B4-BE49-F238E27FC236}">
                      <a16:creationId xmlns="" xmlns:a16="http://schemas.microsoft.com/office/drawing/2014/main" id="{180CC70D-A0E5-4ECC-9784-E5BFC5107EDF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036525" y="1135146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69" name="100 Conector recto">
                  <a:extLst>
                    <a:ext uri="{FF2B5EF4-FFF2-40B4-BE49-F238E27FC236}">
                      <a16:creationId xmlns="" xmlns:a16="http://schemas.microsoft.com/office/drawing/2014/main" id="{3EB11420-7596-40CF-A36A-823289BF9FAD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480168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70" name="101 Conector recto">
                  <a:extLst>
                    <a:ext uri="{FF2B5EF4-FFF2-40B4-BE49-F238E27FC236}">
                      <a16:creationId xmlns="" xmlns:a16="http://schemas.microsoft.com/office/drawing/2014/main" id="{8F80D2BC-EBCB-4B01-860A-8B3192BC4EC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953267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71" name="102 Conector recto">
                  <a:extLst>
                    <a:ext uri="{FF2B5EF4-FFF2-40B4-BE49-F238E27FC236}">
                      <a16:creationId xmlns="" xmlns:a16="http://schemas.microsoft.com/office/drawing/2014/main" id="{A7F46C40-769A-48FD-9C48-FAC5D5809B19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385315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72" name="103 Conector recto">
                  <a:extLst>
                    <a:ext uri="{FF2B5EF4-FFF2-40B4-BE49-F238E27FC236}">
                      <a16:creationId xmlns="" xmlns:a16="http://schemas.microsoft.com/office/drawing/2014/main" id="{495FF16F-73FC-4705-BD95-3833ABBC928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797372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173" name="Grupo 172">
                <a:extLst>
                  <a:ext uri="{FF2B5EF4-FFF2-40B4-BE49-F238E27FC236}">
                    <a16:creationId xmlns="" xmlns:a16="http://schemas.microsoft.com/office/drawing/2014/main" id="{331B6909-EA9D-44C9-A218-8FAA4F7F222C}"/>
                  </a:ext>
                </a:extLst>
              </p:cNvPr>
              <p:cNvGrpSpPr/>
              <p:nvPr/>
            </p:nvGrpSpPr>
            <p:grpSpPr>
              <a:xfrm>
                <a:off x="2185078" y="2999048"/>
                <a:ext cx="2179186" cy="223455"/>
                <a:chOff x="1475656" y="1003813"/>
                <a:chExt cx="2452010" cy="223455"/>
              </a:xfrm>
            </p:grpSpPr>
            <p:sp>
              <p:nvSpPr>
                <p:cNvPr id="174" name="104 CuadroTexto">
                  <a:extLst>
                    <a:ext uri="{FF2B5EF4-FFF2-40B4-BE49-F238E27FC236}">
                      <a16:creationId xmlns="" xmlns:a16="http://schemas.microsoft.com/office/drawing/2014/main" id="{118DF5BD-8DBC-4D40-830E-70E49C412C06}"/>
                    </a:ext>
                  </a:extLst>
                </p:cNvPr>
                <p:cNvSpPr txBox="1"/>
                <p:nvPr/>
              </p:nvSpPr>
              <p:spPr bwMode="auto">
                <a:xfrm>
                  <a:off x="1475656" y="1010782"/>
                  <a:ext cx="239219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0.3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75" name="105 CuadroTexto">
                  <a:extLst>
                    <a:ext uri="{FF2B5EF4-FFF2-40B4-BE49-F238E27FC236}">
                      <a16:creationId xmlns="" xmlns:a16="http://schemas.microsoft.com/office/drawing/2014/main" id="{028628CD-FEB5-4CD3-A3F0-688E61F087E8}"/>
                    </a:ext>
                  </a:extLst>
                </p:cNvPr>
                <p:cNvSpPr txBox="1"/>
                <p:nvPr/>
              </p:nvSpPr>
              <p:spPr bwMode="auto">
                <a:xfrm>
                  <a:off x="1906941" y="1011824"/>
                  <a:ext cx="180395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76" name="106 CuadroTexto">
                  <a:extLst>
                    <a:ext uri="{FF2B5EF4-FFF2-40B4-BE49-F238E27FC236}">
                      <a16:creationId xmlns="" xmlns:a16="http://schemas.microsoft.com/office/drawing/2014/main" id="{D09662CB-33AD-4E5E-93C5-D12FB05C8BBE}"/>
                    </a:ext>
                  </a:extLst>
                </p:cNvPr>
                <p:cNvSpPr txBox="1"/>
                <p:nvPr/>
              </p:nvSpPr>
              <p:spPr bwMode="auto">
                <a:xfrm>
                  <a:off x="2318259" y="1009129"/>
                  <a:ext cx="219611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77" name="107 CuadroTexto">
                  <a:extLst>
                    <a:ext uri="{FF2B5EF4-FFF2-40B4-BE49-F238E27FC236}">
                      <a16:creationId xmlns="" xmlns:a16="http://schemas.microsoft.com/office/drawing/2014/main" id="{F8D5C542-22C6-45E1-BE66-EBD4005C57E5}"/>
                    </a:ext>
                  </a:extLst>
                </p:cNvPr>
                <p:cNvSpPr txBox="1"/>
                <p:nvPr/>
              </p:nvSpPr>
              <p:spPr bwMode="auto">
                <a:xfrm>
                  <a:off x="2793018" y="1003814"/>
                  <a:ext cx="258827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78" name="108 CuadroTexto">
                  <a:extLst>
                    <a:ext uri="{FF2B5EF4-FFF2-40B4-BE49-F238E27FC236}">
                      <a16:creationId xmlns="" xmlns:a16="http://schemas.microsoft.com/office/drawing/2014/main" id="{B3ED50E6-A5F3-435D-ABEA-F2A275F3B1E9}"/>
                    </a:ext>
                  </a:extLst>
                </p:cNvPr>
                <p:cNvSpPr txBox="1"/>
                <p:nvPr/>
              </p:nvSpPr>
              <p:spPr bwMode="auto">
                <a:xfrm>
                  <a:off x="3189577" y="1003813"/>
                  <a:ext cx="298044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179" name="109 CuadroTexto">
                  <a:extLst>
                    <a:ext uri="{FF2B5EF4-FFF2-40B4-BE49-F238E27FC236}">
                      <a16:creationId xmlns="" xmlns:a16="http://schemas.microsoft.com/office/drawing/2014/main" id="{AB14F5A3-1903-4EA5-891F-2F29DB2692C3}"/>
                    </a:ext>
                  </a:extLst>
                </p:cNvPr>
                <p:cNvSpPr txBox="1"/>
                <p:nvPr/>
              </p:nvSpPr>
              <p:spPr bwMode="auto">
                <a:xfrm>
                  <a:off x="3590406" y="1003813"/>
                  <a:ext cx="337260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</p:grpSp>
          <p:grpSp>
            <p:nvGrpSpPr>
              <p:cNvPr id="180" name="116 Grupo">
                <a:extLst>
                  <a:ext uri="{FF2B5EF4-FFF2-40B4-BE49-F238E27FC236}">
                    <a16:creationId xmlns="" xmlns:a16="http://schemas.microsoft.com/office/drawing/2014/main" id="{E5E4D49D-4FF1-4681-A257-036487840089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229344" y="3347875"/>
                <a:ext cx="296441" cy="566523"/>
                <a:chOff x="184357" y="1862482"/>
                <a:chExt cx="488857" cy="566398"/>
              </a:xfrm>
            </p:grpSpPr>
            <p:sp>
              <p:nvSpPr>
                <p:cNvPr id="181" name="117 CuadroTexto">
                  <a:extLst>
                    <a:ext uri="{FF2B5EF4-FFF2-40B4-BE49-F238E27FC236}">
                      <a16:creationId xmlns="" xmlns:a16="http://schemas.microsoft.com/office/drawing/2014/main" id="{A7A91C81-0342-46F3-9342-AAE40C3EFDFB}"/>
                    </a:ext>
                  </a:extLst>
                </p:cNvPr>
                <p:cNvSpPr txBox="1"/>
                <p:nvPr/>
              </p:nvSpPr>
              <p:spPr>
                <a:xfrm rot="16200000">
                  <a:off x="121625" y="1939585"/>
                  <a:ext cx="458682" cy="304476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75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150 </a:t>
                  </a:r>
                  <a:r>
                    <a:rPr lang="es-ES" sz="750" kern="0" dirty="0" err="1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nA</a:t>
                  </a:r>
                  <a:endParaRPr lang="es-MX" sz="75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grpSp>
              <p:nvGrpSpPr>
                <p:cNvPr id="182" name="118 Grupo">
                  <a:extLst>
                    <a:ext uri="{FF2B5EF4-FFF2-40B4-BE49-F238E27FC236}">
                      <a16:creationId xmlns="" xmlns:a16="http://schemas.microsoft.com/office/drawing/2014/main" id="{8DE28EA4-13B9-43B6-896D-771C827E6DDF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84357" y="1971775"/>
                  <a:ext cx="488857" cy="457105"/>
                  <a:chOff x="204204" y="1975108"/>
                  <a:chExt cx="488857" cy="457105"/>
                </a:xfrm>
              </p:grpSpPr>
              <p:cxnSp>
                <p:nvCxnSpPr>
                  <p:cNvPr id="183" name="119 Conector recto">
                    <a:extLst>
                      <a:ext uri="{FF2B5EF4-FFF2-40B4-BE49-F238E27FC236}">
                        <a16:creationId xmlns="" xmlns:a16="http://schemas.microsoft.com/office/drawing/2014/main" id="{309AEB08-FB2A-4866-98E9-BE76B0A1BB7A}"/>
                      </a:ext>
                    </a:extLst>
                  </p:cNvPr>
                  <p:cNvCxnSpPr/>
                  <p:nvPr/>
                </p:nvCxnSpPr>
                <p:spPr>
                  <a:xfrm>
                    <a:off x="493589" y="1975108"/>
                    <a:ext cx="0" cy="2856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120 Conector recto">
                    <a:extLst>
                      <a:ext uri="{FF2B5EF4-FFF2-40B4-BE49-F238E27FC236}">
                        <a16:creationId xmlns="" xmlns:a16="http://schemas.microsoft.com/office/drawing/2014/main" id="{B3387048-AF61-43EE-BB1A-71A0D6B86EE5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7956" y="2254138"/>
                    <a:ext cx="385105" cy="0"/>
                  </a:xfrm>
                  <a:prstGeom prst="line">
                    <a:avLst/>
                  </a:prstGeom>
                  <a:noFill/>
                  <a:ln w="9525" algn="ctr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sp>
                <p:nvSpPr>
                  <p:cNvPr id="185" name="121 CuadroTexto">
                    <a:extLst>
                      <a:ext uri="{FF2B5EF4-FFF2-40B4-BE49-F238E27FC236}">
                        <a16:creationId xmlns="" xmlns:a16="http://schemas.microsoft.com/office/drawing/2014/main" id="{74326F8C-C972-4CED-8F37-0CDF816071FA}"/>
                      </a:ext>
                    </a:extLst>
                  </p:cNvPr>
                  <p:cNvSpPr txBox="1"/>
                  <p:nvPr/>
                </p:nvSpPr>
                <p:spPr>
                  <a:xfrm>
                    <a:off x="204204" y="2222707"/>
                    <a:ext cx="425423" cy="209506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s-ES" sz="800" kern="0" dirty="0">
                        <a:solidFill>
                          <a:sysClr val="windowText" lastClr="000000"/>
                        </a:solidFill>
                        <a:latin typeface="+mn-lt"/>
                        <a:cs typeface="Arial" pitchFamily="34" charset="0"/>
                      </a:rPr>
                      <a:t>4 min</a:t>
                    </a:r>
                    <a:endParaRPr lang="es-MX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547" name="AutoShape 200">
                <a:extLst>
                  <a:ext uri="{FF2B5EF4-FFF2-40B4-BE49-F238E27FC236}">
                    <a16:creationId xmlns="" xmlns:a16="http://schemas.microsoft.com/office/drawing/2014/main" id="{29AF0BDD-D733-4183-8F4C-567D0A53DCE8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722438" y="3395663"/>
                <a:ext cx="2732087" cy="3984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48" name="Freeform 202">
                <a:extLst>
                  <a:ext uri="{FF2B5EF4-FFF2-40B4-BE49-F238E27FC236}">
                    <a16:creationId xmlns="" xmlns:a16="http://schemas.microsoft.com/office/drawing/2014/main" id="{AD67F007-8E80-45FA-A3FE-ACAABF09D6F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31963" y="3414713"/>
                <a:ext cx="2713037" cy="427037"/>
              </a:xfrm>
              <a:custGeom>
                <a:avLst/>
                <a:gdLst>
                  <a:gd name="T0" fmla="*/ 0 w 571"/>
                  <a:gd name="T1" fmla="*/ 2 h 46"/>
                  <a:gd name="T2" fmla="*/ 5 w 571"/>
                  <a:gd name="T3" fmla="*/ 2 h 46"/>
                  <a:gd name="T4" fmla="*/ 11 w 571"/>
                  <a:gd name="T5" fmla="*/ 2 h 46"/>
                  <a:gd name="T6" fmla="*/ 18 w 571"/>
                  <a:gd name="T7" fmla="*/ 4 h 46"/>
                  <a:gd name="T8" fmla="*/ 26 w 571"/>
                  <a:gd name="T9" fmla="*/ 35 h 46"/>
                  <a:gd name="T10" fmla="*/ 31 w 571"/>
                  <a:gd name="T11" fmla="*/ 35 h 46"/>
                  <a:gd name="T12" fmla="*/ 46 w 571"/>
                  <a:gd name="T13" fmla="*/ 2 h 46"/>
                  <a:gd name="T14" fmla="*/ 55 w 571"/>
                  <a:gd name="T15" fmla="*/ 1 h 46"/>
                  <a:gd name="T16" fmla="*/ 77 w 571"/>
                  <a:gd name="T17" fmla="*/ 0 h 46"/>
                  <a:gd name="T18" fmla="*/ 103 w 571"/>
                  <a:gd name="T19" fmla="*/ 1 h 46"/>
                  <a:gd name="T20" fmla="*/ 107 w 571"/>
                  <a:gd name="T21" fmla="*/ 1 h 46"/>
                  <a:gd name="T22" fmla="*/ 117 w 571"/>
                  <a:gd name="T23" fmla="*/ 35 h 46"/>
                  <a:gd name="T24" fmla="*/ 121 w 571"/>
                  <a:gd name="T25" fmla="*/ 36 h 46"/>
                  <a:gd name="T26" fmla="*/ 125 w 571"/>
                  <a:gd name="T27" fmla="*/ 36 h 46"/>
                  <a:gd name="T28" fmla="*/ 127 w 571"/>
                  <a:gd name="T29" fmla="*/ 35 h 46"/>
                  <a:gd name="T30" fmla="*/ 133 w 571"/>
                  <a:gd name="T31" fmla="*/ 0 h 46"/>
                  <a:gd name="T32" fmla="*/ 175 w 571"/>
                  <a:gd name="T33" fmla="*/ 0 h 46"/>
                  <a:gd name="T34" fmla="*/ 179 w 571"/>
                  <a:gd name="T35" fmla="*/ 1 h 46"/>
                  <a:gd name="T36" fmla="*/ 182 w 571"/>
                  <a:gd name="T37" fmla="*/ 1 h 46"/>
                  <a:gd name="T38" fmla="*/ 198 w 571"/>
                  <a:gd name="T39" fmla="*/ 36 h 46"/>
                  <a:gd name="T40" fmla="*/ 202 w 571"/>
                  <a:gd name="T41" fmla="*/ 36 h 46"/>
                  <a:gd name="T42" fmla="*/ 208 w 571"/>
                  <a:gd name="T43" fmla="*/ 36 h 46"/>
                  <a:gd name="T44" fmla="*/ 218 w 571"/>
                  <a:gd name="T45" fmla="*/ 0 h 46"/>
                  <a:gd name="T46" fmla="*/ 248 w 571"/>
                  <a:gd name="T47" fmla="*/ 0 h 46"/>
                  <a:gd name="T48" fmla="*/ 260 w 571"/>
                  <a:gd name="T49" fmla="*/ 0 h 46"/>
                  <a:gd name="T50" fmla="*/ 262 w 571"/>
                  <a:gd name="T51" fmla="*/ 0 h 46"/>
                  <a:gd name="T52" fmla="*/ 277 w 571"/>
                  <a:gd name="T53" fmla="*/ 36 h 46"/>
                  <a:gd name="T54" fmla="*/ 280 w 571"/>
                  <a:gd name="T55" fmla="*/ 36 h 46"/>
                  <a:gd name="T56" fmla="*/ 285 w 571"/>
                  <a:gd name="T57" fmla="*/ 36 h 46"/>
                  <a:gd name="T58" fmla="*/ 288 w 571"/>
                  <a:gd name="T59" fmla="*/ 36 h 46"/>
                  <a:gd name="T60" fmla="*/ 290 w 571"/>
                  <a:gd name="T61" fmla="*/ 36 h 46"/>
                  <a:gd name="T62" fmla="*/ 305 w 571"/>
                  <a:gd name="T63" fmla="*/ 0 h 46"/>
                  <a:gd name="T64" fmla="*/ 310 w 571"/>
                  <a:gd name="T65" fmla="*/ 0 h 46"/>
                  <a:gd name="T66" fmla="*/ 346 w 571"/>
                  <a:gd name="T67" fmla="*/ 0 h 46"/>
                  <a:gd name="T68" fmla="*/ 350 w 571"/>
                  <a:gd name="T69" fmla="*/ 0 h 46"/>
                  <a:gd name="T70" fmla="*/ 352 w 571"/>
                  <a:gd name="T71" fmla="*/ 0 h 46"/>
                  <a:gd name="T72" fmla="*/ 361 w 571"/>
                  <a:gd name="T73" fmla="*/ 36 h 46"/>
                  <a:gd name="T74" fmla="*/ 365 w 571"/>
                  <a:gd name="T75" fmla="*/ 36 h 46"/>
                  <a:gd name="T76" fmla="*/ 368 w 571"/>
                  <a:gd name="T77" fmla="*/ 34 h 46"/>
                  <a:gd name="T78" fmla="*/ 372 w 571"/>
                  <a:gd name="T79" fmla="*/ 34 h 46"/>
                  <a:gd name="T80" fmla="*/ 379 w 571"/>
                  <a:gd name="T81" fmla="*/ 36 h 46"/>
                  <a:gd name="T82" fmla="*/ 389 w 571"/>
                  <a:gd name="T83" fmla="*/ 0 h 46"/>
                  <a:gd name="T84" fmla="*/ 431 w 571"/>
                  <a:gd name="T85" fmla="*/ 0 h 46"/>
                  <a:gd name="T86" fmla="*/ 432 w 571"/>
                  <a:gd name="T87" fmla="*/ 0 h 46"/>
                  <a:gd name="T88" fmla="*/ 439 w 571"/>
                  <a:gd name="T89" fmla="*/ 36 h 46"/>
                  <a:gd name="T90" fmla="*/ 448 w 571"/>
                  <a:gd name="T91" fmla="*/ 24 h 46"/>
                  <a:gd name="T92" fmla="*/ 454 w 571"/>
                  <a:gd name="T93" fmla="*/ 24 h 46"/>
                  <a:gd name="T94" fmla="*/ 461 w 571"/>
                  <a:gd name="T95" fmla="*/ 35 h 46"/>
                  <a:gd name="T96" fmla="*/ 466 w 571"/>
                  <a:gd name="T97" fmla="*/ 3 h 46"/>
                  <a:gd name="T98" fmla="*/ 475 w 571"/>
                  <a:gd name="T99" fmla="*/ 0 h 46"/>
                  <a:gd name="T100" fmla="*/ 484 w 571"/>
                  <a:gd name="T101" fmla="*/ 0 h 46"/>
                  <a:gd name="T102" fmla="*/ 495 w 571"/>
                  <a:gd name="T103" fmla="*/ 0 h 46"/>
                  <a:gd name="T104" fmla="*/ 510 w 571"/>
                  <a:gd name="T105" fmla="*/ 0 h 46"/>
                  <a:gd name="T106" fmla="*/ 516 w 571"/>
                  <a:gd name="T107" fmla="*/ 36 h 46"/>
                  <a:gd name="T108" fmla="*/ 525 w 571"/>
                  <a:gd name="T109" fmla="*/ 20 h 46"/>
                  <a:gd name="T110" fmla="*/ 530 w 571"/>
                  <a:gd name="T111" fmla="*/ 20 h 46"/>
                  <a:gd name="T112" fmla="*/ 539 w 571"/>
                  <a:gd name="T113" fmla="*/ 35 h 46"/>
                  <a:gd name="T114" fmla="*/ 550 w 571"/>
                  <a:gd name="T115" fmla="*/ 1 h 46"/>
                  <a:gd name="T116" fmla="*/ 563 w 571"/>
                  <a:gd name="T117" fmla="*/ 1 h 46"/>
                  <a:gd name="T118" fmla="*/ 571 w 571"/>
                  <a:gd name="T119" fmla="*/ 1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571" h="46">
                    <a:moveTo>
                      <a:pt x="0" y="2"/>
                    </a:moveTo>
                    <a:cubicBezTo>
                      <a:pt x="0" y="2"/>
                      <a:pt x="3" y="2"/>
                      <a:pt x="5" y="2"/>
                    </a:cubicBezTo>
                    <a:cubicBezTo>
                      <a:pt x="8" y="2"/>
                      <a:pt x="10" y="2"/>
                      <a:pt x="11" y="2"/>
                    </a:cubicBezTo>
                    <a:cubicBezTo>
                      <a:pt x="15" y="3"/>
                      <a:pt x="18" y="1"/>
                      <a:pt x="18" y="4"/>
                    </a:cubicBezTo>
                    <a:cubicBezTo>
                      <a:pt x="22" y="18"/>
                      <a:pt x="18" y="35"/>
                      <a:pt x="26" y="35"/>
                    </a:cubicBezTo>
                    <a:cubicBezTo>
                      <a:pt x="29" y="36"/>
                      <a:pt x="30" y="35"/>
                      <a:pt x="31" y="35"/>
                    </a:cubicBezTo>
                    <a:cubicBezTo>
                      <a:pt x="44" y="37"/>
                      <a:pt x="41" y="35"/>
                      <a:pt x="46" y="2"/>
                    </a:cubicBezTo>
                    <a:cubicBezTo>
                      <a:pt x="46" y="0"/>
                      <a:pt x="53" y="1"/>
                      <a:pt x="55" y="1"/>
                    </a:cubicBezTo>
                    <a:cubicBezTo>
                      <a:pt x="58" y="0"/>
                      <a:pt x="74" y="0"/>
                      <a:pt x="77" y="0"/>
                    </a:cubicBezTo>
                    <a:cubicBezTo>
                      <a:pt x="88" y="1"/>
                      <a:pt x="93" y="1"/>
                      <a:pt x="103" y="1"/>
                    </a:cubicBezTo>
                    <a:cubicBezTo>
                      <a:pt x="104" y="1"/>
                      <a:pt x="106" y="1"/>
                      <a:pt x="107" y="1"/>
                    </a:cubicBezTo>
                    <a:cubicBezTo>
                      <a:pt x="109" y="1"/>
                      <a:pt x="108" y="35"/>
                      <a:pt x="117" y="35"/>
                    </a:cubicBezTo>
                    <a:cubicBezTo>
                      <a:pt x="118" y="35"/>
                      <a:pt x="120" y="36"/>
                      <a:pt x="121" y="36"/>
                    </a:cubicBezTo>
                    <a:cubicBezTo>
                      <a:pt x="122" y="36"/>
                      <a:pt x="124" y="36"/>
                      <a:pt x="125" y="36"/>
                    </a:cubicBezTo>
                    <a:cubicBezTo>
                      <a:pt x="126" y="36"/>
                      <a:pt x="126" y="35"/>
                      <a:pt x="127" y="35"/>
                    </a:cubicBezTo>
                    <a:cubicBezTo>
                      <a:pt x="129" y="35"/>
                      <a:pt x="131" y="0"/>
                      <a:pt x="133" y="0"/>
                    </a:cubicBezTo>
                    <a:cubicBezTo>
                      <a:pt x="152" y="1"/>
                      <a:pt x="159" y="0"/>
                      <a:pt x="175" y="0"/>
                    </a:cubicBezTo>
                    <a:cubicBezTo>
                      <a:pt x="177" y="0"/>
                      <a:pt x="178" y="0"/>
                      <a:pt x="179" y="1"/>
                    </a:cubicBezTo>
                    <a:cubicBezTo>
                      <a:pt x="180" y="1"/>
                      <a:pt x="181" y="1"/>
                      <a:pt x="182" y="1"/>
                    </a:cubicBezTo>
                    <a:cubicBezTo>
                      <a:pt x="186" y="1"/>
                      <a:pt x="186" y="36"/>
                      <a:pt x="198" y="36"/>
                    </a:cubicBezTo>
                    <a:cubicBezTo>
                      <a:pt x="199" y="36"/>
                      <a:pt x="201" y="36"/>
                      <a:pt x="202" y="36"/>
                    </a:cubicBezTo>
                    <a:cubicBezTo>
                      <a:pt x="204" y="36"/>
                      <a:pt x="206" y="36"/>
                      <a:pt x="208" y="36"/>
                    </a:cubicBezTo>
                    <a:cubicBezTo>
                      <a:pt x="212" y="36"/>
                      <a:pt x="214" y="0"/>
                      <a:pt x="218" y="0"/>
                    </a:cubicBezTo>
                    <a:cubicBezTo>
                      <a:pt x="228" y="0"/>
                      <a:pt x="238" y="0"/>
                      <a:pt x="248" y="0"/>
                    </a:cubicBezTo>
                    <a:cubicBezTo>
                      <a:pt x="251" y="0"/>
                      <a:pt x="257" y="0"/>
                      <a:pt x="260" y="0"/>
                    </a:cubicBezTo>
                    <a:cubicBezTo>
                      <a:pt x="261" y="0"/>
                      <a:pt x="261" y="0"/>
                      <a:pt x="262" y="0"/>
                    </a:cubicBezTo>
                    <a:cubicBezTo>
                      <a:pt x="268" y="0"/>
                      <a:pt x="268" y="36"/>
                      <a:pt x="277" y="36"/>
                    </a:cubicBezTo>
                    <a:cubicBezTo>
                      <a:pt x="278" y="36"/>
                      <a:pt x="279" y="36"/>
                      <a:pt x="280" y="36"/>
                    </a:cubicBezTo>
                    <a:cubicBezTo>
                      <a:pt x="282" y="36"/>
                      <a:pt x="283" y="36"/>
                      <a:pt x="285" y="36"/>
                    </a:cubicBezTo>
                    <a:cubicBezTo>
                      <a:pt x="285" y="36"/>
                      <a:pt x="287" y="36"/>
                      <a:pt x="288" y="36"/>
                    </a:cubicBezTo>
                    <a:cubicBezTo>
                      <a:pt x="289" y="36"/>
                      <a:pt x="290" y="36"/>
                      <a:pt x="290" y="36"/>
                    </a:cubicBezTo>
                    <a:cubicBezTo>
                      <a:pt x="296" y="36"/>
                      <a:pt x="299" y="0"/>
                      <a:pt x="305" y="0"/>
                    </a:cubicBezTo>
                    <a:cubicBezTo>
                      <a:pt x="306" y="0"/>
                      <a:pt x="308" y="0"/>
                      <a:pt x="310" y="0"/>
                    </a:cubicBezTo>
                    <a:cubicBezTo>
                      <a:pt x="325" y="1"/>
                      <a:pt x="332" y="0"/>
                      <a:pt x="346" y="0"/>
                    </a:cubicBezTo>
                    <a:cubicBezTo>
                      <a:pt x="347" y="0"/>
                      <a:pt x="349" y="0"/>
                      <a:pt x="350" y="0"/>
                    </a:cubicBezTo>
                    <a:cubicBezTo>
                      <a:pt x="351" y="0"/>
                      <a:pt x="352" y="0"/>
                      <a:pt x="352" y="0"/>
                    </a:cubicBezTo>
                    <a:cubicBezTo>
                      <a:pt x="354" y="0"/>
                      <a:pt x="356" y="36"/>
                      <a:pt x="361" y="36"/>
                    </a:cubicBezTo>
                    <a:cubicBezTo>
                      <a:pt x="363" y="36"/>
                      <a:pt x="363" y="36"/>
                      <a:pt x="365" y="36"/>
                    </a:cubicBezTo>
                    <a:cubicBezTo>
                      <a:pt x="366" y="36"/>
                      <a:pt x="367" y="34"/>
                      <a:pt x="368" y="34"/>
                    </a:cubicBezTo>
                    <a:cubicBezTo>
                      <a:pt x="370" y="34"/>
                      <a:pt x="371" y="34"/>
                      <a:pt x="372" y="34"/>
                    </a:cubicBezTo>
                    <a:cubicBezTo>
                      <a:pt x="374" y="34"/>
                      <a:pt x="376" y="36"/>
                      <a:pt x="379" y="36"/>
                    </a:cubicBezTo>
                    <a:cubicBezTo>
                      <a:pt x="383" y="36"/>
                      <a:pt x="385" y="0"/>
                      <a:pt x="389" y="0"/>
                    </a:cubicBezTo>
                    <a:cubicBezTo>
                      <a:pt x="401" y="0"/>
                      <a:pt x="421" y="0"/>
                      <a:pt x="431" y="0"/>
                    </a:cubicBezTo>
                    <a:cubicBezTo>
                      <a:pt x="431" y="0"/>
                      <a:pt x="432" y="0"/>
                      <a:pt x="432" y="0"/>
                    </a:cubicBezTo>
                    <a:cubicBezTo>
                      <a:pt x="437" y="0"/>
                      <a:pt x="434" y="34"/>
                      <a:pt x="439" y="36"/>
                    </a:cubicBezTo>
                    <a:cubicBezTo>
                      <a:pt x="445" y="38"/>
                      <a:pt x="446" y="24"/>
                      <a:pt x="448" y="24"/>
                    </a:cubicBezTo>
                    <a:cubicBezTo>
                      <a:pt x="449" y="24"/>
                      <a:pt x="452" y="24"/>
                      <a:pt x="454" y="24"/>
                    </a:cubicBezTo>
                    <a:cubicBezTo>
                      <a:pt x="455" y="24"/>
                      <a:pt x="457" y="42"/>
                      <a:pt x="461" y="35"/>
                    </a:cubicBezTo>
                    <a:cubicBezTo>
                      <a:pt x="463" y="30"/>
                      <a:pt x="463" y="13"/>
                      <a:pt x="466" y="3"/>
                    </a:cubicBezTo>
                    <a:cubicBezTo>
                      <a:pt x="466" y="1"/>
                      <a:pt x="474" y="0"/>
                      <a:pt x="475" y="0"/>
                    </a:cubicBezTo>
                    <a:cubicBezTo>
                      <a:pt x="479" y="0"/>
                      <a:pt x="480" y="0"/>
                      <a:pt x="484" y="0"/>
                    </a:cubicBezTo>
                    <a:cubicBezTo>
                      <a:pt x="488" y="0"/>
                      <a:pt x="491" y="0"/>
                      <a:pt x="495" y="0"/>
                    </a:cubicBezTo>
                    <a:cubicBezTo>
                      <a:pt x="497" y="0"/>
                      <a:pt x="495" y="0"/>
                      <a:pt x="510" y="0"/>
                    </a:cubicBezTo>
                    <a:cubicBezTo>
                      <a:pt x="512" y="0"/>
                      <a:pt x="511" y="28"/>
                      <a:pt x="516" y="36"/>
                    </a:cubicBezTo>
                    <a:cubicBezTo>
                      <a:pt x="522" y="46"/>
                      <a:pt x="523" y="20"/>
                      <a:pt x="525" y="20"/>
                    </a:cubicBezTo>
                    <a:cubicBezTo>
                      <a:pt x="527" y="20"/>
                      <a:pt x="529" y="20"/>
                      <a:pt x="530" y="20"/>
                    </a:cubicBezTo>
                    <a:cubicBezTo>
                      <a:pt x="532" y="20"/>
                      <a:pt x="534" y="41"/>
                      <a:pt x="539" y="35"/>
                    </a:cubicBezTo>
                    <a:cubicBezTo>
                      <a:pt x="544" y="28"/>
                      <a:pt x="540" y="4"/>
                      <a:pt x="550" y="1"/>
                    </a:cubicBezTo>
                    <a:cubicBezTo>
                      <a:pt x="554" y="0"/>
                      <a:pt x="559" y="1"/>
                      <a:pt x="563" y="1"/>
                    </a:cubicBezTo>
                    <a:cubicBezTo>
                      <a:pt x="566" y="1"/>
                      <a:pt x="569" y="1"/>
                      <a:pt x="571" y="1"/>
                    </a:cubicBezTo>
                  </a:path>
                </a:pathLst>
              </a:custGeom>
              <a:noFill/>
              <a:ln w="9525">
                <a:solidFill>
                  <a:srgbClr val="24211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</p:grpSp>
        <p:grpSp>
          <p:nvGrpSpPr>
            <p:cNvPr id="2" name="1 Grupo"/>
            <p:cNvGrpSpPr/>
            <p:nvPr/>
          </p:nvGrpSpPr>
          <p:grpSpPr>
            <a:xfrm>
              <a:off x="973758" y="951328"/>
              <a:ext cx="3526805" cy="861871"/>
              <a:chOff x="973758" y="951328"/>
              <a:chExt cx="3526805" cy="861871"/>
            </a:xfrm>
          </p:grpSpPr>
          <p:grpSp>
            <p:nvGrpSpPr>
              <p:cNvPr id="122" name="Grupo 121">
                <a:extLst>
                  <a:ext uri="{FF2B5EF4-FFF2-40B4-BE49-F238E27FC236}">
                    <a16:creationId xmlns="" xmlns:a16="http://schemas.microsoft.com/office/drawing/2014/main" id="{87EE3A55-F554-4306-9B60-E3BA3D4DE71C}"/>
                  </a:ext>
                </a:extLst>
              </p:cNvPr>
              <p:cNvGrpSpPr/>
              <p:nvPr/>
            </p:nvGrpSpPr>
            <p:grpSpPr>
              <a:xfrm>
                <a:off x="2227718" y="1127498"/>
                <a:ext cx="2077601" cy="7648"/>
                <a:chOff x="1577958" y="1127498"/>
                <a:chExt cx="2337708" cy="7648"/>
              </a:xfrm>
            </p:grpSpPr>
            <p:cxnSp>
              <p:nvCxnSpPr>
                <p:cNvPr id="30" name="92 Conector recto">
                  <a:extLst>
                    <a:ext uri="{FF2B5EF4-FFF2-40B4-BE49-F238E27FC236}">
                      <a16:creationId xmlns="" xmlns:a16="http://schemas.microsoft.com/office/drawing/2014/main" id="{5D41AA56-3B91-430C-BC56-4A0BBCA7F1A3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77958" y="1135146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31" name="94 Conector recto">
                  <a:extLst>
                    <a:ext uri="{FF2B5EF4-FFF2-40B4-BE49-F238E27FC236}">
                      <a16:creationId xmlns="" xmlns:a16="http://schemas.microsoft.com/office/drawing/2014/main" id="{C998354D-35BE-4392-98F2-1E278392353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009231" y="1135146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32" name="100 Conector recto">
                  <a:extLst>
                    <a:ext uri="{FF2B5EF4-FFF2-40B4-BE49-F238E27FC236}">
                      <a16:creationId xmlns="" xmlns:a16="http://schemas.microsoft.com/office/drawing/2014/main" id="{AB907B8C-A42E-4C72-8FA7-63C4A4F08BFF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471070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33" name="101 Conector recto">
                  <a:extLst>
                    <a:ext uri="{FF2B5EF4-FFF2-40B4-BE49-F238E27FC236}">
                      <a16:creationId xmlns="" xmlns:a16="http://schemas.microsoft.com/office/drawing/2014/main" id="{04AD37BC-05B6-40AA-97C8-06051AD4E11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953267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34" name="102 Conector recto">
                  <a:extLst>
                    <a:ext uri="{FF2B5EF4-FFF2-40B4-BE49-F238E27FC236}">
                      <a16:creationId xmlns="" xmlns:a16="http://schemas.microsoft.com/office/drawing/2014/main" id="{3FE4AC34-AE39-4247-B095-FA0C52120EA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385315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35" name="103 Conector recto">
                  <a:extLst>
                    <a:ext uri="{FF2B5EF4-FFF2-40B4-BE49-F238E27FC236}">
                      <a16:creationId xmlns="" xmlns:a16="http://schemas.microsoft.com/office/drawing/2014/main" id="{DAE3D0F2-BCFE-4DC8-BF15-54949DCF346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820117" y="1127498"/>
                  <a:ext cx="95549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grpSp>
            <p:nvGrpSpPr>
              <p:cNvPr id="121" name="Grupo 120">
                <a:extLst>
                  <a:ext uri="{FF2B5EF4-FFF2-40B4-BE49-F238E27FC236}">
                    <a16:creationId xmlns="" xmlns:a16="http://schemas.microsoft.com/office/drawing/2014/main" id="{2FE2B0DA-FB68-4044-B185-9555F2553C98}"/>
                  </a:ext>
                </a:extLst>
              </p:cNvPr>
              <p:cNvGrpSpPr/>
              <p:nvPr/>
            </p:nvGrpSpPr>
            <p:grpSpPr>
              <a:xfrm>
                <a:off x="2136798" y="951328"/>
                <a:ext cx="2219614" cy="223455"/>
                <a:chOff x="1475656" y="1003813"/>
                <a:chExt cx="2497500" cy="223455"/>
              </a:xfrm>
            </p:grpSpPr>
            <p:sp>
              <p:nvSpPr>
                <p:cNvPr id="24" name="104 CuadroTexto">
                  <a:extLst>
                    <a:ext uri="{FF2B5EF4-FFF2-40B4-BE49-F238E27FC236}">
                      <a16:creationId xmlns="" xmlns:a16="http://schemas.microsoft.com/office/drawing/2014/main" id="{C326CDFD-3F66-4DA8-87F5-61A9B7D01552}"/>
                    </a:ext>
                  </a:extLst>
                </p:cNvPr>
                <p:cNvSpPr txBox="1"/>
                <p:nvPr/>
              </p:nvSpPr>
              <p:spPr bwMode="auto">
                <a:xfrm>
                  <a:off x="1475656" y="1010782"/>
                  <a:ext cx="239219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0.3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25" name="105 CuadroTexto">
                  <a:extLst>
                    <a:ext uri="{FF2B5EF4-FFF2-40B4-BE49-F238E27FC236}">
                      <a16:creationId xmlns="" xmlns:a16="http://schemas.microsoft.com/office/drawing/2014/main" id="{88E9375C-5989-42E8-80E8-18D6775A0D8F}"/>
                    </a:ext>
                  </a:extLst>
                </p:cNvPr>
                <p:cNvSpPr txBox="1"/>
                <p:nvPr/>
              </p:nvSpPr>
              <p:spPr bwMode="auto">
                <a:xfrm>
                  <a:off x="1943333" y="1011824"/>
                  <a:ext cx="180395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26" name="106 CuadroTexto">
                  <a:extLst>
                    <a:ext uri="{FF2B5EF4-FFF2-40B4-BE49-F238E27FC236}">
                      <a16:creationId xmlns="" xmlns:a16="http://schemas.microsoft.com/office/drawing/2014/main" id="{CEB2F9E3-51F8-4322-B9A2-04EF5768662E}"/>
                    </a:ext>
                  </a:extLst>
                </p:cNvPr>
                <p:cNvSpPr txBox="1"/>
                <p:nvPr/>
              </p:nvSpPr>
              <p:spPr bwMode="auto">
                <a:xfrm>
                  <a:off x="2367584" y="1009129"/>
                  <a:ext cx="219611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27" name="107 CuadroTexto">
                  <a:extLst>
                    <a:ext uri="{FF2B5EF4-FFF2-40B4-BE49-F238E27FC236}">
                      <a16:creationId xmlns="" xmlns:a16="http://schemas.microsoft.com/office/drawing/2014/main" id="{30EBB6F1-1924-4E28-BF14-BC9B3167C7D3}"/>
                    </a:ext>
                  </a:extLst>
                </p:cNvPr>
                <p:cNvSpPr txBox="1"/>
                <p:nvPr/>
              </p:nvSpPr>
              <p:spPr bwMode="auto">
                <a:xfrm>
                  <a:off x="2824861" y="1003814"/>
                  <a:ext cx="258827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28" name="108 CuadroTexto">
                  <a:extLst>
                    <a:ext uri="{FF2B5EF4-FFF2-40B4-BE49-F238E27FC236}">
                      <a16:creationId xmlns="" xmlns:a16="http://schemas.microsoft.com/office/drawing/2014/main" id="{6E437A4E-EE1E-4038-9FD4-3CBE69E57F62}"/>
                    </a:ext>
                  </a:extLst>
                </p:cNvPr>
                <p:cNvSpPr txBox="1"/>
                <p:nvPr/>
              </p:nvSpPr>
              <p:spPr bwMode="auto">
                <a:xfrm>
                  <a:off x="3245964" y="1003813"/>
                  <a:ext cx="298044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29" name="109 CuadroTexto">
                  <a:extLst>
                    <a:ext uri="{FF2B5EF4-FFF2-40B4-BE49-F238E27FC236}">
                      <a16:creationId xmlns="" xmlns:a16="http://schemas.microsoft.com/office/drawing/2014/main" id="{BA720E0E-2220-4CD6-A124-A9C324219D06}"/>
                    </a:ext>
                  </a:extLst>
                </p:cNvPr>
                <p:cNvSpPr txBox="1"/>
                <p:nvPr/>
              </p:nvSpPr>
              <p:spPr bwMode="auto">
                <a:xfrm>
                  <a:off x="3635896" y="1003813"/>
                  <a:ext cx="337260" cy="21544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30000</a:t>
                  </a:r>
                  <a:endParaRPr lang="es-MX" sz="8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</p:grpSp>
          <p:grpSp>
            <p:nvGrpSpPr>
              <p:cNvPr id="15" name="3132 Grupo">
                <a:extLst>
                  <a:ext uri="{FF2B5EF4-FFF2-40B4-BE49-F238E27FC236}">
                    <a16:creationId xmlns="" xmlns:a16="http://schemas.microsoft.com/office/drawing/2014/main" id="{7FD3B844-9DE8-4D31-8B8D-FAA30F15A61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973758" y="956311"/>
                <a:ext cx="871251" cy="353180"/>
                <a:chOff x="-928248" y="1129608"/>
                <a:chExt cx="1436782" cy="353105"/>
              </a:xfrm>
            </p:grpSpPr>
            <p:sp>
              <p:nvSpPr>
                <p:cNvPr id="22" name="110 CuadroTexto">
                  <a:extLst>
                    <a:ext uri="{FF2B5EF4-FFF2-40B4-BE49-F238E27FC236}">
                      <a16:creationId xmlns="" xmlns:a16="http://schemas.microsoft.com/office/drawing/2014/main" id="{980534F9-9DB2-4008-8CA0-46728BDD0CD7}"/>
                    </a:ext>
                  </a:extLst>
                </p:cNvPr>
                <p:cNvSpPr txBox="1"/>
                <p:nvPr/>
              </p:nvSpPr>
              <p:spPr>
                <a:xfrm>
                  <a:off x="-928248" y="1270077"/>
                  <a:ext cx="1436782" cy="212636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900" kern="0" dirty="0" err="1" smtClean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Hypo</a:t>
                  </a:r>
                  <a:r>
                    <a:rPr lang="es-ES" sz="900" kern="0" dirty="0" smtClean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 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(30 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cs typeface="Arial" pitchFamily="34" charset="0"/>
                    </a:rPr>
                    <a:t>µ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M)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sp>
              <p:nvSpPr>
                <p:cNvPr id="23" name="111 CuadroTexto">
                  <a:extLst>
                    <a:ext uri="{FF2B5EF4-FFF2-40B4-BE49-F238E27FC236}">
                      <a16:creationId xmlns="" xmlns:a16="http://schemas.microsoft.com/office/drawing/2014/main" id="{6F26A61A-48A3-49F8-9D83-026F2FA21EF0}"/>
                    </a:ext>
                  </a:extLst>
                </p:cNvPr>
                <p:cNvSpPr txBox="1"/>
                <p:nvPr/>
              </p:nvSpPr>
              <p:spPr>
                <a:xfrm>
                  <a:off x="-915189" y="1129608"/>
                  <a:ext cx="1222150" cy="230783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9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Homo    (</a:t>
                  </a:r>
                  <a:r>
                    <a:rPr lang="es-ES" sz="900" kern="0" dirty="0">
                      <a:solidFill>
                        <a:sysClr val="windowText" lastClr="000000"/>
                      </a:solidFill>
                      <a:cs typeface="Arial" pitchFamily="34" charset="0"/>
                    </a:rPr>
                    <a:t>µM)</a:t>
                  </a:r>
                  <a:endParaRPr lang="es-MX" sz="90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</p:grpSp>
          <p:grpSp>
            <p:nvGrpSpPr>
              <p:cNvPr id="16" name="116 Grupo">
                <a:extLst>
                  <a:ext uri="{FF2B5EF4-FFF2-40B4-BE49-F238E27FC236}">
                    <a16:creationId xmlns="" xmlns:a16="http://schemas.microsoft.com/office/drawing/2014/main" id="{65598958-6AC6-463B-A145-0CADB2EFEAB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208710" y="1246676"/>
                <a:ext cx="296441" cy="566523"/>
                <a:chOff x="184357" y="1862482"/>
                <a:chExt cx="488857" cy="566398"/>
              </a:xfrm>
            </p:grpSpPr>
            <p:sp>
              <p:nvSpPr>
                <p:cNvPr id="17" name="117 CuadroTexto">
                  <a:extLst>
                    <a:ext uri="{FF2B5EF4-FFF2-40B4-BE49-F238E27FC236}">
                      <a16:creationId xmlns="" xmlns:a16="http://schemas.microsoft.com/office/drawing/2014/main" id="{FB09104F-79B8-4927-83FF-91B70B2FCC02}"/>
                    </a:ext>
                  </a:extLst>
                </p:cNvPr>
                <p:cNvSpPr txBox="1"/>
                <p:nvPr/>
              </p:nvSpPr>
              <p:spPr>
                <a:xfrm rot="16200000">
                  <a:off x="115401" y="1939585"/>
                  <a:ext cx="458682" cy="304476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s-ES" sz="75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150 </a:t>
                  </a:r>
                  <a:r>
                    <a:rPr lang="es-ES" sz="750" kern="0" dirty="0" err="1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rPr>
                    <a:t>nA</a:t>
                  </a:r>
                  <a:endParaRPr lang="es-MX" sz="750" kern="0" dirty="0">
                    <a:solidFill>
                      <a:sysClr val="windowText" lastClr="000000"/>
                    </a:solidFill>
                    <a:latin typeface="+mn-lt"/>
                    <a:cs typeface="Arial" pitchFamily="34" charset="0"/>
                  </a:endParaRPr>
                </a:p>
              </p:txBody>
            </p:sp>
            <p:grpSp>
              <p:nvGrpSpPr>
                <p:cNvPr id="18" name="118 Grupo">
                  <a:extLst>
                    <a:ext uri="{FF2B5EF4-FFF2-40B4-BE49-F238E27FC236}">
                      <a16:creationId xmlns="" xmlns:a16="http://schemas.microsoft.com/office/drawing/2014/main" id="{E8F5721D-6497-49BE-A1DB-201029698F31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84357" y="1971775"/>
                  <a:ext cx="488857" cy="457105"/>
                  <a:chOff x="204204" y="1975108"/>
                  <a:chExt cx="488857" cy="457105"/>
                </a:xfrm>
              </p:grpSpPr>
              <p:cxnSp>
                <p:nvCxnSpPr>
                  <p:cNvPr id="19" name="119 Conector recto">
                    <a:extLst>
                      <a:ext uri="{FF2B5EF4-FFF2-40B4-BE49-F238E27FC236}">
                        <a16:creationId xmlns="" xmlns:a16="http://schemas.microsoft.com/office/drawing/2014/main" id="{B95FFD48-3CF8-4B9C-B4B3-D8CFA1625370}"/>
                      </a:ext>
                    </a:extLst>
                  </p:cNvPr>
                  <p:cNvCxnSpPr/>
                  <p:nvPr/>
                </p:nvCxnSpPr>
                <p:spPr>
                  <a:xfrm>
                    <a:off x="493589" y="1975108"/>
                    <a:ext cx="0" cy="2856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120 Conector recto">
                    <a:extLst>
                      <a:ext uri="{FF2B5EF4-FFF2-40B4-BE49-F238E27FC236}">
                        <a16:creationId xmlns="" xmlns:a16="http://schemas.microsoft.com/office/drawing/2014/main" id="{1FF2AF14-6FB1-4931-BBFB-BD41EE84F9DE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7956" y="2254138"/>
                    <a:ext cx="385105" cy="0"/>
                  </a:xfrm>
                  <a:prstGeom prst="line">
                    <a:avLst/>
                  </a:prstGeom>
                  <a:noFill/>
                  <a:ln w="9525" algn="ctr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sp>
                <p:nvSpPr>
                  <p:cNvPr id="21" name="121 CuadroTexto">
                    <a:extLst>
                      <a:ext uri="{FF2B5EF4-FFF2-40B4-BE49-F238E27FC236}">
                        <a16:creationId xmlns="" xmlns:a16="http://schemas.microsoft.com/office/drawing/2014/main" id="{C9C45156-43BB-4D79-AB2F-05AA252D2764}"/>
                      </a:ext>
                    </a:extLst>
                  </p:cNvPr>
                  <p:cNvSpPr txBox="1"/>
                  <p:nvPr/>
                </p:nvSpPr>
                <p:spPr>
                  <a:xfrm>
                    <a:off x="204204" y="2222707"/>
                    <a:ext cx="425423" cy="209506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s-ES" sz="800" kern="0" dirty="0">
                        <a:solidFill>
                          <a:sysClr val="windowText" lastClr="000000"/>
                        </a:solidFill>
                        <a:latin typeface="+mn-lt"/>
                        <a:cs typeface="Arial" pitchFamily="34" charset="0"/>
                      </a:rPr>
                      <a:t>4 min</a:t>
                    </a:r>
                    <a:endParaRPr lang="es-MX" sz="800" kern="0" dirty="0">
                      <a:solidFill>
                        <a:sysClr val="windowText" lastClr="000000"/>
                      </a:solidFill>
                      <a:latin typeface="+mn-lt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128" name="Grupo 127">
                <a:extLst>
                  <a:ext uri="{FF2B5EF4-FFF2-40B4-BE49-F238E27FC236}">
                    <a16:creationId xmlns="" xmlns:a16="http://schemas.microsoft.com/office/drawing/2014/main" id="{D6219836-9DF7-49BA-B645-BF71A32771EF}"/>
                  </a:ext>
                </a:extLst>
              </p:cNvPr>
              <p:cNvGrpSpPr/>
              <p:nvPr/>
            </p:nvGrpSpPr>
            <p:grpSpPr>
              <a:xfrm>
                <a:off x="1769510" y="1268760"/>
                <a:ext cx="2565214" cy="0"/>
                <a:chOff x="1062385" y="1268760"/>
                <a:chExt cx="2886367" cy="0"/>
              </a:xfrm>
            </p:grpSpPr>
            <p:cxnSp>
              <p:nvCxnSpPr>
                <p:cNvPr id="36" name="91 Conector recto">
                  <a:extLst>
                    <a:ext uri="{FF2B5EF4-FFF2-40B4-BE49-F238E27FC236}">
                      <a16:creationId xmlns="" xmlns:a16="http://schemas.microsoft.com/office/drawing/2014/main" id="{2FE19E65-E440-4715-B41E-8DD11D24466E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62385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15" name="91 Conector recto">
                  <a:extLst>
                    <a:ext uri="{FF2B5EF4-FFF2-40B4-BE49-F238E27FC236}">
                      <a16:creationId xmlns="" xmlns:a16="http://schemas.microsoft.com/office/drawing/2014/main" id="{7EFE73DB-690B-4B71-986A-4B33D174C480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547680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16" name="91 Conector recto">
                  <a:extLst>
                    <a:ext uri="{FF2B5EF4-FFF2-40B4-BE49-F238E27FC236}">
                      <a16:creationId xmlns="" xmlns:a16="http://schemas.microsoft.com/office/drawing/2014/main" id="{FD6B7F6C-85AE-4296-8CB9-BF2B7F77EF52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979712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17" name="91 Conector recto">
                  <a:extLst>
                    <a:ext uri="{FF2B5EF4-FFF2-40B4-BE49-F238E27FC236}">
                      <a16:creationId xmlns="" xmlns:a16="http://schemas.microsoft.com/office/drawing/2014/main" id="{E401AB47-2614-4A2B-8C5A-0D72ED0D88CA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423672" y="1268760"/>
                  <a:ext cx="1692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18" name="91 Conector recto">
                  <a:extLst>
                    <a:ext uri="{FF2B5EF4-FFF2-40B4-BE49-F238E27FC236}">
                      <a16:creationId xmlns="" xmlns:a16="http://schemas.microsoft.com/office/drawing/2014/main" id="{EE4BD7FC-C309-45F7-9781-05A1CB986301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2915832" y="1268760"/>
                  <a:ext cx="144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19" name="91 Conector recto">
                  <a:extLst>
                    <a:ext uri="{FF2B5EF4-FFF2-40B4-BE49-F238E27FC236}">
                      <a16:creationId xmlns="" xmlns:a16="http://schemas.microsoft.com/office/drawing/2014/main" id="{E4686BDA-A90B-4286-8E12-201669B0641C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347864" y="1268760"/>
                  <a:ext cx="1620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20" name="91 Conector recto">
                  <a:extLst>
                    <a:ext uri="{FF2B5EF4-FFF2-40B4-BE49-F238E27FC236}">
                      <a16:creationId xmlns="" xmlns:a16="http://schemas.microsoft.com/office/drawing/2014/main" id="{285EF537-7EB3-49AD-960C-8F64D90EB56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3775952" y="1268760"/>
                  <a:ext cx="172800" cy="0"/>
                </a:xfrm>
                <a:prstGeom prst="line">
                  <a:avLst/>
                </a:prstGeom>
                <a:noFill/>
                <a:ln w="12700" algn="ctr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sp>
            <p:nvSpPr>
              <p:cNvPr id="550" name="AutoShape 204">
                <a:extLst>
                  <a:ext uri="{FF2B5EF4-FFF2-40B4-BE49-F238E27FC236}">
                    <a16:creationId xmlns="" xmlns:a16="http://schemas.microsoft.com/office/drawing/2014/main" id="{6B208754-0EEF-4D37-8A9F-0A62966CBB70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681163" y="1312863"/>
                <a:ext cx="2819400" cy="1635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  <p:sp>
            <p:nvSpPr>
              <p:cNvPr id="551" name="Freeform 206">
                <a:extLst>
                  <a:ext uri="{FF2B5EF4-FFF2-40B4-BE49-F238E27FC236}">
                    <a16:creationId xmlns="" xmlns:a16="http://schemas.microsoft.com/office/drawing/2014/main" id="{FEA9EFFF-FC68-4028-8430-39A02475EF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0688" y="1331913"/>
                <a:ext cx="2798763" cy="117475"/>
              </a:xfrm>
              <a:custGeom>
                <a:avLst/>
                <a:gdLst>
                  <a:gd name="T0" fmla="*/ 5 w 571"/>
                  <a:gd name="T1" fmla="*/ 1 h 12"/>
                  <a:gd name="T2" fmla="*/ 18 w 571"/>
                  <a:gd name="T3" fmla="*/ 1 h 12"/>
                  <a:gd name="T4" fmla="*/ 26 w 571"/>
                  <a:gd name="T5" fmla="*/ 12 h 12"/>
                  <a:gd name="T6" fmla="*/ 41 w 571"/>
                  <a:gd name="T7" fmla="*/ 12 h 12"/>
                  <a:gd name="T8" fmla="*/ 55 w 571"/>
                  <a:gd name="T9" fmla="*/ 0 h 12"/>
                  <a:gd name="T10" fmla="*/ 103 w 571"/>
                  <a:gd name="T11" fmla="*/ 0 h 12"/>
                  <a:gd name="T12" fmla="*/ 112 w 571"/>
                  <a:gd name="T13" fmla="*/ 12 h 12"/>
                  <a:gd name="T14" fmla="*/ 121 w 571"/>
                  <a:gd name="T15" fmla="*/ 12 h 12"/>
                  <a:gd name="T16" fmla="*/ 127 w 571"/>
                  <a:gd name="T17" fmla="*/ 12 h 12"/>
                  <a:gd name="T18" fmla="*/ 175 w 571"/>
                  <a:gd name="T19" fmla="*/ 0 h 12"/>
                  <a:gd name="T20" fmla="*/ 182 w 571"/>
                  <a:gd name="T21" fmla="*/ 0 h 12"/>
                  <a:gd name="T22" fmla="*/ 198 w 571"/>
                  <a:gd name="T23" fmla="*/ 12 h 12"/>
                  <a:gd name="T24" fmla="*/ 208 w 571"/>
                  <a:gd name="T25" fmla="*/ 12 h 12"/>
                  <a:gd name="T26" fmla="*/ 248 w 571"/>
                  <a:gd name="T27" fmla="*/ 0 h 12"/>
                  <a:gd name="T28" fmla="*/ 262 w 571"/>
                  <a:gd name="T29" fmla="*/ 0 h 12"/>
                  <a:gd name="T30" fmla="*/ 277 w 571"/>
                  <a:gd name="T31" fmla="*/ 12 h 12"/>
                  <a:gd name="T32" fmla="*/ 284 w 571"/>
                  <a:gd name="T33" fmla="*/ 11 h 12"/>
                  <a:gd name="T34" fmla="*/ 290 w 571"/>
                  <a:gd name="T35" fmla="*/ 12 h 12"/>
                  <a:gd name="T36" fmla="*/ 310 w 571"/>
                  <a:gd name="T37" fmla="*/ 0 h 12"/>
                  <a:gd name="T38" fmla="*/ 350 w 571"/>
                  <a:gd name="T39" fmla="*/ 0 h 12"/>
                  <a:gd name="T40" fmla="*/ 361 w 571"/>
                  <a:gd name="T41" fmla="*/ 12 h 12"/>
                  <a:gd name="T42" fmla="*/ 368 w 571"/>
                  <a:gd name="T43" fmla="*/ 7 h 12"/>
                  <a:gd name="T44" fmla="*/ 377 w 571"/>
                  <a:gd name="T45" fmla="*/ 12 h 12"/>
                  <a:gd name="T46" fmla="*/ 389 w 571"/>
                  <a:gd name="T47" fmla="*/ 0 h 12"/>
                  <a:gd name="T48" fmla="*/ 432 w 571"/>
                  <a:gd name="T49" fmla="*/ 0 h 12"/>
                  <a:gd name="T50" fmla="*/ 444 w 571"/>
                  <a:gd name="T51" fmla="*/ 12 h 12"/>
                  <a:gd name="T52" fmla="*/ 452 w 571"/>
                  <a:gd name="T53" fmla="*/ 5 h 12"/>
                  <a:gd name="T54" fmla="*/ 461 w 571"/>
                  <a:gd name="T55" fmla="*/ 12 h 12"/>
                  <a:gd name="T56" fmla="*/ 475 w 571"/>
                  <a:gd name="T57" fmla="*/ 0 h 12"/>
                  <a:gd name="T58" fmla="*/ 495 w 571"/>
                  <a:gd name="T59" fmla="*/ 0 h 12"/>
                  <a:gd name="T60" fmla="*/ 517 w 571"/>
                  <a:gd name="T61" fmla="*/ 12 h 12"/>
                  <a:gd name="T62" fmla="*/ 526 w 571"/>
                  <a:gd name="T63" fmla="*/ 2 h 12"/>
                  <a:gd name="T64" fmla="*/ 535 w 571"/>
                  <a:gd name="T65" fmla="*/ 12 h 12"/>
                  <a:gd name="T66" fmla="*/ 550 w 571"/>
                  <a:gd name="T67" fmla="*/ 0 h 12"/>
                  <a:gd name="T68" fmla="*/ 571 w 571"/>
                  <a:gd name="T69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571" h="12">
                    <a:moveTo>
                      <a:pt x="0" y="0"/>
                    </a:moveTo>
                    <a:cubicBezTo>
                      <a:pt x="0" y="0"/>
                      <a:pt x="3" y="0"/>
                      <a:pt x="5" y="1"/>
                    </a:cubicBezTo>
                    <a:cubicBezTo>
                      <a:pt x="8" y="1"/>
                      <a:pt x="10" y="1"/>
                      <a:pt x="11" y="1"/>
                    </a:cubicBezTo>
                    <a:cubicBezTo>
                      <a:pt x="15" y="1"/>
                      <a:pt x="18" y="0"/>
                      <a:pt x="18" y="1"/>
                    </a:cubicBezTo>
                    <a:cubicBezTo>
                      <a:pt x="20" y="3"/>
                      <a:pt x="19" y="5"/>
                      <a:pt x="22" y="12"/>
                    </a:cubicBezTo>
                    <a:cubicBezTo>
                      <a:pt x="23" y="12"/>
                      <a:pt x="26" y="12"/>
                      <a:pt x="26" y="12"/>
                    </a:cubicBezTo>
                    <a:cubicBezTo>
                      <a:pt x="29" y="12"/>
                      <a:pt x="30" y="12"/>
                      <a:pt x="31" y="12"/>
                    </a:cubicBezTo>
                    <a:cubicBezTo>
                      <a:pt x="35" y="12"/>
                      <a:pt x="38" y="12"/>
                      <a:pt x="41" y="12"/>
                    </a:cubicBezTo>
                    <a:cubicBezTo>
                      <a:pt x="44" y="12"/>
                      <a:pt x="45" y="3"/>
                      <a:pt x="46" y="1"/>
                    </a:cubicBezTo>
                    <a:cubicBezTo>
                      <a:pt x="46" y="0"/>
                      <a:pt x="53" y="0"/>
                      <a:pt x="55" y="0"/>
                    </a:cubicBezTo>
                    <a:cubicBezTo>
                      <a:pt x="58" y="0"/>
                      <a:pt x="74" y="0"/>
                      <a:pt x="77" y="0"/>
                    </a:cubicBezTo>
                    <a:cubicBezTo>
                      <a:pt x="88" y="0"/>
                      <a:pt x="93" y="0"/>
                      <a:pt x="103" y="0"/>
                    </a:cubicBezTo>
                    <a:cubicBezTo>
                      <a:pt x="104" y="0"/>
                      <a:pt x="106" y="0"/>
                      <a:pt x="107" y="0"/>
                    </a:cubicBezTo>
                    <a:cubicBezTo>
                      <a:pt x="108" y="0"/>
                      <a:pt x="110" y="12"/>
                      <a:pt x="112" y="12"/>
                    </a:cubicBezTo>
                    <a:cubicBezTo>
                      <a:pt x="113" y="12"/>
                      <a:pt x="116" y="12"/>
                      <a:pt x="117" y="12"/>
                    </a:cubicBezTo>
                    <a:cubicBezTo>
                      <a:pt x="118" y="12"/>
                      <a:pt x="120" y="12"/>
                      <a:pt x="121" y="12"/>
                    </a:cubicBezTo>
                    <a:cubicBezTo>
                      <a:pt x="122" y="12"/>
                      <a:pt x="124" y="12"/>
                      <a:pt x="125" y="12"/>
                    </a:cubicBezTo>
                    <a:cubicBezTo>
                      <a:pt x="126" y="12"/>
                      <a:pt x="126" y="12"/>
                      <a:pt x="127" y="12"/>
                    </a:cubicBezTo>
                    <a:cubicBezTo>
                      <a:pt x="129" y="12"/>
                      <a:pt x="131" y="0"/>
                      <a:pt x="133" y="0"/>
                    </a:cubicBezTo>
                    <a:cubicBezTo>
                      <a:pt x="152" y="0"/>
                      <a:pt x="159" y="0"/>
                      <a:pt x="175" y="0"/>
                    </a:cubicBezTo>
                    <a:cubicBezTo>
                      <a:pt x="177" y="0"/>
                      <a:pt x="178" y="0"/>
                      <a:pt x="179" y="0"/>
                    </a:cubicBezTo>
                    <a:cubicBezTo>
                      <a:pt x="180" y="0"/>
                      <a:pt x="181" y="0"/>
                      <a:pt x="182" y="0"/>
                    </a:cubicBezTo>
                    <a:cubicBezTo>
                      <a:pt x="185" y="0"/>
                      <a:pt x="187" y="12"/>
                      <a:pt x="190" y="12"/>
                    </a:cubicBezTo>
                    <a:cubicBezTo>
                      <a:pt x="192" y="12"/>
                      <a:pt x="196" y="12"/>
                      <a:pt x="198" y="12"/>
                    </a:cubicBezTo>
                    <a:cubicBezTo>
                      <a:pt x="199" y="12"/>
                      <a:pt x="201" y="12"/>
                      <a:pt x="202" y="12"/>
                    </a:cubicBezTo>
                    <a:cubicBezTo>
                      <a:pt x="204" y="12"/>
                      <a:pt x="206" y="12"/>
                      <a:pt x="208" y="12"/>
                    </a:cubicBezTo>
                    <a:cubicBezTo>
                      <a:pt x="212" y="12"/>
                      <a:pt x="214" y="0"/>
                      <a:pt x="218" y="0"/>
                    </a:cubicBezTo>
                    <a:cubicBezTo>
                      <a:pt x="228" y="0"/>
                      <a:pt x="238" y="0"/>
                      <a:pt x="248" y="0"/>
                    </a:cubicBezTo>
                    <a:cubicBezTo>
                      <a:pt x="251" y="0"/>
                      <a:pt x="257" y="0"/>
                      <a:pt x="260" y="0"/>
                    </a:cubicBezTo>
                    <a:cubicBezTo>
                      <a:pt x="261" y="0"/>
                      <a:pt x="261" y="0"/>
                      <a:pt x="262" y="0"/>
                    </a:cubicBezTo>
                    <a:cubicBezTo>
                      <a:pt x="268" y="0"/>
                      <a:pt x="268" y="12"/>
                      <a:pt x="273" y="12"/>
                    </a:cubicBezTo>
                    <a:cubicBezTo>
                      <a:pt x="274" y="12"/>
                      <a:pt x="276" y="12"/>
                      <a:pt x="277" y="12"/>
                    </a:cubicBezTo>
                    <a:cubicBezTo>
                      <a:pt x="278" y="12"/>
                      <a:pt x="279" y="10"/>
                      <a:pt x="280" y="11"/>
                    </a:cubicBezTo>
                    <a:cubicBezTo>
                      <a:pt x="282" y="11"/>
                      <a:pt x="283" y="11"/>
                      <a:pt x="284" y="11"/>
                    </a:cubicBezTo>
                    <a:cubicBezTo>
                      <a:pt x="285" y="11"/>
                      <a:pt x="287" y="12"/>
                      <a:pt x="288" y="12"/>
                    </a:cubicBezTo>
                    <a:cubicBezTo>
                      <a:pt x="289" y="12"/>
                      <a:pt x="290" y="12"/>
                      <a:pt x="290" y="12"/>
                    </a:cubicBezTo>
                    <a:cubicBezTo>
                      <a:pt x="296" y="12"/>
                      <a:pt x="299" y="0"/>
                      <a:pt x="305" y="0"/>
                    </a:cubicBezTo>
                    <a:cubicBezTo>
                      <a:pt x="306" y="0"/>
                      <a:pt x="308" y="0"/>
                      <a:pt x="310" y="0"/>
                    </a:cubicBezTo>
                    <a:cubicBezTo>
                      <a:pt x="325" y="0"/>
                      <a:pt x="332" y="0"/>
                      <a:pt x="346" y="0"/>
                    </a:cubicBezTo>
                    <a:cubicBezTo>
                      <a:pt x="347" y="0"/>
                      <a:pt x="349" y="0"/>
                      <a:pt x="350" y="0"/>
                    </a:cubicBezTo>
                    <a:cubicBezTo>
                      <a:pt x="351" y="0"/>
                      <a:pt x="352" y="0"/>
                      <a:pt x="352" y="0"/>
                    </a:cubicBezTo>
                    <a:cubicBezTo>
                      <a:pt x="354" y="0"/>
                      <a:pt x="356" y="12"/>
                      <a:pt x="361" y="12"/>
                    </a:cubicBezTo>
                    <a:cubicBezTo>
                      <a:pt x="363" y="12"/>
                      <a:pt x="362" y="12"/>
                      <a:pt x="364" y="12"/>
                    </a:cubicBezTo>
                    <a:cubicBezTo>
                      <a:pt x="365" y="12"/>
                      <a:pt x="366" y="7"/>
                      <a:pt x="368" y="7"/>
                    </a:cubicBezTo>
                    <a:cubicBezTo>
                      <a:pt x="369" y="7"/>
                      <a:pt x="371" y="7"/>
                      <a:pt x="372" y="7"/>
                    </a:cubicBezTo>
                    <a:cubicBezTo>
                      <a:pt x="374" y="7"/>
                      <a:pt x="375" y="12"/>
                      <a:pt x="377" y="12"/>
                    </a:cubicBezTo>
                    <a:cubicBezTo>
                      <a:pt x="377" y="12"/>
                      <a:pt x="378" y="12"/>
                      <a:pt x="379" y="12"/>
                    </a:cubicBezTo>
                    <a:cubicBezTo>
                      <a:pt x="383" y="12"/>
                      <a:pt x="385" y="0"/>
                      <a:pt x="389" y="0"/>
                    </a:cubicBezTo>
                    <a:cubicBezTo>
                      <a:pt x="401" y="0"/>
                      <a:pt x="421" y="0"/>
                      <a:pt x="431" y="0"/>
                    </a:cubicBezTo>
                    <a:cubicBezTo>
                      <a:pt x="431" y="0"/>
                      <a:pt x="432" y="0"/>
                      <a:pt x="432" y="0"/>
                    </a:cubicBezTo>
                    <a:cubicBezTo>
                      <a:pt x="437" y="0"/>
                      <a:pt x="434" y="12"/>
                      <a:pt x="441" y="12"/>
                    </a:cubicBezTo>
                    <a:cubicBezTo>
                      <a:pt x="442" y="12"/>
                      <a:pt x="443" y="12"/>
                      <a:pt x="444" y="12"/>
                    </a:cubicBezTo>
                    <a:cubicBezTo>
                      <a:pt x="446" y="12"/>
                      <a:pt x="447" y="4"/>
                      <a:pt x="449" y="4"/>
                    </a:cubicBezTo>
                    <a:cubicBezTo>
                      <a:pt x="450" y="4"/>
                      <a:pt x="451" y="5"/>
                      <a:pt x="452" y="5"/>
                    </a:cubicBezTo>
                    <a:cubicBezTo>
                      <a:pt x="454" y="5"/>
                      <a:pt x="455" y="12"/>
                      <a:pt x="457" y="12"/>
                    </a:cubicBezTo>
                    <a:cubicBezTo>
                      <a:pt x="458" y="12"/>
                      <a:pt x="460" y="12"/>
                      <a:pt x="461" y="12"/>
                    </a:cubicBezTo>
                    <a:cubicBezTo>
                      <a:pt x="463" y="9"/>
                      <a:pt x="463" y="4"/>
                      <a:pt x="466" y="1"/>
                    </a:cubicBezTo>
                    <a:cubicBezTo>
                      <a:pt x="466" y="0"/>
                      <a:pt x="474" y="0"/>
                      <a:pt x="475" y="0"/>
                    </a:cubicBezTo>
                    <a:cubicBezTo>
                      <a:pt x="479" y="0"/>
                      <a:pt x="480" y="0"/>
                      <a:pt x="484" y="0"/>
                    </a:cubicBezTo>
                    <a:cubicBezTo>
                      <a:pt x="488" y="0"/>
                      <a:pt x="491" y="0"/>
                      <a:pt x="495" y="0"/>
                    </a:cubicBezTo>
                    <a:cubicBezTo>
                      <a:pt x="497" y="0"/>
                      <a:pt x="495" y="0"/>
                      <a:pt x="510" y="0"/>
                    </a:cubicBezTo>
                    <a:cubicBezTo>
                      <a:pt x="512" y="0"/>
                      <a:pt x="512" y="9"/>
                      <a:pt x="517" y="12"/>
                    </a:cubicBezTo>
                    <a:cubicBezTo>
                      <a:pt x="517" y="12"/>
                      <a:pt x="519" y="12"/>
                      <a:pt x="520" y="12"/>
                    </a:cubicBezTo>
                    <a:cubicBezTo>
                      <a:pt x="522" y="12"/>
                      <a:pt x="524" y="2"/>
                      <a:pt x="526" y="2"/>
                    </a:cubicBezTo>
                    <a:cubicBezTo>
                      <a:pt x="527" y="2"/>
                      <a:pt x="529" y="2"/>
                      <a:pt x="531" y="2"/>
                    </a:cubicBezTo>
                    <a:cubicBezTo>
                      <a:pt x="533" y="2"/>
                      <a:pt x="533" y="12"/>
                      <a:pt x="535" y="12"/>
                    </a:cubicBezTo>
                    <a:cubicBezTo>
                      <a:pt x="536" y="12"/>
                      <a:pt x="538" y="12"/>
                      <a:pt x="539" y="12"/>
                    </a:cubicBezTo>
                    <a:cubicBezTo>
                      <a:pt x="544" y="9"/>
                      <a:pt x="540" y="1"/>
                      <a:pt x="550" y="0"/>
                    </a:cubicBezTo>
                    <a:cubicBezTo>
                      <a:pt x="554" y="0"/>
                      <a:pt x="559" y="0"/>
                      <a:pt x="563" y="0"/>
                    </a:cubicBezTo>
                    <a:cubicBezTo>
                      <a:pt x="566" y="0"/>
                      <a:pt x="569" y="0"/>
                      <a:pt x="571" y="0"/>
                    </a:cubicBezTo>
                  </a:path>
                </a:pathLst>
              </a:custGeom>
              <a:noFill/>
              <a:ln w="9525">
                <a:solidFill>
                  <a:srgbClr val="24211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MX"/>
              </a:p>
            </p:txBody>
          </p:sp>
        </p:grpSp>
        <p:sp>
          <p:nvSpPr>
            <p:cNvPr id="280" name="CuadroTexto 283"/>
            <p:cNvSpPr txBox="1"/>
            <p:nvPr/>
          </p:nvSpPr>
          <p:spPr>
            <a:xfrm>
              <a:off x="992806" y="657349"/>
              <a:ext cx="217358" cy="376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/>
                <a:t>A</a:t>
              </a:r>
            </a:p>
          </p:txBody>
        </p:sp>
        <p:sp>
          <p:nvSpPr>
            <p:cNvPr id="281" name="CuadroTexto 284"/>
            <p:cNvSpPr txBox="1"/>
            <p:nvPr/>
          </p:nvSpPr>
          <p:spPr>
            <a:xfrm>
              <a:off x="4572000" y="644974"/>
              <a:ext cx="217358" cy="376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55913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92</TotalTime>
  <Words>119</Words>
  <Application>Microsoft Office PowerPoint</Application>
  <PresentationFormat>Presentación en pantalla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reta</dc:creator>
  <cp:lastModifiedBy>LENIN</cp:lastModifiedBy>
  <cp:revision>230</cp:revision>
  <cp:lastPrinted>2018-06-07T01:42:23Z</cp:lastPrinted>
  <dcterms:created xsi:type="dcterms:W3CDTF">2013-01-27T20:54:38Z</dcterms:created>
  <dcterms:modified xsi:type="dcterms:W3CDTF">2018-06-10T23:34:30Z</dcterms:modified>
</cp:coreProperties>
</file>